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BC88E-6B78-46F2-B1FB-482449C475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8DBBA-75B4-4586-B3BF-FE7CD4668B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B859FE-E492-4BFC-8204-85A076AA5C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8EFAF-B0BC-4544-9E53-80E83F466B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048D5-ECB8-4A2F-B9E2-4DB0E21D5E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3AD48-ECF6-4A8D-8B77-A2C32D0FA9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1D171A-F343-42A4-99DA-014E3470A0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75D7C-5D29-4BB6-A5CC-C1424041F1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3E610-EBC9-4B0B-8FC6-BD98412C75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93BA3-DBE7-42B5-BC79-EBB74667D7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6D54F-1C97-427B-B731-033953F868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2EFCCF-79E3-43F7-A7DB-C5481096AA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38541F-1DE0-4690-ADEC-4BF31EDA3CB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90400" y="1393920"/>
            <a:ext cx="3497400" cy="3130560"/>
          </a:xfrm>
          <a:custGeom>
            <a:avLst/>
            <a:gdLst/>
            <a:ahLst/>
            <a:rect l="l" t="t" r="r" b="b"/>
            <a:pathLst>
              <a:path w="27050" h="19200">
                <a:moveTo>
                  <a:pt x="2350" y="18700"/>
                </a:moveTo>
                <a:lnTo>
                  <a:pt x="1600" y="18650"/>
                </a:lnTo>
                <a:lnTo>
                  <a:pt x="1600" y="18550"/>
                </a:lnTo>
                <a:lnTo>
                  <a:pt x="2350" y="18600"/>
                </a:lnTo>
                <a:lnTo>
                  <a:pt x="2350" y="18700"/>
                </a:lnTo>
                <a:close/>
                <a:moveTo>
                  <a:pt x="1600" y="18650"/>
                </a:moveTo>
                <a:lnTo>
                  <a:pt x="0" y="18500"/>
                </a:lnTo>
                <a:lnTo>
                  <a:pt x="0" y="18400"/>
                </a:lnTo>
                <a:lnTo>
                  <a:pt x="1600" y="18550"/>
                </a:lnTo>
                <a:lnTo>
                  <a:pt x="1600" y="18650"/>
                </a:lnTo>
                <a:close/>
                <a:moveTo>
                  <a:pt x="0" y="18500"/>
                </a:moveTo>
                <a:lnTo>
                  <a:pt x="0" y="18400"/>
                </a:lnTo>
                <a:lnTo>
                  <a:pt x="0" y="18450"/>
                </a:lnTo>
                <a:lnTo>
                  <a:pt x="0" y="18500"/>
                </a:lnTo>
                <a:close/>
                <a:moveTo>
                  <a:pt x="0" y="18400"/>
                </a:moveTo>
                <a:lnTo>
                  <a:pt x="3450" y="18700"/>
                </a:lnTo>
                <a:lnTo>
                  <a:pt x="3450" y="18800"/>
                </a:lnTo>
                <a:lnTo>
                  <a:pt x="0" y="18500"/>
                </a:lnTo>
                <a:lnTo>
                  <a:pt x="0" y="18400"/>
                </a:lnTo>
                <a:close/>
                <a:moveTo>
                  <a:pt x="3450" y="18800"/>
                </a:moveTo>
                <a:lnTo>
                  <a:pt x="3450" y="18800"/>
                </a:lnTo>
                <a:lnTo>
                  <a:pt x="3450" y="18750"/>
                </a:lnTo>
                <a:lnTo>
                  <a:pt x="3450" y="18800"/>
                </a:lnTo>
                <a:close/>
                <a:moveTo>
                  <a:pt x="3450" y="18700"/>
                </a:moveTo>
                <a:lnTo>
                  <a:pt x="5750" y="18750"/>
                </a:lnTo>
                <a:lnTo>
                  <a:pt x="5750" y="18850"/>
                </a:lnTo>
                <a:lnTo>
                  <a:pt x="3450" y="18800"/>
                </a:lnTo>
                <a:lnTo>
                  <a:pt x="3450" y="18700"/>
                </a:lnTo>
                <a:close/>
                <a:moveTo>
                  <a:pt x="5750" y="18850"/>
                </a:moveTo>
                <a:lnTo>
                  <a:pt x="5750" y="18850"/>
                </a:lnTo>
                <a:lnTo>
                  <a:pt x="5750" y="18800"/>
                </a:lnTo>
                <a:lnTo>
                  <a:pt x="5750" y="18850"/>
                </a:lnTo>
                <a:close/>
                <a:moveTo>
                  <a:pt x="5750" y="18750"/>
                </a:moveTo>
                <a:lnTo>
                  <a:pt x="8700" y="18800"/>
                </a:lnTo>
                <a:lnTo>
                  <a:pt x="8700" y="18900"/>
                </a:lnTo>
                <a:lnTo>
                  <a:pt x="5750" y="18850"/>
                </a:lnTo>
                <a:lnTo>
                  <a:pt x="5750" y="18750"/>
                </a:lnTo>
                <a:close/>
                <a:moveTo>
                  <a:pt x="8700" y="18900"/>
                </a:moveTo>
                <a:lnTo>
                  <a:pt x="8700" y="18900"/>
                </a:lnTo>
                <a:lnTo>
                  <a:pt x="8700" y="18850"/>
                </a:lnTo>
                <a:lnTo>
                  <a:pt x="8700" y="18900"/>
                </a:lnTo>
                <a:close/>
                <a:moveTo>
                  <a:pt x="8700" y="18800"/>
                </a:moveTo>
                <a:lnTo>
                  <a:pt x="9700" y="18800"/>
                </a:lnTo>
                <a:lnTo>
                  <a:pt x="9700" y="18900"/>
                </a:lnTo>
                <a:lnTo>
                  <a:pt x="8700" y="18900"/>
                </a:lnTo>
                <a:lnTo>
                  <a:pt x="8700" y="18800"/>
                </a:lnTo>
                <a:close/>
                <a:moveTo>
                  <a:pt x="9700" y="18800"/>
                </a:moveTo>
                <a:lnTo>
                  <a:pt x="9700" y="18800"/>
                </a:lnTo>
                <a:lnTo>
                  <a:pt x="9700" y="18850"/>
                </a:lnTo>
                <a:lnTo>
                  <a:pt x="9700" y="18800"/>
                </a:lnTo>
                <a:close/>
                <a:moveTo>
                  <a:pt x="9700" y="18800"/>
                </a:moveTo>
                <a:lnTo>
                  <a:pt x="10150" y="18800"/>
                </a:lnTo>
                <a:lnTo>
                  <a:pt x="10100" y="18900"/>
                </a:lnTo>
                <a:lnTo>
                  <a:pt x="9700" y="18900"/>
                </a:lnTo>
                <a:lnTo>
                  <a:pt x="9700" y="18800"/>
                </a:lnTo>
                <a:close/>
                <a:moveTo>
                  <a:pt x="10150" y="18900"/>
                </a:moveTo>
                <a:lnTo>
                  <a:pt x="10150" y="18900"/>
                </a:lnTo>
                <a:lnTo>
                  <a:pt x="10100" y="18900"/>
                </a:lnTo>
                <a:lnTo>
                  <a:pt x="10150" y="18850"/>
                </a:lnTo>
                <a:lnTo>
                  <a:pt x="10150" y="18900"/>
                </a:lnTo>
                <a:close/>
                <a:moveTo>
                  <a:pt x="10100" y="18800"/>
                </a:moveTo>
                <a:lnTo>
                  <a:pt x="10500" y="18550"/>
                </a:lnTo>
                <a:lnTo>
                  <a:pt x="10550" y="18650"/>
                </a:lnTo>
                <a:lnTo>
                  <a:pt x="10150" y="18900"/>
                </a:lnTo>
                <a:lnTo>
                  <a:pt x="10100" y="18800"/>
                </a:lnTo>
                <a:close/>
                <a:moveTo>
                  <a:pt x="10500" y="18550"/>
                </a:moveTo>
                <a:lnTo>
                  <a:pt x="10550" y="18550"/>
                </a:lnTo>
                <a:lnTo>
                  <a:pt x="10550" y="18600"/>
                </a:lnTo>
                <a:lnTo>
                  <a:pt x="10500" y="18550"/>
                </a:lnTo>
                <a:close/>
                <a:moveTo>
                  <a:pt x="10550" y="18550"/>
                </a:moveTo>
                <a:lnTo>
                  <a:pt x="10900" y="18650"/>
                </a:lnTo>
                <a:lnTo>
                  <a:pt x="10900" y="18750"/>
                </a:lnTo>
                <a:lnTo>
                  <a:pt x="10500" y="18650"/>
                </a:lnTo>
                <a:lnTo>
                  <a:pt x="10550" y="18550"/>
                </a:lnTo>
                <a:close/>
                <a:moveTo>
                  <a:pt x="10900" y="18750"/>
                </a:moveTo>
                <a:lnTo>
                  <a:pt x="10900" y="18750"/>
                </a:lnTo>
                <a:lnTo>
                  <a:pt x="10900" y="18700"/>
                </a:lnTo>
                <a:lnTo>
                  <a:pt x="10900" y="18750"/>
                </a:lnTo>
                <a:close/>
                <a:moveTo>
                  <a:pt x="10900" y="18650"/>
                </a:moveTo>
                <a:lnTo>
                  <a:pt x="11250" y="18700"/>
                </a:lnTo>
                <a:lnTo>
                  <a:pt x="11250" y="18800"/>
                </a:lnTo>
                <a:lnTo>
                  <a:pt x="10900" y="18750"/>
                </a:lnTo>
                <a:lnTo>
                  <a:pt x="10900" y="18650"/>
                </a:lnTo>
                <a:close/>
                <a:moveTo>
                  <a:pt x="11250" y="18800"/>
                </a:moveTo>
                <a:lnTo>
                  <a:pt x="11250" y="18800"/>
                </a:lnTo>
                <a:lnTo>
                  <a:pt x="11250" y="18750"/>
                </a:lnTo>
                <a:lnTo>
                  <a:pt x="11250" y="18800"/>
                </a:lnTo>
                <a:close/>
                <a:moveTo>
                  <a:pt x="11250" y="18700"/>
                </a:moveTo>
                <a:lnTo>
                  <a:pt x="12200" y="18700"/>
                </a:lnTo>
                <a:lnTo>
                  <a:pt x="12200" y="18800"/>
                </a:lnTo>
                <a:lnTo>
                  <a:pt x="11250" y="18800"/>
                </a:lnTo>
                <a:lnTo>
                  <a:pt x="11250" y="18700"/>
                </a:lnTo>
                <a:close/>
                <a:moveTo>
                  <a:pt x="12200" y="18800"/>
                </a:moveTo>
                <a:lnTo>
                  <a:pt x="12200" y="18800"/>
                </a:lnTo>
                <a:lnTo>
                  <a:pt x="12200" y="18750"/>
                </a:lnTo>
                <a:lnTo>
                  <a:pt x="12200" y="18800"/>
                </a:lnTo>
                <a:close/>
                <a:moveTo>
                  <a:pt x="12200" y="18700"/>
                </a:moveTo>
                <a:lnTo>
                  <a:pt x="13350" y="18750"/>
                </a:lnTo>
                <a:lnTo>
                  <a:pt x="13300" y="18850"/>
                </a:lnTo>
                <a:lnTo>
                  <a:pt x="12200" y="18800"/>
                </a:lnTo>
                <a:lnTo>
                  <a:pt x="12200" y="18700"/>
                </a:lnTo>
                <a:close/>
                <a:moveTo>
                  <a:pt x="13350" y="18850"/>
                </a:moveTo>
                <a:lnTo>
                  <a:pt x="13350" y="18850"/>
                </a:lnTo>
                <a:lnTo>
                  <a:pt x="13300" y="18850"/>
                </a:lnTo>
                <a:lnTo>
                  <a:pt x="13350" y="18800"/>
                </a:lnTo>
                <a:lnTo>
                  <a:pt x="13350" y="18850"/>
                </a:lnTo>
                <a:close/>
                <a:moveTo>
                  <a:pt x="13300" y="18750"/>
                </a:moveTo>
                <a:lnTo>
                  <a:pt x="14000" y="18700"/>
                </a:lnTo>
                <a:lnTo>
                  <a:pt x="14000" y="18800"/>
                </a:lnTo>
                <a:lnTo>
                  <a:pt x="13350" y="18850"/>
                </a:lnTo>
                <a:lnTo>
                  <a:pt x="13300" y="18750"/>
                </a:lnTo>
                <a:close/>
                <a:moveTo>
                  <a:pt x="14000" y="18800"/>
                </a:moveTo>
                <a:lnTo>
                  <a:pt x="14000" y="18800"/>
                </a:lnTo>
                <a:lnTo>
                  <a:pt x="14000" y="18750"/>
                </a:lnTo>
                <a:lnTo>
                  <a:pt x="14000" y="18800"/>
                </a:lnTo>
                <a:close/>
                <a:moveTo>
                  <a:pt x="14000" y="18700"/>
                </a:moveTo>
                <a:lnTo>
                  <a:pt x="14850" y="18600"/>
                </a:lnTo>
                <a:lnTo>
                  <a:pt x="14850" y="18700"/>
                </a:lnTo>
                <a:lnTo>
                  <a:pt x="14000" y="18800"/>
                </a:lnTo>
                <a:lnTo>
                  <a:pt x="14000" y="18700"/>
                </a:lnTo>
                <a:close/>
                <a:moveTo>
                  <a:pt x="14850" y="18700"/>
                </a:moveTo>
                <a:lnTo>
                  <a:pt x="14850" y="18700"/>
                </a:lnTo>
                <a:lnTo>
                  <a:pt x="14850" y="18650"/>
                </a:lnTo>
                <a:lnTo>
                  <a:pt x="14850" y="18700"/>
                </a:lnTo>
                <a:close/>
                <a:moveTo>
                  <a:pt x="14850" y="18600"/>
                </a:moveTo>
                <a:lnTo>
                  <a:pt x="15150" y="18550"/>
                </a:lnTo>
                <a:lnTo>
                  <a:pt x="15150" y="18600"/>
                </a:lnTo>
                <a:lnTo>
                  <a:pt x="14850" y="18700"/>
                </a:lnTo>
                <a:lnTo>
                  <a:pt x="14850" y="18600"/>
                </a:lnTo>
                <a:close/>
                <a:moveTo>
                  <a:pt x="15200" y="18600"/>
                </a:moveTo>
                <a:lnTo>
                  <a:pt x="15200" y="18600"/>
                </a:lnTo>
                <a:lnTo>
                  <a:pt x="15150" y="18600"/>
                </a:lnTo>
                <a:lnTo>
                  <a:pt x="15150" y="18550"/>
                </a:lnTo>
                <a:lnTo>
                  <a:pt x="15200" y="18600"/>
                </a:lnTo>
                <a:close/>
                <a:moveTo>
                  <a:pt x="15150" y="18550"/>
                </a:moveTo>
                <a:lnTo>
                  <a:pt x="15300" y="18400"/>
                </a:lnTo>
                <a:lnTo>
                  <a:pt x="15350" y="18500"/>
                </a:lnTo>
                <a:lnTo>
                  <a:pt x="15200" y="18600"/>
                </a:lnTo>
                <a:lnTo>
                  <a:pt x="15150" y="18550"/>
                </a:lnTo>
                <a:close/>
                <a:moveTo>
                  <a:pt x="15300" y="18400"/>
                </a:moveTo>
                <a:lnTo>
                  <a:pt x="15450" y="18300"/>
                </a:lnTo>
                <a:lnTo>
                  <a:pt x="15500" y="18350"/>
                </a:lnTo>
                <a:lnTo>
                  <a:pt x="15350" y="18500"/>
                </a:lnTo>
                <a:lnTo>
                  <a:pt x="15300" y="18400"/>
                </a:lnTo>
                <a:close/>
                <a:moveTo>
                  <a:pt x="15450" y="18300"/>
                </a:moveTo>
                <a:lnTo>
                  <a:pt x="15450" y="18300"/>
                </a:lnTo>
                <a:close/>
                <a:moveTo>
                  <a:pt x="15450" y="18300"/>
                </a:moveTo>
                <a:lnTo>
                  <a:pt x="15750" y="18250"/>
                </a:lnTo>
                <a:lnTo>
                  <a:pt x="15750" y="18350"/>
                </a:lnTo>
                <a:lnTo>
                  <a:pt x="15450" y="18350"/>
                </a:lnTo>
                <a:lnTo>
                  <a:pt x="15450" y="18300"/>
                </a:lnTo>
                <a:close/>
                <a:moveTo>
                  <a:pt x="15750" y="18250"/>
                </a:moveTo>
                <a:lnTo>
                  <a:pt x="15750" y="18250"/>
                </a:lnTo>
                <a:lnTo>
                  <a:pt x="15750" y="18300"/>
                </a:lnTo>
                <a:lnTo>
                  <a:pt x="15750" y="18250"/>
                </a:lnTo>
                <a:close/>
                <a:moveTo>
                  <a:pt x="15750" y="18250"/>
                </a:moveTo>
                <a:lnTo>
                  <a:pt x="15950" y="18300"/>
                </a:lnTo>
                <a:lnTo>
                  <a:pt x="15950" y="18400"/>
                </a:lnTo>
                <a:lnTo>
                  <a:pt x="15750" y="18350"/>
                </a:lnTo>
                <a:lnTo>
                  <a:pt x="15750" y="18250"/>
                </a:lnTo>
                <a:close/>
                <a:moveTo>
                  <a:pt x="16000" y="18400"/>
                </a:moveTo>
                <a:lnTo>
                  <a:pt x="15950" y="18400"/>
                </a:lnTo>
                <a:lnTo>
                  <a:pt x="15950" y="18350"/>
                </a:lnTo>
                <a:lnTo>
                  <a:pt x="16000" y="18400"/>
                </a:lnTo>
                <a:close/>
                <a:moveTo>
                  <a:pt x="15900" y="18300"/>
                </a:moveTo>
                <a:lnTo>
                  <a:pt x="16050" y="18150"/>
                </a:lnTo>
                <a:lnTo>
                  <a:pt x="16150" y="18250"/>
                </a:lnTo>
                <a:lnTo>
                  <a:pt x="16000" y="18400"/>
                </a:lnTo>
                <a:lnTo>
                  <a:pt x="15900" y="18300"/>
                </a:lnTo>
                <a:close/>
                <a:moveTo>
                  <a:pt x="16150" y="18200"/>
                </a:moveTo>
                <a:lnTo>
                  <a:pt x="16150" y="18250"/>
                </a:lnTo>
                <a:lnTo>
                  <a:pt x="16100" y="18200"/>
                </a:lnTo>
                <a:lnTo>
                  <a:pt x="16150" y="18200"/>
                </a:lnTo>
                <a:close/>
                <a:moveTo>
                  <a:pt x="16050" y="18200"/>
                </a:moveTo>
                <a:lnTo>
                  <a:pt x="16150" y="17900"/>
                </a:lnTo>
                <a:lnTo>
                  <a:pt x="16250" y="17950"/>
                </a:lnTo>
                <a:lnTo>
                  <a:pt x="16150" y="18200"/>
                </a:lnTo>
                <a:lnTo>
                  <a:pt x="16050" y="18200"/>
                </a:lnTo>
                <a:close/>
                <a:moveTo>
                  <a:pt x="16250" y="17900"/>
                </a:moveTo>
                <a:lnTo>
                  <a:pt x="16250" y="17900"/>
                </a:lnTo>
                <a:lnTo>
                  <a:pt x="16250" y="17950"/>
                </a:lnTo>
                <a:lnTo>
                  <a:pt x="16200" y="17900"/>
                </a:lnTo>
                <a:lnTo>
                  <a:pt x="16250" y="17900"/>
                </a:lnTo>
                <a:close/>
                <a:moveTo>
                  <a:pt x="16150" y="17900"/>
                </a:moveTo>
                <a:lnTo>
                  <a:pt x="16250" y="17650"/>
                </a:lnTo>
                <a:lnTo>
                  <a:pt x="16350" y="17650"/>
                </a:lnTo>
                <a:lnTo>
                  <a:pt x="16250" y="17900"/>
                </a:lnTo>
                <a:lnTo>
                  <a:pt x="16150" y="17900"/>
                </a:lnTo>
                <a:close/>
                <a:moveTo>
                  <a:pt x="16250" y="17650"/>
                </a:moveTo>
                <a:lnTo>
                  <a:pt x="16250" y="17650"/>
                </a:lnTo>
                <a:lnTo>
                  <a:pt x="16300" y="17650"/>
                </a:lnTo>
                <a:lnTo>
                  <a:pt x="16250" y="17650"/>
                </a:lnTo>
                <a:close/>
                <a:moveTo>
                  <a:pt x="16250" y="17650"/>
                </a:moveTo>
                <a:lnTo>
                  <a:pt x="16350" y="17400"/>
                </a:lnTo>
                <a:lnTo>
                  <a:pt x="16450" y="17450"/>
                </a:lnTo>
                <a:lnTo>
                  <a:pt x="16350" y="17700"/>
                </a:lnTo>
                <a:lnTo>
                  <a:pt x="16250" y="17650"/>
                </a:lnTo>
                <a:close/>
                <a:moveTo>
                  <a:pt x="16350" y="17400"/>
                </a:moveTo>
                <a:lnTo>
                  <a:pt x="16350" y="17350"/>
                </a:lnTo>
                <a:lnTo>
                  <a:pt x="16400" y="17350"/>
                </a:lnTo>
                <a:lnTo>
                  <a:pt x="16400" y="17400"/>
                </a:lnTo>
                <a:lnTo>
                  <a:pt x="16350" y="17400"/>
                </a:lnTo>
                <a:close/>
                <a:moveTo>
                  <a:pt x="16400" y="17350"/>
                </a:moveTo>
                <a:lnTo>
                  <a:pt x="16550" y="17400"/>
                </a:lnTo>
                <a:lnTo>
                  <a:pt x="16550" y="17500"/>
                </a:lnTo>
                <a:lnTo>
                  <a:pt x="16400" y="17450"/>
                </a:lnTo>
                <a:lnTo>
                  <a:pt x="16400" y="17350"/>
                </a:lnTo>
                <a:close/>
                <a:moveTo>
                  <a:pt x="16550" y="17400"/>
                </a:moveTo>
                <a:lnTo>
                  <a:pt x="16550" y="17400"/>
                </a:lnTo>
                <a:lnTo>
                  <a:pt x="16600" y="17400"/>
                </a:lnTo>
                <a:lnTo>
                  <a:pt x="16550" y="17450"/>
                </a:lnTo>
                <a:lnTo>
                  <a:pt x="16550" y="17400"/>
                </a:lnTo>
                <a:close/>
                <a:moveTo>
                  <a:pt x="16600" y="17400"/>
                </a:moveTo>
                <a:lnTo>
                  <a:pt x="16850" y="17850"/>
                </a:lnTo>
                <a:lnTo>
                  <a:pt x="16800" y="17900"/>
                </a:lnTo>
                <a:lnTo>
                  <a:pt x="16500" y="17450"/>
                </a:lnTo>
                <a:lnTo>
                  <a:pt x="16600" y="17400"/>
                </a:lnTo>
                <a:close/>
                <a:moveTo>
                  <a:pt x="16800" y="17900"/>
                </a:moveTo>
                <a:lnTo>
                  <a:pt x="16800" y="17900"/>
                </a:lnTo>
                <a:close/>
                <a:moveTo>
                  <a:pt x="16850" y="17850"/>
                </a:moveTo>
                <a:lnTo>
                  <a:pt x="17000" y="18100"/>
                </a:lnTo>
                <a:lnTo>
                  <a:pt x="16950" y="18150"/>
                </a:lnTo>
                <a:lnTo>
                  <a:pt x="16800" y="17900"/>
                </a:lnTo>
                <a:lnTo>
                  <a:pt x="16850" y="17850"/>
                </a:lnTo>
                <a:close/>
                <a:moveTo>
                  <a:pt x="16950" y="18150"/>
                </a:moveTo>
                <a:lnTo>
                  <a:pt x="16950" y="18150"/>
                </a:lnTo>
                <a:lnTo>
                  <a:pt x="16950" y="18100"/>
                </a:lnTo>
                <a:lnTo>
                  <a:pt x="16950" y="18150"/>
                </a:lnTo>
                <a:close/>
                <a:moveTo>
                  <a:pt x="16950" y="18050"/>
                </a:moveTo>
                <a:lnTo>
                  <a:pt x="17200" y="18050"/>
                </a:lnTo>
                <a:lnTo>
                  <a:pt x="17200" y="18150"/>
                </a:lnTo>
                <a:lnTo>
                  <a:pt x="16950" y="18150"/>
                </a:lnTo>
                <a:lnTo>
                  <a:pt x="16950" y="18050"/>
                </a:lnTo>
                <a:close/>
                <a:moveTo>
                  <a:pt x="17250" y="18150"/>
                </a:moveTo>
                <a:lnTo>
                  <a:pt x="17200" y="18150"/>
                </a:lnTo>
                <a:lnTo>
                  <a:pt x="17200" y="18100"/>
                </a:lnTo>
                <a:lnTo>
                  <a:pt x="17250" y="18150"/>
                </a:lnTo>
                <a:close/>
                <a:moveTo>
                  <a:pt x="17150" y="18100"/>
                </a:moveTo>
                <a:lnTo>
                  <a:pt x="17300" y="17700"/>
                </a:lnTo>
                <a:lnTo>
                  <a:pt x="17400" y="17750"/>
                </a:lnTo>
                <a:lnTo>
                  <a:pt x="17250" y="18150"/>
                </a:lnTo>
                <a:lnTo>
                  <a:pt x="17150" y="18100"/>
                </a:lnTo>
                <a:close/>
                <a:moveTo>
                  <a:pt x="17400" y="17750"/>
                </a:moveTo>
                <a:lnTo>
                  <a:pt x="17400" y="17750"/>
                </a:lnTo>
                <a:lnTo>
                  <a:pt x="17350" y="17750"/>
                </a:lnTo>
                <a:lnTo>
                  <a:pt x="17400" y="17750"/>
                </a:lnTo>
                <a:close/>
                <a:moveTo>
                  <a:pt x="17300" y="17700"/>
                </a:moveTo>
                <a:lnTo>
                  <a:pt x="17450" y="16950"/>
                </a:lnTo>
                <a:lnTo>
                  <a:pt x="17550" y="16950"/>
                </a:lnTo>
                <a:lnTo>
                  <a:pt x="17400" y="17750"/>
                </a:lnTo>
                <a:lnTo>
                  <a:pt x="17300" y="17700"/>
                </a:lnTo>
                <a:close/>
                <a:moveTo>
                  <a:pt x="17550" y="16950"/>
                </a:moveTo>
                <a:lnTo>
                  <a:pt x="17550" y="16950"/>
                </a:lnTo>
                <a:lnTo>
                  <a:pt x="17500" y="16950"/>
                </a:lnTo>
                <a:lnTo>
                  <a:pt x="17550" y="16950"/>
                </a:lnTo>
                <a:close/>
                <a:moveTo>
                  <a:pt x="17450" y="16950"/>
                </a:moveTo>
                <a:lnTo>
                  <a:pt x="17500" y="15950"/>
                </a:lnTo>
                <a:lnTo>
                  <a:pt x="17600" y="15950"/>
                </a:lnTo>
                <a:lnTo>
                  <a:pt x="17550" y="16950"/>
                </a:lnTo>
                <a:lnTo>
                  <a:pt x="17450" y="16950"/>
                </a:lnTo>
                <a:close/>
                <a:moveTo>
                  <a:pt x="17600" y="15950"/>
                </a:moveTo>
                <a:lnTo>
                  <a:pt x="17600" y="15950"/>
                </a:lnTo>
                <a:lnTo>
                  <a:pt x="17550" y="15950"/>
                </a:lnTo>
                <a:lnTo>
                  <a:pt x="17600" y="15950"/>
                </a:lnTo>
                <a:close/>
                <a:moveTo>
                  <a:pt x="17500" y="15950"/>
                </a:moveTo>
                <a:lnTo>
                  <a:pt x="17550" y="14050"/>
                </a:lnTo>
                <a:lnTo>
                  <a:pt x="17650" y="14050"/>
                </a:lnTo>
                <a:lnTo>
                  <a:pt x="17600" y="15950"/>
                </a:lnTo>
                <a:lnTo>
                  <a:pt x="17500" y="15950"/>
                </a:lnTo>
                <a:close/>
                <a:moveTo>
                  <a:pt x="17550" y="14050"/>
                </a:moveTo>
                <a:lnTo>
                  <a:pt x="17600" y="11150"/>
                </a:lnTo>
                <a:lnTo>
                  <a:pt x="17700" y="11150"/>
                </a:lnTo>
                <a:lnTo>
                  <a:pt x="17650" y="14050"/>
                </a:lnTo>
                <a:lnTo>
                  <a:pt x="17550" y="14050"/>
                </a:lnTo>
                <a:close/>
                <a:moveTo>
                  <a:pt x="17700" y="11150"/>
                </a:moveTo>
                <a:lnTo>
                  <a:pt x="17700" y="11150"/>
                </a:lnTo>
                <a:lnTo>
                  <a:pt x="17650" y="11150"/>
                </a:lnTo>
                <a:lnTo>
                  <a:pt x="17700" y="11150"/>
                </a:lnTo>
                <a:close/>
                <a:moveTo>
                  <a:pt x="17600" y="11150"/>
                </a:moveTo>
                <a:lnTo>
                  <a:pt x="17650" y="8300"/>
                </a:lnTo>
                <a:lnTo>
                  <a:pt x="17750" y="8300"/>
                </a:lnTo>
                <a:lnTo>
                  <a:pt x="17700" y="11150"/>
                </a:lnTo>
                <a:lnTo>
                  <a:pt x="17600" y="11150"/>
                </a:lnTo>
                <a:close/>
                <a:moveTo>
                  <a:pt x="17650" y="8300"/>
                </a:moveTo>
                <a:lnTo>
                  <a:pt x="17700" y="3900"/>
                </a:lnTo>
                <a:lnTo>
                  <a:pt x="17800" y="3900"/>
                </a:lnTo>
                <a:lnTo>
                  <a:pt x="17750" y="8300"/>
                </a:lnTo>
                <a:lnTo>
                  <a:pt x="17650" y="8300"/>
                </a:lnTo>
                <a:close/>
                <a:moveTo>
                  <a:pt x="17700" y="3900"/>
                </a:moveTo>
                <a:lnTo>
                  <a:pt x="17700" y="3900"/>
                </a:lnTo>
                <a:lnTo>
                  <a:pt x="17750" y="3900"/>
                </a:lnTo>
                <a:lnTo>
                  <a:pt x="17700" y="3900"/>
                </a:lnTo>
                <a:close/>
                <a:moveTo>
                  <a:pt x="17700" y="3900"/>
                </a:moveTo>
                <a:lnTo>
                  <a:pt x="17750" y="2050"/>
                </a:lnTo>
                <a:lnTo>
                  <a:pt x="17850" y="2050"/>
                </a:lnTo>
                <a:lnTo>
                  <a:pt x="17800" y="3900"/>
                </a:lnTo>
                <a:lnTo>
                  <a:pt x="17700" y="3900"/>
                </a:lnTo>
                <a:close/>
                <a:moveTo>
                  <a:pt x="17750" y="2050"/>
                </a:moveTo>
                <a:lnTo>
                  <a:pt x="17750" y="2050"/>
                </a:lnTo>
                <a:lnTo>
                  <a:pt x="17800" y="2050"/>
                </a:lnTo>
                <a:lnTo>
                  <a:pt x="17750" y="2050"/>
                </a:lnTo>
                <a:close/>
                <a:moveTo>
                  <a:pt x="17750" y="2050"/>
                </a:moveTo>
                <a:lnTo>
                  <a:pt x="17800" y="950"/>
                </a:lnTo>
                <a:lnTo>
                  <a:pt x="17900" y="950"/>
                </a:lnTo>
                <a:lnTo>
                  <a:pt x="17850" y="2050"/>
                </a:lnTo>
                <a:lnTo>
                  <a:pt x="17750" y="2050"/>
                </a:lnTo>
                <a:close/>
                <a:moveTo>
                  <a:pt x="17800" y="950"/>
                </a:moveTo>
                <a:lnTo>
                  <a:pt x="17800" y="950"/>
                </a:lnTo>
                <a:lnTo>
                  <a:pt x="17850" y="950"/>
                </a:lnTo>
                <a:lnTo>
                  <a:pt x="17800" y="950"/>
                </a:lnTo>
                <a:close/>
                <a:moveTo>
                  <a:pt x="17800" y="950"/>
                </a:moveTo>
                <a:lnTo>
                  <a:pt x="17800" y="950"/>
                </a:lnTo>
                <a:lnTo>
                  <a:pt x="17900" y="950"/>
                </a:lnTo>
                <a:lnTo>
                  <a:pt x="17800" y="950"/>
                </a:lnTo>
                <a:close/>
                <a:moveTo>
                  <a:pt x="17800" y="950"/>
                </a:moveTo>
                <a:lnTo>
                  <a:pt x="17800" y="950"/>
                </a:lnTo>
                <a:lnTo>
                  <a:pt x="17850" y="950"/>
                </a:lnTo>
                <a:lnTo>
                  <a:pt x="17800" y="950"/>
                </a:lnTo>
                <a:close/>
                <a:moveTo>
                  <a:pt x="17800" y="950"/>
                </a:moveTo>
                <a:cubicBezTo>
                  <a:pt x="17800" y="900"/>
                  <a:pt x="17800" y="850"/>
                  <a:pt x="17850" y="750"/>
                </a:cubicBezTo>
                <a:lnTo>
                  <a:pt x="17950" y="800"/>
                </a:lnTo>
                <a:cubicBezTo>
                  <a:pt x="17900" y="850"/>
                  <a:pt x="17900" y="900"/>
                  <a:pt x="17900" y="950"/>
                </a:cubicBezTo>
                <a:lnTo>
                  <a:pt x="17800" y="950"/>
                </a:lnTo>
                <a:close/>
                <a:moveTo>
                  <a:pt x="17850" y="750"/>
                </a:moveTo>
                <a:cubicBezTo>
                  <a:pt x="17850" y="700"/>
                  <a:pt x="17850" y="650"/>
                  <a:pt x="17850" y="600"/>
                </a:cubicBezTo>
                <a:lnTo>
                  <a:pt x="17950" y="600"/>
                </a:lnTo>
                <a:cubicBezTo>
                  <a:pt x="17950" y="650"/>
                  <a:pt x="17950" y="750"/>
                  <a:pt x="17950" y="800"/>
                </a:cubicBezTo>
                <a:lnTo>
                  <a:pt x="17850" y="750"/>
                </a:lnTo>
                <a:close/>
                <a:moveTo>
                  <a:pt x="17850" y="600"/>
                </a:moveTo>
                <a:lnTo>
                  <a:pt x="17900" y="0"/>
                </a:lnTo>
                <a:lnTo>
                  <a:pt x="17950" y="600"/>
                </a:lnTo>
                <a:lnTo>
                  <a:pt x="17900" y="600"/>
                </a:lnTo>
                <a:lnTo>
                  <a:pt x="17850" y="600"/>
                </a:lnTo>
                <a:close/>
                <a:moveTo>
                  <a:pt x="17950" y="600"/>
                </a:moveTo>
                <a:lnTo>
                  <a:pt x="18000" y="1100"/>
                </a:lnTo>
                <a:lnTo>
                  <a:pt x="17900" y="1100"/>
                </a:lnTo>
                <a:lnTo>
                  <a:pt x="17850" y="600"/>
                </a:lnTo>
                <a:lnTo>
                  <a:pt x="17950" y="600"/>
                </a:lnTo>
                <a:close/>
                <a:moveTo>
                  <a:pt x="18000" y="1100"/>
                </a:moveTo>
                <a:lnTo>
                  <a:pt x="18000" y="1100"/>
                </a:lnTo>
                <a:lnTo>
                  <a:pt x="17950" y="1100"/>
                </a:lnTo>
                <a:lnTo>
                  <a:pt x="18000" y="1100"/>
                </a:lnTo>
                <a:close/>
                <a:moveTo>
                  <a:pt x="18000" y="1100"/>
                </a:moveTo>
                <a:lnTo>
                  <a:pt x="18050" y="2100"/>
                </a:lnTo>
                <a:lnTo>
                  <a:pt x="17950" y="2100"/>
                </a:lnTo>
                <a:lnTo>
                  <a:pt x="17900" y="1100"/>
                </a:lnTo>
                <a:lnTo>
                  <a:pt x="18000" y="1100"/>
                </a:lnTo>
                <a:close/>
                <a:moveTo>
                  <a:pt x="18050" y="2100"/>
                </a:moveTo>
                <a:lnTo>
                  <a:pt x="18050" y="2100"/>
                </a:lnTo>
                <a:lnTo>
                  <a:pt x="18000" y="2100"/>
                </a:lnTo>
                <a:lnTo>
                  <a:pt x="18050" y="2100"/>
                </a:lnTo>
                <a:close/>
                <a:moveTo>
                  <a:pt x="18050" y="2100"/>
                </a:moveTo>
                <a:lnTo>
                  <a:pt x="18100" y="3700"/>
                </a:lnTo>
                <a:lnTo>
                  <a:pt x="18000" y="3700"/>
                </a:lnTo>
                <a:lnTo>
                  <a:pt x="17950" y="2100"/>
                </a:lnTo>
                <a:lnTo>
                  <a:pt x="18050" y="2100"/>
                </a:lnTo>
                <a:close/>
                <a:moveTo>
                  <a:pt x="18100" y="3700"/>
                </a:moveTo>
                <a:lnTo>
                  <a:pt x="18150" y="5300"/>
                </a:lnTo>
                <a:lnTo>
                  <a:pt x="18050" y="5300"/>
                </a:lnTo>
                <a:lnTo>
                  <a:pt x="18000" y="3700"/>
                </a:lnTo>
                <a:lnTo>
                  <a:pt x="18100" y="3700"/>
                </a:lnTo>
                <a:close/>
                <a:moveTo>
                  <a:pt x="18050" y="5300"/>
                </a:moveTo>
                <a:lnTo>
                  <a:pt x="18050" y="5300"/>
                </a:lnTo>
                <a:lnTo>
                  <a:pt x="18100" y="5300"/>
                </a:lnTo>
                <a:lnTo>
                  <a:pt x="18050" y="5300"/>
                </a:lnTo>
                <a:close/>
                <a:moveTo>
                  <a:pt x="18150" y="5300"/>
                </a:moveTo>
                <a:lnTo>
                  <a:pt x="18200" y="6750"/>
                </a:lnTo>
                <a:lnTo>
                  <a:pt x="18100" y="6750"/>
                </a:lnTo>
                <a:lnTo>
                  <a:pt x="18050" y="5300"/>
                </a:lnTo>
                <a:lnTo>
                  <a:pt x="18150" y="5300"/>
                </a:lnTo>
                <a:close/>
                <a:moveTo>
                  <a:pt x="18200" y="6750"/>
                </a:moveTo>
                <a:lnTo>
                  <a:pt x="18350" y="10000"/>
                </a:lnTo>
                <a:lnTo>
                  <a:pt x="18250" y="10000"/>
                </a:lnTo>
                <a:lnTo>
                  <a:pt x="18100" y="6750"/>
                </a:lnTo>
                <a:lnTo>
                  <a:pt x="18200" y="6750"/>
                </a:lnTo>
                <a:close/>
                <a:moveTo>
                  <a:pt x="18250" y="10000"/>
                </a:moveTo>
                <a:lnTo>
                  <a:pt x="18250" y="10000"/>
                </a:lnTo>
                <a:lnTo>
                  <a:pt x="18300" y="10000"/>
                </a:lnTo>
                <a:lnTo>
                  <a:pt x="18250" y="10000"/>
                </a:lnTo>
                <a:close/>
                <a:moveTo>
                  <a:pt x="18350" y="10000"/>
                </a:moveTo>
                <a:lnTo>
                  <a:pt x="18400" y="11650"/>
                </a:lnTo>
                <a:lnTo>
                  <a:pt x="18300" y="11650"/>
                </a:lnTo>
                <a:lnTo>
                  <a:pt x="18250" y="10000"/>
                </a:lnTo>
                <a:lnTo>
                  <a:pt x="18350" y="10000"/>
                </a:lnTo>
                <a:close/>
                <a:moveTo>
                  <a:pt x="18300" y="11650"/>
                </a:moveTo>
                <a:lnTo>
                  <a:pt x="18300" y="11650"/>
                </a:lnTo>
                <a:lnTo>
                  <a:pt x="18350" y="11650"/>
                </a:lnTo>
                <a:lnTo>
                  <a:pt x="18300" y="11650"/>
                </a:lnTo>
                <a:close/>
                <a:moveTo>
                  <a:pt x="18400" y="11650"/>
                </a:moveTo>
                <a:lnTo>
                  <a:pt x="18500" y="12800"/>
                </a:lnTo>
                <a:lnTo>
                  <a:pt x="18400" y="12800"/>
                </a:lnTo>
                <a:lnTo>
                  <a:pt x="18300" y="11650"/>
                </a:lnTo>
                <a:lnTo>
                  <a:pt x="18400" y="11650"/>
                </a:lnTo>
                <a:close/>
                <a:moveTo>
                  <a:pt x="18500" y="12800"/>
                </a:moveTo>
                <a:lnTo>
                  <a:pt x="18550" y="13500"/>
                </a:lnTo>
                <a:lnTo>
                  <a:pt x="18450" y="13500"/>
                </a:lnTo>
                <a:lnTo>
                  <a:pt x="18400" y="12800"/>
                </a:lnTo>
                <a:lnTo>
                  <a:pt x="18500" y="12800"/>
                </a:lnTo>
                <a:close/>
                <a:moveTo>
                  <a:pt x="18450" y="13500"/>
                </a:moveTo>
                <a:lnTo>
                  <a:pt x="18450" y="13500"/>
                </a:lnTo>
                <a:lnTo>
                  <a:pt x="18500" y="13500"/>
                </a:lnTo>
                <a:lnTo>
                  <a:pt x="18450" y="13500"/>
                </a:lnTo>
                <a:close/>
                <a:moveTo>
                  <a:pt x="18550" y="13500"/>
                </a:moveTo>
                <a:lnTo>
                  <a:pt x="18550" y="13900"/>
                </a:lnTo>
                <a:lnTo>
                  <a:pt x="18450" y="13900"/>
                </a:lnTo>
                <a:lnTo>
                  <a:pt x="18450" y="13500"/>
                </a:lnTo>
                <a:lnTo>
                  <a:pt x="18550" y="13500"/>
                </a:lnTo>
                <a:close/>
                <a:moveTo>
                  <a:pt x="18450" y="13900"/>
                </a:moveTo>
                <a:lnTo>
                  <a:pt x="18450" y="13900"/>
                </a:lnTo>
                <a:lnTo>
                  <a:pt x="18500" y="13900"/>
                </a:lnTo>
                <a:lnTo>
                  <a:pt x="18450" y="13900"/>
                </a:lnTo>
                <a:close/>
                <a:moveTo>
                  <a:pt x="18550" y="13900"/>
                </a:moveTo>
                <a:lnTo>
                  <a:pt x="18600" y="14200"/>
                </a:lnTo>
                <a:lnTo>
                  <a:pt x="18500" y="14200"/>
                </a:lnTo>
                <a:lnTo>
                  <a:pt x="18450" y="13900"/>
                </a:lnTo>
                <a:lnTo>
                  <a:pt x="18550" y="13900"/>
                </a:lnTo>
                <a:close/>
                <a:moveTo>
                  <a:pt x="18500" y="14250"/>
                </a:moveTo>
                <a:lnTo>
                  <a:pt x="18500" y="14200"/>
                </a:lnTo>
                <a:lnTo>
                  <a:pt x="18550" y="14200"/>
                </a:lnTo>
                <a:lnTo>
                  <a:pt x="18500" y="14250"/>
                </a:lnTo>
                <a:close/>
                <a:moveTo>
                  <a:pt x="18600" y="14200"/>
                </a:moveTo>
                <a:lnTo>
                  <a:pt x="18850" y="15250"/>
                </a:lnTo>
                <a:lnTo>
                  <a:pt x="18750" y="15250"/>
                </a:lnTo>
                <a:lnTo>
                  <a:pt x="18500" y="14250"/>
                </a:lnTo>
                <a:lnTo>
                  <a:pt x="18600" y="14200"/>
                </a:lnTo>
                <a:close/>
                <a:moveTo>
                  <a:pt x="18750" y="15250"/>
                </a:moveTo>
                <a:lnTo>
                  <a:pt x="18750" y="15250"/>
                </a:lnTo>
                <a:lnTo>
                  <a:pt x="18800" y="15250"/>
                </a:lnTo>
                <a:lnTo>
                  <a:pt x="18750" y="15250"/>
                </a:lnTo>
                <a:close/>
                <a:moveTo>
                  <a:pt x="18850" y="15250"/>
                </a:moveTo>
                <a:lnTo>
                  <a:pt x="19000" y="15950"/>
                </a:lnTo>
                <a:lnTo>
                  <a:pt x="18900" y="15950"/>
                </a:lnTo>
                <a:lnTo>
                  <a:pt x="18750" y="15250"/>
                </a:lnTo>
                <a:lnTo>
                  <a:pt x="18850" y="15250"/>
                </a:lnTo>
                <a:close/>
                <a:moveTo>
                  <a:pt x="19000" y="15950"/>
                </a:moveTo>
                <a:lnTo>
                  <a:pt x="19000" y="15950"/>
                </a:lnTo>
                <a:lnTo>
                  <a:pt x="18950" y="15950"/>
                </a:lnTo>
                <a:lnTo>
                  <a:pt x="19000" y="15950"/>
                </a:lnTo>
                <a:close/>
                <a:moveTo>
                  <a:pt x="19000" y="15950"/>
                </a:moveTo>
                <a:lnTo>
                  <a:pt x="19150" y="16500"/>
                </a:lnTo>
                <a:lnTo>
                  <a:pt x="19050" y="16500"/>
                </a:lnTo>
                <a:lnTo>
                  <a:pt x="18900" y="15950"/>
                </a:lnTo>
                <a:lnTo>
                  <a:pt x="19000" y="15950"/>
                </a:lnTo>
                <a:close/>
                <a:moveTo>
                  <a:pt x="19050" y="16500"/>
                </a:moveTo>
                <a:lnTo>
                  <a:pt x="19050" y="16500"/>
                </a:lnTo>
                <a:lnTo>
                  <a:pt x="19100" y="16500"/>
                </a:lnTo>
                <a:lnTo>
                  <a:pt x="19050" y="16500"/>
                </a:lnTo>
                <a:close/>
                <a:moveTo>
                  <a:pt x="19150" y="16500"/>
                </a:moveTo>
                <a:lnTo>
                  <a:pt x="19250" y="16950"/>
                </a:lnTo>
                <a:lnTo>
                  <a:pt x="19150" y="17000"/>
                </a:lnTo>
                <a:lnTo>
                  <a:pt x="19050" y="16500"/>
                </a:lnTo>
                <a:lnTo>
                  <a:pt x="19150" y="16500"/>
                </a:lnTo>
                <a:close/>
                <a:moveTo>
                  <a:pt x="19150" y="17000"/>
                </a:moveTo>
                <a:lnTo>
                  <a:pt x="19150" y="17000"/>
                </a:lnTo>
                <a:lnTo>
                  <a:pt x="19200" y="16950"/>
                </a:lnTo>
                <a:lnTo>
                  <a:pt x="19150" y="17000"/>
                </a:lnTo>
                <a:close/>
                <a:moveTo>
                  <a:pt x="19250" y="16950"/>
                </a:moveTo>
                <a:lnTo>
                  <a:pt x="19350" y="17100"/>
                </a:lnTo>
                <a:lnTo>
                  <a:pt x="19300" y="17150"/>
                </a:lnTo>
                <a:lnTo>
                  <a:pt x="19150" y="17000"/>
                </a:lnTo>
                <a:lnTo>
                  <a:pt x="19250" y="16950"/>
                </a:lnTo>
                <a:close/>
                <a:moveTo>
                  <a:pt x="19400" y="17150"/>
                </a:moveTo>
                <a:lnTo>
                  <a:pt x="19350" y="17250"/>
                </a:lnTo>
                <a:lnTo>
                  <a:pt x="19300" y="17150"/>
                </a:lnTo>
                <a:lnTo>
                  <a:pt x="19350" y="17100"/>
                </a:lnTo>
                <a:lnTo>
                  <a:pt x="19400" y="17150"/>
                </a:lnTo>
                <a:close/>
                <a:moveTo>
                  <a:pt x="19300" y="17100"/>
                </a:moveTo>
                <a:lnTo>
                  <a:pt x="19350" y="16850"/>
                </a:lnTo>
                <a:lnTo>
                  <a:pt x="19450" y="16850"/>
                </a:lnTo>
                <a:lnTo>
                  <a:pt x="19400" y="17150"/>
                </a:lnTo>
                <a:lnTo>
                  <a:pt x="19300" y="17100"/>
                </a:lnTo>
                <a:close/>
                <a:moveTo>
                  <a:pt x="19450" y="16850"/>
                </a:moveTo>
                <a:lnTo>
                  <a:pt x="19450" y="16850"/>
                </a:lnTo>
                <a:lnTo>
                  <a:pt x="19400" y="16850"/>
                </a:lnTo>
                <a:lnTo>
                  <a:pt x="19450" y="16850"/>
                </a:lnTo>
                <a:close/>
                <a:moveTo>
                  <a:pt x="19350" y="16850"/>
                </a:moveTo>
                <a:lnTo>
                  <a:pt x="19400" y="16100"/>
                </a:lnTo>
                <a:lnTo>
                  <a:pt x="19500" y="16100"/>
                </a:lnTo>
                <a:lnTo>
                  <a:pt x="19450" y="16850"/>
                </a:lnTo>
                <a:lnTo>
                  <a:pt x="19350" y="16850"/>
                </a:lnTo>
                <a:close/>
                <a:moveTo>
                  <a:pt x="19500" y="16100"/>
                </a:moveTo>
                <a:lnTo>
                  <a:pt x="19500" y="16100"/>
                </a:lnTo>
                <a:lnTo>
                  <a:pt x="19450" y="16100"/>
                </a:lnTo>
                <a:lnTo>
                  <a:pt x="19500" y="16100"/>
                </a:lnTo>
                <a:close/>
                <a:moveTo>
                  <a:pt x="19400" y="16100"/>
                </a:moveTo>
                <a:lnTo>
                  <a:pt x="19450" y="14850"/>
                </a:lnTo>
                <a:lnTo>
                  <a:pt x="19550" y="14850"/>
                </a:lnTo>
                <a:lnTo>
                  <a:pt x="19500" y="16100"/>
                </a:lnTo>
                <a:lnTo>
                  <a:pt x="19400" y="16100"/>
                </a:lnTo>
                <a:close/>
                <a:moveTo>
                  <a:pt x="19550" y="14850"/>
                </a:moveTo>
                <a:lnTo>
                  <a:pt x="19550" y="14850"/>
                </a:lnTo>
                <a:lnTo>
                  <a:pt x="19500" y="14850"/>
                </a:lnTo>
                <a:lnTo>
                  <a:pt x="19550" y="14850"/>
                </a:lnTo>
                <a:close/>
                <a:moveTo>
                  <a:pt x="19450" y="14850"/>
                </a:moveTo>
                <a:lnTo>
                  <a:pt x="19500" y="13250"/>
                </a:lnTo>
                <a:lnTo>
                  <a:pt x="19600" y="13250"/>
                </a:lnTo>
                <a:lnTo>
                  <a:pt x="19550" y="14850"/>
                </a:lnTo>
                <a:lnTo>
                  <a:pt x="19450" y="14850"/>
                </a:lnTo>
                <a:close/>
                <a:moveTo>
                  <a:pt x="19600" y="13250"/>
                </a:moveTo>
                <a:lnTo>
                  <a:pt x="19600" y="13250"/>
                </a:lnTo>
                <a:lnTo>
                  <a:pt x="19550" y="13250"/>
                </a:lnTo>
                <a:lnTo>
                  <a:pt x="19600" y="13250"/>
                </a:lnTo>
                <a:close/>
                <a:moveTo>
                  <a:pt x="19500" y="13250"/>
                </a:moveTo>
                <a:lnTo>
                  <a:pt x="19550" y="11050"/>
                </a:lnTo>
                <a:lnTo>
                  <a:pt x="19650" y="11050"/>
                </a:lnTo>
                <a:lnTo>
                  <a:pt x="19600" y="13250"/>
                </a:lnTo>
                <a:lnTo>
                  <a:pt x="19500" y="13250"/>
                </a:lnTo>
                <a:close/>
                <a:moveTo>
                  <a:pt x="19550" y="11050"/>
                </a:moveTo>
                <a:lnTo>
                  <a:pt x="19650" y="8100"/>
                </a:lnTo>
                <a:lnTo>
                  <a:pt x="19750" y="8100"/>
                </a:lnTo>
                <a:lnTo>
                  <a:pt x="19650" y="11050"/>
                </a:lnTo>
                <a:lnTo>
                  <a:pt x="19550" y="11050"/>
                </a:lnTo>
                <a:close/>
                <a:moveTo>
                  <a:pt x="19750" y="8100"/>
                </a:moveTo>
                <a:lnTo>
                  <a:pt x="19750" y="8100"/>
                </a:lnTo>
                <a:lnTo>
                  <a:pt x="19700" y="8100"/>
                </a:lnTo>
                <a:lnTo>
                  <a:pt x="19750" y="8100"/>
                </a:lnTo>
                <a:close/>
                <a:moveTo>
                  <a:pt x="19650" y="8100"/>
                </a:moveTo>
                <a:lnTo>
                  <a:pt x="19650" y="6100"/>
                </a:lnTo>
                <a:lnTo>
                  <a:pt x="19750" y="6100"/>
                </a:lnTo>
                <a:lnTo>
                  <a:pt x="19750" y="8100"/>
                </a:lnTo>
                <a:lnTo>
                  <a:pt x="19650" y="8100"/>
                </a:lnTo>
                <a:close/>
                <a:moveTo>
                  <a:pt x="19750" y="6100"/>
                </a:moveTo>
                <a:lnTo>
                  <a:pt x="19750" y="6100"/>
                </a:lnTo>
                <a:lnTo>
                  <a:pt x="19700" y="6100"/>
                </a:lnTo>
                <a:lnTo>
                  <a:pt x="19750" y="6100"/>
                </a:lnTo>
                <a:close/>
                <a:moveTo>
                  <a:pt x="19650" y="6100"/>
                </a:moveTo>
                <a:lnTo>
                  <a:pt x="19700" y="4850"/>
                </a:lnTo>
                <a:lnTo>
                  <a:pt x="19800" y="4900"/>
                </a:lnTo>
                <a:lnTo>
                  <a:pt x="19750" y="6100"/>
                </a:lnTo>
                <a:lnTo>
                  <a:pt x="19650" y="6100"/>
                </a:lnTo>
                <a:close/>
                <a:moveTo>
                  <a:pt x="19700" y="4850"/>
                </a:moveTo>
                <a:lnTo>
                  <a:pt x="19700" y="4850"/>
                </a:lnTo>
                <a:lnTo>
                  <a:pt x="19750" y="4900"/>
                </a:lnTo>
                <a:lnTo>
                  <a:pt x="19700" y="4850"/>
                </a:lnTo>
                <a:close/>
                <a:moveTo>
                  <a:pt x="19700" y="4850"/>
                </a:moveTo>
                <a:lnTo>
                  <a:pt x="19800" y="4150"/>
                </a:lnTo>
                <a:lnTo>
                  <a:pt x="19900" y="4150"/>
                </a:lnTo>
                <a:lnTo>
                  <a:pt x="19800" y="4900"/>
                </a:lnTo>
                <a:lnTo>
                  <a:pt x="19700" y="4850"/>
                </a:lnTo>
                <a:close/>
                <a:moveTo>
                  <a:pt x="19800" y="4150"/>
                </a:moveTo>
                <a:lnTo>
                  <a:pt x="19850" y="3650"/>
                </a:lnTo>
                <a:lnTo>
                  <a:pt x="19900" y="4150"/>
                </a:lnTo>
                <a:lnTo>
                  <a:pt x="19850" y="4150"/>
                </a:lnTo>
                <a:lnTo>
                  <a:pt x="19800" y="4150"/>
                </a:lnTo>
                <a:close/>
                <a:moveTo>
                  <a:pt x="19900" y="4150"/>
                </a:moveTo>
                <a:lnTo>
                  <a:pt x="19950" y="4750"/>
                </a:lnTo>
                <a:lnTo>
                  <a:pt x="19850" y="4800"/>
                </a:lnTo>
                <a:lnTo>
                  <a:pt x="19800" y="4150"/>
                </a:lnTo>
                <a:lnTo>
                  <a:pt x="19900" y="4150"/>
                </a:lnTo>
                <a:close/>
                <a:moveTo>
                  <a:pt x="19950" y="4750"/>
                </a:moveTo>
                <a:lnTo>
                  <a:pt x="19950" y="4800"/>
                </a:lnTo>
                <a:lnTo>
                  <a:pt x="19900" y="4800"/>
                </a:lnTo>
                <a:lnTo>
                  <a:pt x="19950" y="4750"/>
                </a:lnTo>
                <a:close/>
                <a:moveTo>
                  <a:pt x="19950" y="4800"/>
                </a:moveTo>
                <a:lnTo>
                  <a:pt x="20000" y="5900"/>
                </a:lnTo>
                <a:lnTo>
                  <a:pt x="19900" y="5900"/>
                </a:lnTo>
                <a:lnTo>
                  <a:pt x="19850" y="4800"/>
                </a:lnTo>
                <a:lnTo>
                  <a:pt x="19950" y="4800"/>
                </a:lnTo>
                <a:close/>
                <a:moveTo>
                  <a:pt x="20000" y="5900"/>
                </a:moveTo>
                <a:lnTo>
                  <a:pt x="20000" y="5900"/>
                </a:lnTo>
                <a:lnTo>
                  <a:pt x="19950" y="5900"/>
                </a:lnTo>
                <a:lnTo>
                  <a:pt x="20000" y="5900"/>
                </a:lnTo>
                <a:close/>
                <a:moveTo>
                  <a:pt x="20000" y="5900"/>
                </a:moveTo>
                <a:lnTo>
                  <a:pt x="20050" y="7350"/>
                </a:lnTo>
                <a:lnTo>
                  <a:pt x="19950" y="7350"/>
                </a:lnTo>
                <a:lnTo>
                  <a:pt x="19900" y="5900"/>
                </a:lnTo>
                <a:lnTo>
                  <a:pt x="20000" y="5900"/>
                </a:lnTo>
                <a:close/>
                <a:moveTo>
                  <a:pt x="20050" y="7350"/>
                </a:moveTo>
                <a:lnTo>
                  <a:pt x="20050" y="7350"/>
                </a:lnTo>
                <a:lnTo>
                  <a:pt x="20000" y="7350"/>
                </a:lnTo>
                <a:lnTo>
                  <a:pt x="20050" y="7350"/>
                </a:lnTo>
                <a:close/>
                <a:moveTo>
                  <a:pt x="20050" y="7350"/>
                </a:moveTo>
                <a:lnTo>
                  <a:pt x="20100" y="9200"/>
                </a:lnTo>
                <a:lnTo>
                  <a:pt x="20000" y="9200"/>
                </a:lnTo>
                <a:lnTo>
                  <a:pt x="19950" y="7350"/>
                </a:lnTo>
                <a:lnTo>
                  <a:pt x="20050" y="7350"/>
                </a:lnTo>
                <a:close/>
                <a:moveTo>
                  <a:pt x="20100" y="9200"/>
                </a:moveTo>
                <a:lnTo>
                  <a:pt x="20100" y="9200"/>
                </a:lnTo>
                <a:lnTo>
                  <a:pt x="20050" y="9200"/>
                </a:lnTo>
                <a:lnTo>
                  <a:pt x="20100" y="9200"/>
                </a:lnTo>
                <a:close/>
                <a:moveTo>
                  <a:pt x="20100" y="9200"/>
                </a:moveTo>
                <a:lnTo>
                  <a:pt x="20100" y="11150"/>
                </a:lnTo>
                <a:lnTo>
                  <a:pt x="20000" y="11150"/>
                </a:lnTo>
                <a:lnTo>
                  <a:pt x="20000" y="9200"/>
                </a:lnTo>
                <a:lnTo>
                  <a:pt x="20100" y="9200"/>
                </a:lnTo>
                <a:close/>
                <a:moveTo>
                  <a:pt x="20000" y="11150"/>
                </a:moveTo>
                <a:lnTo>
                  <a:pt x="20000" y="11150"/>
                </a:lnTo>
                <a:lnTo>
                  <a:pt x="20050" y="11150"/>
                </a:lnTo>
                <a:lnTo>
                  <a:pt x="20000" y="11150"/>
                </a:lnTo>
                <a:close/>
                <a:moveTo>
                  <a:pt x="20100" y="11150"/>
                </a:moveTo>
                <a:lnTo>
                  <a:pt x="20200" y="13400"/>
                </a:lnTo>
                <a:lnTo>
                  <a:pt x="20100" y="13400"/>
                </a:lnTo>
                <a:lnTo>
                  <a:pt x="20000" y="11150"/>
                </a:lnTo>
                <a:lnTo>
                  <a:pt x="20100" y="11150"/>
                </a:lnTo>
                <a:close/>
                <a:moveTo>
                  <a:pt x="20100" y="13400"/>
                </a:moveTo>
                <a:lnTo>
                  <a:pt x="20100" y="13400"/>
                </a:lnTo>
                <a:lnTo>
                  <a:pt x="20150" y="13400"/>
                </a:lnTo>
                <a:lnTo>
                  <a:pt x="20100" y="13400"/>
                </a:lnTo>
                <a:close/>
                <a:moveTo>
                  <a:pt x="20200" y="13400"/>
                </a:moveTo>
                <a:lnTo>
                  <a:pt x="20300" y="14800"/>
                </a:lnTo>
                <a:lnTo>
                  <a:pt x="20200" y="14800"/>
                </a:lnTo>
                <a:lnTo>
                  <a:pt x="20100" y="13400"/>
                </a:lnTo>
                <a:lnTo>
                  <a:pt x="20200" y="13400"/>
                </a:lnTo>
                <a:close/>
                <a:moveTo>
                  <a:pt x="20200" y="14800"/>
                </a:moveTo>
                <a:lnTo>
                  <a:pt x="20200" y="14800"/>
                </a:lnTo>
                <a:lnTo>
                  <a:pt x="20250" y="14800"/>
                </a:lnTo>
                <a:lnTo>
                  <a:pt x="20200" y="14800"/>
                </a:lnTo>
                <a:close/>
                <a:moveTo>
                  <a:pt x="20300" y="14800"/>
                </a:moveTo>
                <a:lnTo>
                  <a:pt x="20450" y="15450"/>
                </a:lnTo>
                <a:lnTo>
                  <a:pt x="20350" y="15450"/>
                </a:lnTo>
                <a:lnTo>
                  <a:pt x="20200" y="14800"/>
                </a:lnTo>
                <a:lnTo>
                  <a:pt x="20300" y="14800"/>
                </a:lnTo>
                <a:close/>
                <a:moveTo>
                  <a:pt x="20350" y="15450"/>
                </a:moveTo>
                <a:lnTo>
                  <a:pt x="20350" y="15450"/>
                </a:lnTo>
                <a:lnTo>
                  <a:pt x="20400" y="15450"/>
                </a:lnTo>
                <a:lnTo>
                  <a:pt x="20350" y="15450"/>
                </a:lnTo>
                <a:close/>
                <a:moveTo>
                  <a:pt x="20450" y="15450"/>
                </a:moveTo>
                <a:lnTo>
                  <a:pt x="20600" y="16200"/>
                </a:lnTo>
                <a:lnTo>
                  <a:pt x="20500" y="16250"/>
                </a:lnTo>
                <a:lnTo>
                  <a:pt x="20350" y="15450"/>
                </a:lnTo>
                <a:lnTo>
                  <a:pt x="20450" y="15450"/>
                </a:lnTo>
                <a:close/>
                <a:moveTo>
                  <a:pt x="20500" y="16250"/>
                </a:moveTo>
                <a:lnTo>
                  <a:pt x="20500" y="16250"/>
                </a:lnTo>
                <a:lnTo>
                  <a:pt x="20550" y="16250"/>
                </a:lnTo>
                <a:lnTo>
                  <a:pt x="20500" y="16250"/>
                </a:lnTo>
                <a:close/>
                <a:moveTo>
                  <a:pt x="20600" y="16200"/>
                </a:moveTo>
                <a:lnTo>
                  <a:pt x="20650" y="16450"/>
                </a:lnTo>
                <a:lnTo>
                  <a:pt x="20600" y="16500"/>
                </a:lnTo>
                <a:lnTo>
                  <a:pt x="20500" y="16250"/>
                </a:lnTo>
                <a:lnTo>
                  <a:pt x="20600" y="16200"/>
                </a:lnTo>
                <a:close/>
                <a:moveTo>
                  <a:pt x="20650" y="16500"/>
                </a:moveTo>
                <a:lnTo>
                  <a:pt x="20600" y="16550"/>
                </a:lnTo>
                <a:lnTo>
                  <a:pt x="20600" y="16500"/>
                </a:lnTo>
                <a:lnTo>
                  <a:pt x="20650" y="16450"/>
                </a:lnTo>
                <a:lnTo>
                  <a:pt x="20650" y="16500"/>
                </a:lnTo>
                <a:close/>
                <a:moveTo>
                  <a:pt x="20600" y="16450"/>
                </a:moveTo>
                <a:lnTo>
                  <a:pt x="20750" y="16300"/>
                </a:lnTo>
                <a:lnTo>
                  <a:pt x="20800" y="16400"/>
                </a:lnTo>
                <a:lnTo>
                  <a:pt x="20650" y="16500"/>
                </a:lnTo>
                <a:lnTo>
                  <a:pt x="20600" y="16450"/>
                </a:lnTo>
                <a:close/>
                <a:moveTo>
                  <a:pt x="20850" y="16350"/>
                </a:moveTo>
                <a:lnTo>
                  <a:pt x="20850" y="16350"/>
                </a:lnTo>
                <a:lnTo>
                  <a:pt x="20800" y="16400"/>
                </a:lnTo>
                <a:lnTo>
                  <a:pt x="20800" y="16350"/>
                </a:lnTo>
                <a:lnTo>
                  <a:pt x="20850" y="16350"/>
                </a:lnTo>
                <a:close/>
                <a:moveTo>
                  <a:pt x="20750" y="16350"/>
                </a:moveTo>
                <a:lnTo>
                  <a:pt x="20800" y="15750"/>
                </a:lnTo>
                <a:lnTo>
                  <a:pt x="20900" y="15800"/>
                </a:lnTo>
                <a:lnTo>
                  <a:pt x="20850" y="16350"/>
                </a:lnTo>
                <a:lnTo>
                  <a:pt x="20750" y="16350"/>
                </a:lnTo>
                <a:close/>
                <a:moveTo>
                  <a:pt x="20800" y="15750"/>
                </a:moveTo>
                <a:lnTo>
                  <a:pt x="20800" y="15750"/>
                </a:lnTo>
                <a:lnTo>
                  <a:pt x="20850" y="15750"/>
                </a:lnTo>
                <a:lnTo>
                  <a:pt x="20800" y="15750"/>
                </a:lnTo>
                <a:close/>
                <a:moveTo>
                  <a:pt x="20800" y="15750"/>
                </a:moveTo>
                <a:lnTo>
                  <a:pt x="20900" y="15250"/>
                </a:lnTo>
                <a:lnTo>
                  <a:pt x="21000" y="15300"/>
                </a:lnTo>
                <a:lnTo>
                  <a:pt x="20900" y="15800"/>
                </a:lnTo>
                <a:lnTo>
                  <a:pt x="20800" y="15750"/>
                </a:lnTo>
                <a:close/>
                <a:moveTo>
                  <a:pt x="20900" y="15250"/>
                </a:moveTo>
                <a:lnTo>
                  <a:pt x="20900" y="15250"/>
                </a:lnTo>
                <a:lnTo>
                  <a:pt x="20950" y="15250"/>
                </a:lnTo>
                <a:lnTo>
                  <a:pt x="20900" y="15250"/>
                </a:lnTo>
                <a:close/>
                <a:moveTo>
                  <a:pt x="20900" y="15250"/>
                </a:moveTo>
                <a:lnTo>
                  <a:pt x="21000" y="15000"/>
                </a:lnTo>
                <a:lnTo>
                  <a:pt x="21100" y="15050"/>
                </a:lnTo>
                <a:lnTo>
                  <a:pt x="21000" y="15300"/>
                </a:lnTo>
                <a:lnTo>
                  <a:pt x="20900" y="15250"/>
                </a:lnTo>
                <a:close/>
                <a:moveTo>
                  <a:pt x="21000" y="15000"/>
                </a:moveTo>
                <a:lnTo>
                  <a:pt x="21050" y="14950"/>
                </a:lnTo>
                <a:lnTo>
                  <a:pt x="21100" y="15000"/>
                </a:lnTo>
                <a:lnTo>
                  <a:pt x="21050" y="15050"/>
                </a:lnTo>
                <a:lnTo>
                  <a:pt x="21000" y="15000"/>
                </a:lnTo>
                <a:close/>
                <a:moveTo>
                  <a:pt x="21100" y="15000"/>
                </a:moveTo>
                <a:lnTo>
                  <a:pt x="21200" y="15150"/>
                </a:lnTo>
                <a:lnTo>
                  <a:pt x="21150" y="15200"/>
                </a:lnTo>
                <a:lnTo>
                  <a:pt x="21000" y="15050"/>
                </a:lnTo>
                <a:lnTo>
                  <a:pt x="21100" y="15000"/>
                </a:lnTo>
                <a:close/>
                <a:moveTo>
                  <a:pt x="21200" y="15150"/>
                </a:moveTo>
                <a:lnTo>
                  <a:pt x="21200" y="15150"/>
                </a:lnTo>
                <a:lnTo>
                  <a:pt x="21150" y="15150"/>
                </a:lnTo>
                <a:lnTo>
                  <a:pt x="21200" y="15150"/>
                </a:lnTo>
                <a:close/>
                <a:moveTo>
                  <a:pt x="21200" y="15150"/>
                </a:moveTo>
                <a:lnTo>
                  <a:pt x="21300" y="15800"/>
                </a:lnTo>
                <a:lnTo>
                  <a:pt x="21200" y="15800"/>
                </a:lnTo>
                <a:lnTo>
                  <a:pt x="21100" y="15150"/>
                </a:lnTo>
                <a:lnTo>
                  <a:pt x="21200" y="15150"/>
                </a:lnTo>
                <a:close/>
                <a:moveTo>
                  <a:pt x="21300" y="15800"/>
                </a:moveTo>
                <a:lnTo>
                  <a:pt x="21300" y="15800"/>
                </a:lnTo>
                <a:lnTo>
                  <a:pt x="21250" y="15800"/>
                </a:lnTo>
                <a:lnTo>
                  <a:pt x="21300" y="15800"/>
                </a:lnTo>
                <a:close/>
                <a:moveTo>
                  <a:pt x="21300" y="15800"/>
                </a:moveTo>
                <a:lnTo>
                  <a:pt x="21400" y="16450"/>
                </a:lnTo>
                <a:lnTo>
                  <a:pt x="21300" y="16450"/>
                </a:lnTo>
                <a:lnTo>
                  <a:pt x="21200" y="15800"/>
                </a:lnTo>
                <a:lnTo>
                  <a:pt x="21300" y="15800"/>
                </a:lnTo>
                <a:close/>
                <a:moveTo>
                  <a:pt x="21300" y="16450"/>
                </a:moveTo>
                <a:lnTo>
                  <a:pt x="21300" y="16450"/>
                </a:lnTo>
                <a:lnTo>
                  <a:pt x="21350" y="16450"/>
                </a:lnTo>
                <a:lnTo>
                  <a:pt x="21300" y="16450"/>
                </a:lnTo>
                <a:close/>
                <a:moveTo>
                  <a:pt x="21400" y="16450"/>
                </a:moveTo>
                <a:lnTo>
                  <a:pt x="21500" y="17100"/>
                </a:lnTo>
                <a:lnTo>
                  <a:pt x="21400" y="17150"/>
                </a:lnTo>
                <a:lnTo>
                  <a:pt x="21300" y="16450"/>
                </a:lnTo>
                <a:lnTo>
                  <a:pt x="21400" y="16450"/>
                </a:lnTo>
                <a:close/>
                <a:moveTo>
                  <a:pt x="21400" y="17150"/>
                </a:moveTo>
                <a:lnTo>
                  <a:pt x="21400" y="17150"/>
                </a:lnTo>
                <a:lnTo>
                  <a:pt x="21450" y="17150"/>
                </a:lnTo>
                <a:lnTo>
                  <a:pt x="21400" y="17150"/>
                </a:lnTo>
                <a:close/>
                <a:moveTo>
                  <a:pt x="21500" y="17100"/>
                </a:moveTo>
                <a:lnTo>
                  <a:pt x="21650" y="17600"/>
                </a:lnTo>
                <a:lnTo>
                  <a:pt x="21550" y="17600"/>
                </a:lnTo>
                <a:lnTo>
                  <a:pt x="21400" y="17150"/>
                </a:lnTo>
                <a:lnTo>
                  <a:pt x="21500" y="17100"/>
                </a:lnTo>
                <a:close/>
                <a:moveTo>
                  <a:pt x="21600" y="17650"/>
                </a:moveTo>
                <a:lnTo>
                  <a:pt x="21550" y="17650"/>
                </a:lnTo>
                <a:lnTo>
                  <a:pt x="21550" y="17600"/>
                </a:lnTo>
                <a:lnTo>
                  <a:pt x="21600" y="17600"/>
                </a:lnTo>
                <a:lnTo>
                  <a:pt x="21600" y="17650"/>
                </a:lnTo>
                <a:close/>
                <a:moveTo>
                  <a:pt x="21650" y="17550"/>
                </a:moveTo>
                <a:lnTo>
                  <a:pt x="21950" y="17750"/>
                </a:lnTo>
                <a:lnTo>
                  <a:pt x="21900" y="17850"/>
                </a:lnTo>
                <a:lnTo>
                  <a:pt x="21600" y="17650"/>
                </a:lnTo>
                <a:lnTo>
                  <a:pt x="21650" y="17550"/>
                </a:lnTo>
                <a:close/>
                <a:moveTo>
                  <a:pt x="21950" y="17750"/>
                </a:moveTo>
                <a:lnTo>
                  <a:pt x="21950" y="17750"/>
                </a:lnTo>
                <a:lnTo>
                  <a:pt x="21900" y="17800"/>
                </a:lnTo>
                <a:lnTo>
                  <a:pt x="21950" y="17750"/>
                </a:lnTo>
                <a:close/>
                <a:moveTo>
                  <a:pt x="21950" y="17750"/>
                </a:moveTo>
                <a:lnTo>
                  <a:pt x="22250" y="18000"/>
                </a:lnTo>
                <a:lnTo>
                  <a:pt x="22200" y="18100"/>
                </a:lnTo>
                <a:lnTo>
                  <a:pt x="21900" y="17850"/>
                </a:lnTo>
                <a:lnTo>
                  <a:pt x="21950" y="17750"/>
                </a:lnTo>
                <a:close/>
                <a:moveTo>
                  <a:pt x="22250" y="18100"/>
                </a:moveTo>
                <a:lnTo>
                  <a:pt x="22200" y="18100"/>
                </a:lnTo>
                <a:lnTo>
                  <a:pt x="22250" y="18050"/>
                </a:lnTo>
                <a:lnTo>
                  <a:pt x="22250" y="18100"/>
                </a:lnTo>
                <a:close/>
                <a:moveTo>
                  <a:pt x="22250" y="18000"/>
                </a:moveTo>
                <a:lnTo>
                  <a:pt x="22800" y="18100"/>
                </a:lnTo>
                <a:lnTo>
                  <a:pt x="22800" y="18200"/>
                </a:lnTo>
                <a:lnTo>
                  <a:pt x="22250" y="18100"/>
                </a:lnTo>
                <a:lnTo>
                  <a:pt x="22250" y="18000"/>
                </a:lnTo>
                <a:close/>
                <a:moveTo>
                  <a:pt x="22800" y="18200"/>
                </a:moveTo>
                <a:lnTo>
                  <a:pt x="22800" y="18200"/>
                </a:lnTo>
                <a:lnTo>
                  <a:pt x="22800" y="18150"/>
                </a:lnTo>
                <a:lnTo>
                  <a:pt x="22800" y="18200"/>
                </a:lnTo>
                <a:close/>
                <a:moveTo>
                  <a:pt x="22800" y="18100"/>
                </a:moveTo>
                <a:lnTo>
                  <a:pt x="23450" y="18200"/>
                </a:lnTo>
                <a:lnTo>
                  <a:pt x="23450" y="18300"/>
                </a:lnTo>
                <a:lnTo>
                  <a:pt x="22800" y="18200"/>
                </a:lnTo>
                <a:lnTo>
                  <a:pt x="22800" y="18100"/>
                </a:lnTo>
                <a:close/>
                <a:moveTo>
                  <a:pt x="23450" y="18200"/>
                </a:moveTo>
                <a:lnTo>
                  <a:pt x="23750" y="18250"/>
                </a:lnTo>
                <a:lnTo>
                  <a:pt x="23750" y="18350"/>
                </a:lnTo>
                <a:lnTo>
                  <a:pt x="23450" y="18300"/>
                </a:lnTo>
                <a:lnTo>
                  <a:pt x="23450" y="18200"/>
                </a:lnTo>
                <a:close/>
                <a:moveTo>
                  <a:pt x="23750" y="18250"/>
                </a:moveTo>
                <a:lnTo>
                  <a:pt x="23800" y="18250"/>
                </a:lnTo>
                <a:lnTo>
                  <a:pt x="23750" y="18300"/>
                </a:lnTo>
                <a:lnTo>
                  <a:pt x="23750" y="18250"/>
                </a:lnTo>
                <a:close/>
                <a:moveTo>
                  <a:pt x="23800" y="18250"/>
                </a:moveTo>
                <a:lnTo>
                  <a:pt x="24100" y="18500"/>
                </a:lnTo>
                <a:lnTo>
                  <a:pt x="24000" y="18550"/>
                </a:lnTo>
                <a:lnTo>
                  <a:pt x="23750" y="18300"/>
                </a:lnTo>
                <a:lnTo>
                  <a:pt x="23800" y="18250"/>
                </a:lnTo>
                <a:close/>
                <a:moveTo>
                  <a:pt x="24050" y="18600"/>
                </a:moveTo>
                <a:lnTo>
                  <a:pt x="24050" y="18600"/>
                </a:lnTo>
                <a:lnTo>
                  <a:pt x="24000" y="18550"/>
                </a:lnTo>
                <a:lnTo>
                  <a:pt x="24050" y="18550"/>
                </a:lnTo>
                <a:lnTo>
                  <a:pt x="24050" y="18600"/>
                </a:lnTo>
                <a:close/>
                <a:moveTo>
                  <a:pt x="24050" y="18500"/>
                </a:moveTo>
                <a:lnTo>
                  <a:pt x="24300" y="18450"/>
                </a:lnTo>
                <a:lnTo>
                  <a:pt x="24350" y="18550"/>
                </a:lnTo>
                <a:lnTo>
                  <a:pt x="24050" y="18600"/>
                </a:lnTo>
                <a:lnTo>
                  <a:pt x="24050" y="18500"/>
                </a:lnTo>
                <a:close/>
                <a:moveTo>
                  <a:pt x="24350" y="18550"/>
                </a:moveTo>
                <a:lnTo>
                  <a:pt x="24350" y="18550"/>
                </a:lnTo>
                <a:lnTo>
                  <a:pt x="24300" y="18500"/>
                </a:lnTo>
                <a:lnTo>
                  <a:pt x="24350" y="18550"/>
                </a:lnTo>
                <a:close/>
                <a:moveTo>
                  <a:pt x="24300" y="18450"/>
                </a:moveTo>
                <a:lnTo>
                  <a:pt x="24500" y="18350"/>
                </a:lnTo>
                <a:lnTo>
                  <a:pt x="24550" y="18450"/>
                </a:lnTo>
                <a:lnTo>
                  <a:pt x="24350" y="18550"/>
                </a:lnTo>
                <a:lnTo>
                  <a:pt x="24300" y="18450"/>
                </a:lnTo>
                <a:close/>
                <a:moveTo>
                  <a:pt x="24500" y="18350"/>
                </a:moveTo>
                <a:lnTo>
                  <a:pt x="24550" y="18350"/>
                </a:lnTo>
                <a:lnTo>
                  <a:pt x="24550" y="18400"/>
                </a:lnTo>
                <a:lnTo>
                  <a:pt x="24500" y="18400"/>
                </a:lnTo>
                <a:lnTo>
                  <a:pt x="24500" y="18350"/>
                </a:lnTo>
                <a:close/>
                <a:moveTo>
                  <a:pt x="24550" y="18400"/>
                </a:moveTo>
                <a:lnTo>
                  <a:pt x="24750" y="18600"/>
                </a:lnTo>
                <a:lnTo>
                  <a:pt x="24650" y="18650"/>
                </a:lnTo>
                <a:lnTo>
                  <a:pt x="24500" y="18450"/>
                </a:lnTo>
                <a:lnTo>
                  <a:pt x="24550" y="18400"/>
                </a:lnTo>
                <a:close/>
                <a:moveTo>
                  <a:pt x="24700" y="18650"/>
                </a:moveTo>
                <a:lnTo>
                  <a:pt x="24650" y="18650"/>
                </a:lnTo>
                <a:lnTo>
                  <a:pt x="24700" y="18600"/>
                </a:lnTo>
                <a:lnTo>
                  <a:pt x="24700" y="18650"/>
                </a:lnTo>
                <a:close/>
                <a:moveTo>
                  <a:pt x="24700" y="18550"/>
                </a:moveTo>
                <a:lnTo>
                  <a:pt x="25050" y="18600"/>
                </a:lnTo>
                <a:lnTo>
                  <a:pt x="25050" y="18700"/>
                </a:lnTo>
                <a:lnTo>
                  <a:pt x="24700" y="18650"/>
                </a:lnTo>
                <a:lnTo>
                  <a:pt x="24700" y="18550"/>
                </a:lnTo>
                <a:close/>
                <a:moveTo>
                  <a:pt x="25050" y="18600"/>
                </a:moveTo>
                <a:lnTo>
                  <a:pt x="25050" y="18600"/>
                </a:lnTo>
                <a:lnTo>
                  <a:pt x="25050" y="18650"/>
                </a:lnTo>
                <a:lnTo>
                  <a:pt x="25050" y="18600"/>
                </a:lnTo>
                <a:close/>
                <a:moveTo>
                  <a:pt x="25050" y="18600"/>
                </a:moveTo>
                <a:lnTo>
                  <a:pt x="25350" y="18650"/>
                </a:lnTo>
                <a:lnTo>
                  <a:pt x="25350" y="18750"/>
                </a:lnTo>
                <a:lnTo>
                  <a:pt x="25050" y="18700"/>
                </a:lnTo>
                <a:lnTo>
                  <a:pt x="25050" y="18600"/>
                </a:lnTo>
                <a:close/>
                <a:moveTo>
                  <a:pt x="25350" y="18750"/>
                </a:moveTo>
                <a:lnTo>
                  <a:pt x="25350" y="18750"/>
                </a:lnTo>
                <a:lnTo>
                  <a:pt x="25350" y="18700"/>
                </a:lnTo>
                <a:lnTo>
                  <a:pt x="25350" y="18750"/>
                </a:lnTo>
                <a:close/>
                <a:moveTo>
                  <a:pt x="25350" y="18650"/>
                </a:moveTo>
                <a:lnTo>
                  <a:pt x="25700" y="18600"/>
                </a:lnTo>
                <a:lnTo>
                  <a:pt x="25700" y="18700"/>
                </a:lnTo>
                <a:lnTo>
                  <a:pt x="25350" y="18750"/>
                </a:lnTo>
                <a:lnTo>
                  <a:pt x="25350" y="18650"/>
                </a:lnTo>
                <a:close/>
                <a:moveTo>
                  <a:pt x="25700" y="18600"/>
                </a:moveTo>
                <a:lnTo>
                  <a:pt x="25700" y="18600"/>
                </a:lnTo>
                <a:lnTo>
                  <a:pt x="25700" y="18650"/>
                </a:lnTo>
                <a:lnTo>
                  <a:pt x="25700" y="18600"/>
                </a:lnTo>
                <a:close/>
                <a:moveTo>
                  <a:pt x="25700" y="18600"/>
                </a:moveTo>
                <a:lnTo>
                  <a:pt x="26000" y="18600"/>
                </a:lnTo>
                <a:lnTo>
                  <a:pt x="26000" y="18700"/>
                </a:lnTo>
                <a:lnTo>
                  <a:pt x="25700" y="18700"/>
                </a:lnTo>
                <a:lnTo>
                  <a:pt x="25700" y="18600"/>
                </a:lnTo>
                <a:close/>
                <a:moveTo>
                  <a:pt x="26000" y="18600"/>
                </a:moveTo>
                <a:lnTo>
                  <a:pt x="26000" y="18600"/>
                </a:lnTo>
                <a:lnTo>
                  <a:pt x="26000" y="18650"/>
                </a:lnTo>
                <a:lnTo>
                  <a:pt x="26000" y="18600"/>
                </a:lnTo>
                <a:close/>
                <a:moveTo>
                  <a:pt x="26000" y="18600"/>
                </a:moveTo>
                <a:lnTo>
                  <a:pt x="26350" y="18650"/>
                </a:lnTo>
                <a:lnTo>
                  <a:pt x="26350" y="18750"/>
                </a:lnTo>
                <a:lnTo>
                  <a:pt x="26000" y="18700"/>
                </a:lnTo>
                <a:lnTo>
                  <a:pt x="26000" y="18600"/>
                </a:lnTo>
                <a:close/>
                <a:moveTo>
                  <a:pt x="26350" y="18650"/>
                </a:moveTo>
                <a:lnTo>
                  <a:pt x="26350" y="18650"/>
                </a:lnTo>
                <a:lnTo>
                  <a:pt x="26350" y="18700"/>
                </a:lnTo>
                <a:lnTo>
                  <a:pt x="26350" y="18650"/>
                </a:lnTo>
                <a:close/>
                <a:moveTo>
                  <a:pt x="26350" y="18650"/>
                </a:moveTo>
                <a:lnTo>
                  <a:pt x="26750" y="18700"/>
                </a:lnTo>
                <a:lnTo>
                  <a:pt x="26700" y="18800"/>
                </a:lnTo>
                <a:lnTo>
                  <a:pt x="26350" y="18750"/>
                </a:lnTo>
                <a:lnTo>
                  <a:pt x="26350" y="18650"/>
                </a:lnTo>
                <a:close/>
                <a:moveTo>
                  <a:pt x="26750" y="18700"/>
                </a:moveTo>
                <a:lnTo>
                  <a:pt x="26750" y="18700"/>
                </a:lnTo>
                <a:lnTo>
                  <a:pt x="26750" y="18750"/>
                </a:lnTo>
                <a:lnTo>
                  <a:pt x="26700" y="18750"/>
                </a:lnTo>
                <a:lnTo>
                  <a:pt x="26750" y="18700"/>
                </a:lnTo>
                <a:close/>
                <a:moveTo>
                  <a:pt x="26750" y="18750"/>
                </a:moveTo>
                <a:lnTo>
                  <a:pt x="26950" y="19000"/>
                </a:lnTo>
                <a:lnTo>
                  <a:pt x="26850" y="19050"/>
                </a:lnTo>
                <a:lnTo>
                  <a:pt x="26700" y="18800"/>
                </a:lnTo>
                <a:lnTo>
                  <a:pt x="26750" y="18750"/>
                </a:lnTo>
                <a:close/>
                <a:moveTo>
                  <a:pt x="26950" y="19000"/>
                </a:moveTo>
                <a:lnTo>
                  <a:pt x="26950" y="19000"/>
                </a:lnTo>
                <a:lnTo>
                  <a:pt x="26900" y="19000"/>
                </a:lnTo>
                <a:lnTo>
                  <a:pt x="26950" y="19000"/>
                </a:lnTo>
                <a:close/>
                <a:moveTo>
                  <a:pt x="26950" y="19000"/>
                </a:moveTo>
                <a:lnTo>
                  <a:pt x="27050" y="19150"/>
                </a:lnTo>
                <a:lnTo>
                  <a:pt x="26950" y="19200"/>
                </a:lnTo>
                <a:lnTo>
                  <a:pt x="26850" y="19050"/>
                </a:lnTo>
                <a:lnTo>
                  <a:pt x="26950" y="19000"/>
                </a:lnTo>
                <a:close/>
              </a:path>
            </a:pathLst>
          </a:custGeom>
          <a:solidFill>
            <a:srgbClr val="24211d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590400" y="4508640"/>
            <a:ext cx="2556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12" y="9"/>
                </a:lnTo>
                <a:lnTo>
                  <a:pt x="0" y="6"/>
                </a:lnTo>
                <a:lnTo>
                  <a:pt x="0" y="0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28560" y="4516560"/>
            <a:ext cx="270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68160" y="451656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706320" y="451656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47720" y="4516560"/>
            <a:ext cx="6480" cy="23760"/>
          </a:xfrm>
          <a:custGeom>
            <a:avLst/>
            <a:gdLst/>
            <a:ahLst/>
            <a:rect l="l" t="t" r="r" b="b"/>
            <a:pathLst>
              <a:path w="3" h="9">
                <a:moveTo>
                  <a:pt x="3" y="9"/>
                </a:moveTo>
                <a:lnTo>
                  <a:pt x="3" y="3"/>
                </a:lnTo>
                <a:lnTo>
                  <a:pt x="0" y="0"/>
                </a:lnTo>
                <a:lnTo>
                  <a:pt x="0" y="6"/>
                </a:lnTo>
                <a:lnTo>
                  <a:pt x="3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54200" y="4540320"/>
            <a:ext cx="36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54200" y="4524480"/>
            <a:ext cx="1908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85880" y="452448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24040" y="452448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61840" y="452448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900000" y="452448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939960" y="452448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958680" y="452448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0"/>
                </a:moveTo>
                <a:lnTo>
                  <a:pt x="3" y="6"/>
                </a:lnTo>
                <a:lnTo>
                  <a:pt x="0" y="0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977760" y="451656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015920" y="4516560"/>
            <a:ext cx="270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055520" y="451656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093680" y="4508640"/>
            <a:ext cx="2880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0"/>
                </a:moveTo>
                <a:lnTo>
                  <a:pt x="12" y="6"/>
                </a:lnTo>
                <a:lnTo>
                  <a:pt x="0" y="9"/>
                </a:lnTo>
                <a:lnTo>
                  <a:pt x="0" y="3"/>
                </a:lnTo>
                <a:lnTo>
                  <a:pt x="12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135080" y="450864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173240" y="4508640"/>
            <a:ext cx="2520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12" y="9"/>
                </a:lnTo>
                <a:lnTo>
                  <a:pt x="0" y="6"/>
                </a:lnTo>
                <a:lnTo>
                  <a:pt x="0" y="0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211400" y="451656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249200" y="451656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287360" y="4516560"/>
            <a:ext cx="270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327320" y="451656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365120" y="4516560"/>
            <a:ext cx="270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405080" y="451656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442880" y="450864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481040" y="4508640"/>
            <a:ext cx="972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0"/>
                </a:moveTo>
                <a:lnTo>
                  <a:pt x="3" y="0"/>
                </a:lnTo>
                <a:lnTo>
                  <a:pt x="0" y="0"/>
                </a:lnTo>
                <a:lnTo>
                  <a:pt x="0" y="6"/>
                </a:lnTo>
                <a:lnTo>
                  <a:pt x="3" y="6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490760" y="4508640"/>
            <a:ext cx="36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490760" y="4508640"/>
            <a:ext cx="1908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522440" y="450864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560600" y="450864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598760" y="450864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636560" y="450864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676520" y="450864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714680" y="450864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739880" y="4524480"/>
            <a:ext cx="468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739880" y="4508640"/>
            <a:ext cx="468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752480" y="4498920"/>
            <a:ext cx="27000" cy="255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0"/>
                </a:moveTo>
                <a:lnTo>
                  <a:pt x="12" y="6"/>
                </a:lnTo>
                <a:lnTo>
                  <a:pt x="0" y="9"/>
                </a:lnTo>
                <a:lnTo>
                  <a:pt x="0" y="3"/>
                </a:lnTo>
                <a:lnTo>
                  <a:pt x="12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792440" y="4498920"/>
            <a:ext cx="25200" cy="176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830240" y="4498920"/>
            <a:ext cx="28800" cy="176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871640" y="4498920"/>
            <a:ext cx="12600" cy="176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0"/>
                </a:moveTo>
                <a:lnTo>
                  <a:pt x="6" y="0"/>
                </a:lnTo>
                <a:lnTo>
                  <a:pt x="0" y="0"/>
                </a:lnTo>
                <a:lnTo>
                  <a:pt x="0" y="6"/>
                </a:lnTo>
                <a:lnTo>
                  <a:pt x="6" y="6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884240" y="4498920"/>
            <a:ext cx="36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884240" y="4498920"/>
            <a:ext cx="12960" cy="176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909800" y="450864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3"/>
                </a:moveTo>
                <a:lnTo>
                  <a:pt x="0" y="0"/>
                </a:lnTo>
                <a:lnTo>
                  <a:pt x="0" y="6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909800" y="4516560"/>
            <a:ext cx="6480" cy="7920"/>
          </a:xfrm>
          <a:custGeom>
            <a:avLst/>
            <a:gdLst/>
            <a:ahLst/>
            <a:rect l="l" t="t" r="r" b="b"/>
            <a:pathLst>
              <a:path w="3" h="3">
                <a:moveTo>
                  <a:pt x="3" y="0"/>
                </a:moveTo>
                <a:lnTo>
                  <a:pt x="3" y="3"/>
                </a:lnTo>
                <a:lnTo>
                  <a:pt x="0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909800" y="4491000"/>
            <a:ext cx="25200" cy="25560"/>
          </a:xfrm>
          <a:custGeom>
            <a:avLst/>
            <a:gdLst/>
            <a:ahLst/>
            <a:rect l="l" t="t" r="r" b="b"/>
            <a:pathLst>
              <a:path w="12" h="9">
                <a:moveTo>
                  <a:pt x="6" y="0"/>
                </a:moveTo>
                <a:lnTo>
                  <a:pt x="12" y="3"/>
                </a:lnTo>
                <a:lnTo>
                  <a:pt x="3" y="9"/>
                </a:lnTo>
                <a:lnTo>
                  <a:pt x="0" y="6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928880" y="445140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9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941480" y="4417920"/>
            <a:ext cx="12600" cy="15840"/>
          </a:xfrm>
          <a:custGeom>
            <a:avLst/>
            <a:gdLst/>
            <a:ahLst/>
            <a:rect l="l" t="t" r="r" b="b"/>
            <a:pathLst>
              <a:path w="6" h="6">
                <a:moveTo>
                  <a:pt x="0" y="0"/>
                </a:moveTo>
                <a:lnTo>
                  <a:pt x="0" y="0"/>
                </a:lnTo>
                <a:lnTo>
                  <a:pt x="0" y="6"/>
                </a:lnTo>
                <a:lnTo>
                  <a:pt x="3" y="6"/>
                </a:lnTo>
                <a:lnTo>
                  <a:pt x="6" y="0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941480" y="4417920"/>
            <a:ext cx="180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941480" y="4402080"/>
            <a:ext cx="19080" cy="15840"/>
          </a:xfrm>
          <a:custGeom>
            <a:avLst/>
            <a:gdLst/>
            <a:ahLst/>
            <a:rect l="l" t="t" r="r" b="b"/>
            <a:pathLst>
              <a:path w="9" h="6">
                <a:moveTo>
                  <a:pt x="3" y="0"/>
                </a:moveTo>
                <a:lnTo>
                  <a:pt x="9" y="0"/>
                </a:lnTo>
                <a:lnTo>
                  <a:pt x="6" y="6"/>
                </a:lnTo>
                <a:lnTo>
                  <a:pt x="0" y="6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947960" y="4361040"/>
            <a:ext cx="19080" cy="25200"/>
          </a:xfrm>
          <a:custGeom>
            <a:avLst/>
            <a:gdLst/>
            <a:ahLst/>
            <a:rect l="l" t="t" r="r" b="b"/>
            <a:pathLst>
              <a:path w="9" h="9">
                <a:moveTo>
                  <a:pt x="3" y="0"/>
                </a:moveTo>
                <a:lnTo>
                  <a:pt x="3" y="0"/>
                </a:lnTo>
                <a:lnTo>
                  <a:pt x="0" y="9"/>
                </a:lnTo>
                <a:lnTo>
                  <a:pt x="6" y="9"/>
                </a:lnTo>
                <a:lnTo>
                  <a:pt x="9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954080" y="4361040"/>
            <a:ext cx="180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954080" y="4352760"/>
            <a:ext cx="19080" cy="16200"/>
          </a:xfrm>
          <a:custGeom>
            <a:avLst/>
            <a:gdLst/>
            <a:ahLst/>
            <a:rect l="l" t="t" r="r" b="b"/>
            <a:pathLst>
              <a:path w="9" h="6">
                <a:moveTo>
                  <a:pt x="3" y="0"/>
                </a:moveTo>
                <a:lnTo>
                  <a:pt x="9" y="3"/>
                </a:lnTo>
                <a:lnTo>
                  <a:pt x="6" y="6"/>
                </a:lnTo>
                <a:lnTo>
                  <a:pt x="0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973160" y="433692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3"/>
                </a:moveTo>
                <a:lnTo>
                  <a:pt x="0" y="0"/>
                </a:lnTo>
                <a:lnTo>
                  <a:pt x="3" y="6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973160" y="4336920"/>
            <a:ext cx="6480" cy="7920"/>
          </a:xfrm>
          <a:custGeom>
            <a:avLst/>
            <a:gdLst/>
            <a:ahLst/>
            <a:rect l="l" t="t" r="r" b="b"/>
            <a:pathLst>
              <a:path w="3" h="3">
                <a:moveTo>
                  <a:pt x="0" y="0"/>
                </a:moveTo>
                <a:lnTo>
                  <a:pt x="0" y="0"/>
                </a:lnTo>
                <a:lnTo>
                  <a:pt x="3" y="3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973160" y="4344840"/>
            <a:ext cx="19080" cy="3204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9"/>
                </a:moveTo>
                <a:lnTo>
                  <a:pt x="6" y="12"/>
                </a:lnTo>
                <a:lnTo>
                  <a:pt x="0" y="3"/>
                </a:lnTo>
                <a:lnTo>
                  <a:pt x="3" y="0"/>
                </a:lnTo>
                <a:lnTo>
                  <a:pt x="9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992240" y="4376880"/>
            <a:ext cx="12600" cy="17280"/>
          </a:xfrm>
          <a:custGeom>
            <a:avLst/>
            <a:gdLst/>
            <a:ahLst/>
            <a:rect l="l" t="t" r="r" b="b"/>
            <a:pathLst>
              <a:path w="6" h="6">
                <a:moveTo>
                  <a:pt x="3" y="6"/>
                </a:moveTo>
                <a:lnTo>
                  <a:pt x="6" y="3"/>
                </a:lnTo>
                <a:lnTo>
                  <a:pt x="6" y="0"/>
                </a:lnTo>
                <a:lnTo>
                  <a:pt x="0" y="3"/>
                </a:lnTo>
                <a:lnTo>
                  <a:pt x="0" y="6"/>
                </a:lnTo>
                <a:lnTo>
                  <a:pt x="3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998720" y="4386240"/>
            <a:ext cx="19080" cy="23760"/>
          </a:xfrm>
          <a:custGeom>
            <a:avLst/>
            <a:gdLst/>
            <a:ahLst/>
            <a:rect l="l" t="t" r="r" b="b"/>
            <a:pathLst>
              <a:path w="9" h="9">
                <a:moveTo>
                  <a:pt x="9" y="3"/>
                </a:moveTo>
                <a:lnTo>
                  <a:pt x="6" y="9"/>
                </a:lnTo>
                <a:lnTo>
                  <a:pt x="0" y="3"/>
                </a:lnTo>
                <a:lnTo>
                  <a:pt x="3" y="0"/>
                </a:lnTo>
                <a:lnTo>
                  <a:pt x="9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023920" y="4410000"/>
            <a:ext cx="6480" cy="7920"/>
          </a:xfrm>
          <a:custGeom>
            <a:avLst/>
            <a:gdLst/>
            <a:ahLst/>
            <a:rect l="l" t="t" r="r" b="b"/>
            <a:pathLst>
              <a:path w="3" h="3">
                <a:moveTo>
                  <a:pt x="3" y="3"/>
                </a:moveTo>
                <a:lnTo>
                  <a:pt x="3" y="0"/>
                </a:lnTo>
                <a:lnTo>
                  <a:pt x="0" y="3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023920" y="4417920"/>
            <a:ext cx="6480" cy="7920"/>
          </a:xfrm>
          <a:custGeom>
            <a:avLst/>
            <a:gdLst/>
            <a:ahLst/>
            <a:rect l="l" t="t" r="r" b="b"/>
            <a:pathLst>
              <a:path w="3" h="3">
                <a:moveTo>
                  <a:pt x="3" y="0"/>
                </a:moveTo>
                <a:lnTo>
                  <a:pt x="3" y="3"/>
                </a:lnTo>
                <a:lnTo>
                  <a:pt x="0" y="0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030400" y="4394160"/>
            <a:ext cx="2700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9" y="0"/>
                </a:moveTo>
                <a:lnTo>
                  <a:pt x="12" y="6"/>
                </a:lnTo>
                <a:lnTo>
                  <a:pt x="0" y="9"/>
                </a:lnTo>
                <a:lnTo>
                  <a:pt x="0" y="6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063880" y="438624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101680" y="4376880"/>
            <a:ext cx="12960" cy="1728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0"/>
                </a:moveTo>
                <a:lnTo>
                  <a:pt x="3" y="0"/>
                </a:lnTo>
                <a:lnTo>
                  <a:pt x="0" y="0"/>
                </a:lnTo>
                <a:lnTo>
                  <a:pt x="0" y="6"/>
                </a:lnTo>
                <a:lnTo>
                  <a:pt x="6" y="6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108160" y="4376880"/>
            <a:ext cx="648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108160" y="4376880"/>
            <a:ext cx="19080" cy="25200"/>
          </a:xfrm>
          <a:custGeom>
            <a:avLst/>
            <a:gdLst/>
            <a:ahLst/>
            <a:rect l="l" t="t" r="r" b="b"/>
            <a:pathLst>
              <a:path w="9" h="9">
                <a:moveTo>
                  <a:pt x="9" y="3"/>
                </a:moveTo>
                <a:lnTo>
                  <a:pt x="6" y="9"/>
                </a:lnTo>
                <a:lnTo>
                  <a:pt x="0" y="6"/>
                </a:lnTo>
                <a:lnTo>
                  <a:pt x="3" y="0"/>
                </a:lnTo>
                <a:lnTo>
                  <a:pt x="9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135160" y="4394160"/>
            <a:ext cx="12600" cy="158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6"/>
                </a:moveTo>
                <a:lnTo>
                  <a:pt x="6" y="0"/>
                </a:lnTo>
                <a:lnTo>
                  <a:pt x="3" y="0"/>
                </a:lnTo>
                <a:lnTo>
                  <a:pt x="0" y="3"/>
                </a:lnTo>
                <a:lnTo>
                  <a:pt x="3" y="6"/>
                </a:lnTo>
                <a:lnTo>
                  <a:pt x="6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141640" y="4410000"/>
            <a:ext cx="612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141640" y="4386240"/>
            <a:ext cx="2520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9" y="0"/>
                </a:moveTo>
                <a:lnTo>
                  <a:pt x="12" y="6"/>
                </a:lnTo>
                <a:lnTo>
                  <a:pt x="3" y="9"/>
                </a:lnTo>
                <a:lnTo>
                  <a:pt x="0" y="3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173320" y="4368960"/>
            <a:ext cx="19080" cy="25200"/>
          </a:xfrm>
          <a:custGeom>
            <a:avLst/>
            <a:gdLst/>
            <a:ahLst/>
            <a:rect l="l" t="t" r="r" b="b"/>
            <a:pathLst>
              <a:path w="9" h="9">
                <a:moveTo>
                  <a:pt x="9" y="0"/>
                </a:moveTo>
                <a:lnTo>
                  <a:pt x="9" y="0"/>
                </a:lnTo>
                <a:lnTo>
                  <a:pt x="0" y="3"/>
                </a:lnTo>
                <a:lnTo>
                  <a:pt x="3" y="9"/>
                </a:lnTo>
                <a:lnTo>
                  <a:pt x="9" y="6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192400" y="4368960"/>
            <a:ext cx="324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192400" y="4368960"/>
            <a:ext cx="6120" cy="25200"/>
          </a:xfrm>
          <a:custGeom>
            <a:avLst/>
            <a:gdLst/>
            <a:ahLst/>
            <a:rect l="l" t="t" r="r" b="b"/>
            <a:pathLst>
              <a:path w="3" h="9">
                <a:moveTo>
                  <a:pt x="3" y="3"/>
                </a:moveTo>
                <a:lnTo>
                  <a:pt x="3" y="9"/>
                </a:lnTo>
                <a:lnTo>
                  <a:pt x="0" y="6"/>
                </a:lnTo>
                <a:lnTo>
                  <a:pt x="0" y="0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211480" y="4376880"/>
            <a:ext cx="28440" cy="2520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12" y="9"/>
                </a:lnTo>
                <a:lnTo>
                  <a:pt x="0" y="6"/>
                </a:lnTo>
                <a:lnTo>
                  <a:pt x="0" y="0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252520" y="4376880"/>
            <a:ext cx="2556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290680" y="4368960"/>
            <a:ext cx="2556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2328840" y="4361040"/>
            <a:ext cx="25560" cy="2520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0"/>
                </a:moveTo>
                <a:lnTo>
                  <a:pt x="12" y="6"/>
                </a:lnTo>
                <a:lnTo>
                  <a:pt x="0" y="9"/>
                </a:lnTo>
                <a:lnTo>
                  <a:pt x="0" y="3"/>
                </a:lnTo>
                <a:lnTo>
                  <a:pt x="12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367000" y="4352760"/>
            <a:ext cx="25200" cy="2412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0"/>
                </a:moveTo>
                <a:lnTo>
                  <a:pt x="12" y="6"/>
                </a:lnTo>
                <a:lnTo>
                  <a:pt x="0" y="9"/>
                </a:lnTo>
                <a:lnTo>
                  <a:pt x="0" y="3"/>
                </a:lnTo>
                <a:lnTo>
                  <a:pt x="12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405160" y="4352760"/>
            <a:ext cx="27000" cy="162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444760" y="4344840"/>
            <a:ext cx="12600" cy="1620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6"/>
                </a:moveTo>
                <a:lnTo>
                  <a:pt x="3" y="0"/>
                </a:lnTo>
                <a:lnTo>
                  <a:pt x="0" y="0"/>
                </a:lnTo>
                <a:lnTo>
                  <a:pt x="0" y="6"/>
                </a:lnTo>
                <a:lnTo>
                  <a:pt x="3" y="6"/>
                </a:lnTo>
                <a:lnTo>
                  <a:pt x="6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451240" y="4361040"/>
            <a:ext cx="612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451240" y="4336920"/>
            <a:ext cx="19080" cy="24120"/>
          </a:xfrm>
          <a:custGeom>
            <a:avLst/>
            <a:gdLst/>
            <a:ahLst/>
            <a:rect l="l" t="t" r="r" b="b"/>
            <a:pathLst>
              <a:path w="9" h="9">
                <a:moveTo>
                  <a:pt x="6" y="0"/>
                </a:moveTo>
                <a:lnTo>
                  <a:pt x="9" y="6"/>
                </a:lnTo>
                <a:lnTo>
                  <a:pt x="3" y="9"/>
                </a:lnTo>
                <a:lnTo>
                  <a:pt x="0" y="3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476440" y="432900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0" y="0"/>
                </a:moveTo>
                <a:lnTo>
                  <a:pt x="0" y="0"/>
                </a:lnTo>
                <a:lnTo>
                  <a:pt x="3" y="6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476440" y="4329000"/>
            <a:ext cx="4680" cy="18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476440" y="4329000"/>
            <a:ext cx="2556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516040" y="4311720"/>
            <a:ext cx="25560" cy="33120"/>
          </a:xfrm>
          <a:custGeom>
            <a:avLst/>
            <a:gdLst/>
            <a:ahLst/>
            <a:rect l="l" t="t" r="r" b="b"/>
            <a:pathLst>
              <a:path w="12" h="12">
                <a:moveTo>
                  <a:pt x="9" y="0"/>
                </a:moveTo>
                <a:lnTo>
                  <a:pt x="12" y="6"/>
                </a:lnTo>
                <a:lnTo>
                  <a:pt x="3" y="12"/>
                </a:lnTo>
                <a:lnTo>
                  <a:pt x="0" y="6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2541600" y="4280040"/>
            <a:ext cx="25560" cy="31680"/>
          </a:xfrm>
          <a:custGeom>
            <a:avLst/>
            <a:gdLst/>
            <a:ahLst/>
            <a:rect l="l" t="t" r="r" b="b"/>
            <a:pathLst>
              <a:path w="12" h="12">
                <a:moveTo>
                  <a:pt x="9" y="0"/>
                </a:moveTo>
                <a:lnTo>
                  <a:pt x="12" y="3"/>
                </a:lnTo>
                <a:lnTo>
                  <a:pt x="6" y="12"/>
                </a:lnTo>
                <a:lnTo>
                  <a:pt x="0" y="9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567160" y="4254480"/>
            <a:ext cx="12600" cy="17640"/>
          </a:xfrm>
          <a:custGeom>
            <a:avLst/>
            <a:gdLst/>
            <a:ahLst/>
            <a:rect l="l" t="t" r="r" b="b"/>
            <a:pathLst>
              <a:path w="6" h="6">
                <a:moveTo>
                  <a:pt x="3" y="0"/>
                </a:moveTo>
                <a:lnTo>
                  <a:pt x="3" y="0"/>
                </a:lnTo>
                <a:lnTo>
                  <a:pt x="0" y="3"/>
                </a:lnTo>
                <a:lnTo>
                  <a:pt x="3" y="6"/>
                </a:lnTo>
                <a:lnTo>
                  <a:pt x="6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573280" y="4254480"/>
            <a:ext cx="32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573280" y="4246560"/>
            <a:ext cx="19080" cy="25560"/>
          </a:xfrm>
          <a:custGeom>
            <a:avLst/>
            <a:gdLst/>
            <a:ahLst/>
            <a:rect l="l" t="t" r="r" b="b"/>
            <a:pathLst>
              <a:path w="9" h="9">
                <a:moveTo>
                  <a:pt x="9" y="0"/>
                </a:moveTo>
                <a:lnTo>
                  <a:pt x="9" y="6"/>
                </a:lnTo>
                <a:lnTo>
                  <a:pt x="3" y="9"/>
                </a:lnTo>
                <a:lnTo>
                  <a:pt x="0" y="3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602080" y="4254480"/>
            <a:ext cx="12600" cy="17640"/>
          </a:xfrm>
          <a:custGeom>
            <a:avLst/>
            <a:gdLst/>
            <a:ahLst/>
            <a:rect l="l" t="t" r="r" b="b"/>
            <a:pathLst>
              <a:path w="6" h="6">
                <a:moveTo>
                  <a:pt x="3" y="6"/>
                </a:moveTo>
                <a:lnTo>
                  <a:pt x="6" y="3"/>
                </a:lnTo>
                <a:lnTo>
                  <a:pt x="3" y="0"/>
                </a:lnTo>
                <a:lnTo>
                  <a:pt x="0" y="6"/>
                </a:lnTo>
                <a:lnTo>
                  <a:pt x="3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608200" y="4272120"/>
            <a:ext cx="36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2608200" y="4254480"/>
            <a:ext cx="25560" cy="255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9" y="9"/>
                </a:lnTo>
                <a:lnTo>
                  <a:pt x="0" y="6"/>
                </a:lnTo>
                <a:lnTo>
                  <a:pt x="3" y="0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2639880" y="4254480"/>
            <a:ext cx="25560" cy="25560"/>
          </a:xfrm>
          <a:custGeom>
            <a:avLst/>
            <a:gdLst/>
            <a:ahLst/>
            <a:rect l="l" t="t" r="r" b="b"/>
            <a:pathLst>
              <a:path w="12" h="9">
                <a:moveTo>
                  <a:pt x="9" y="0"/>
                </a:moveTo>
                <a:lnTo>
                  <a:pt x="12" y="3"/>
                </a:lnTo>
                <a:lnTo>
                  <a:pt x="3" y="9"/>
                </a:lnTo>
                <a:lnTo>
                  <a:pt x="0" y="3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665440" y="421488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9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2678040" y="4165560"/>
            <a:ext cx="25560" cy="41400"/>
          </a:xfrm>
          <a:custGeom>
            <a:avLst/>
            <a:gdLst/>
            <a:ahLst/>
            <a:rect l="l" t="t" r="r" b="b"/>
            <a:pathLst>
              <a:path w="12" h="15">
                <a:moveTo>
                  <a:pt x="6" y="0"/>
                </a:moveTo>
                <a:lnTo>
                  <a:pt x="12" y="3"/>
                </a:lnTo>
                <a:lnTo>
                  <a:pt x="6" y="15"/>
                </a:lnTo>
                <a:lnTo>
                  <a:pt x="0" y="12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690640" y="4116240"/>
            <a:ext cx="19080" cy="41400"/>
          </a:xfrm>
          <a:custGeom>
            <a:avLst/>
            <a:gdLst/>
            <a:ahLst/>
            <a:rect l="l" t="t" r="r" b="b"/>
            <a:pathLst>
              <a:path w="9" h="15">
                <a:moveTo>
                  <a:pt x="3" y="0"/>
                </a:moveTo>
                <a:lnTo>
                  <a:pt x="9" y="3"/>
                </a:lnTo>
                <a:lnTo>
                  <a:pt x="6" y="15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703600" y="4084560"/>
            <a:ext cx="12600" cy="23760"/>
          </a:xfrm>
          <a:custGeom>
            <a:avLst/>
            <a:gdLst/>
            <a:ahLst/>
            <a:rect l="l" t="t" r="r" b="b"/>
            <a:pathLst>
              <a:path w="6" h="9">
                <a:moveTo>
                  <a:pt x="3" y="0"/>
                </a:moveTo>
                <a:lnTo>
                  <a:pt x="0" y="0"/>
                </a:lnTo>
                <a:lnTo>
                  <a:pt x="0" y="6"/>
                </a:lnTo>
                <a:lnTo>
                  <a:pt x="6" y="9"/>
                </a:lnTo>
                <a:lnTo>
                  <a:pt x="6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709720" y="4075200"/>
            <a:ext cx="12960" cy="17280"/>
          </a:xfrm>
          <a:custGeom>
            <a:avLst/>
            <a:gdLst/>
            <a:ahLst/>
            <a:rect l="l" t="t" r="r" b="b"/>
            <a:pathLst>
              <a:path w="6" h="6">
                <a:moveTo>
                  <a:pt x="3" y="0"/>
                </a:moveTo>
                <a:lnTo>
                  <a:pt x="6" y="3"/>
                </a:lnTo>
                <a:lnTo>
                  <a:pt x="3" y="6"/>
                </a:lnTo>
                <a:lnTo>
                  <a:pt x="0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722680" y="4075200"/>
            <a:ext cx="19080" cy="41040"/>
          </a:xfrm>
          <a:custGeom>
            <a:avLst/>
            <a:gdLst/>
            <a:ahLst/>
            <a:rect l="l" t="t" r="r" b="b"/>
            <a:pathLst>
              <a:path w="9" h="15">
                <a:moveTo>
                  <a:pt x="9" y="12"/>
                </a:moveTo>
                <a:lnTo>
                  <a:pt x="6" y="15"/>
                </a:lnTo>
                <a:lnTo>
                  <a:pt x="0" y="3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2735280" y="4124160"/>
            <a:ext cx="25560" cy="33480"/>
          </a:xfrm>
          <a:custGeom>
            <a:avLst/>
            <a:gdLst/>
            <a:ahLst/>
            <a:rect l="l" t="t" r="r" b="b"/>
            <a:pathLst>
              <a:path w="12" h="12">
                <a:moveTo>
                  <a:pt x="12" y="9"/>
                </a:moveTo>
                <a:lnTo>
                  <a:pt x="6" y="12"/>
                </a:lnTo>
                <a:lnTo>
                  <a:pt x="0" y="0"/>
                </a:lnTo>
                <a:lnTo>
                  <a:pt x="6" y="0"/>
                </a:lnTo>
                <a:lnTo>
                  <a:pt x="12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754360" y="416556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6" y="12"/>
                </a:lnTo>
                <a:lnTo>
                  <a:pt x="0" y="3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773440" y="4206960"/>
            <a:ext cx="20520" cy="39600"/>
          </a:xfrm>
          <a:custGeom>
            <a:avLst/>
            <a:gdLst/>
            <a:ahLst/>
            <a:rect l="l" t="t" r="r" b="b"/>
            <a:pathLst>
              <a:path w="9" h="15">
                <a:moveTo>
                  <a:pt x="6" y="15"/>
                </a:moveTo>
                <a:lnTo>
                  <a:pt x="9" y="9"/>
                </a:lnTo>
                <a:lnTo>
                  <a:pt x="3" y="0"/>
                </a:lnTo>
                <a:lnTo>
                  <a:pt x="0" y="3"/>
                </a:lnTo>
                <a:lnTo>
                  <a:pt x="3" y="12"/>
                </a:lnTo>
                <a:lnTo>
                  <a:pt x="6" y="15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779560" y="4238640"/>
            <a:ext cx="7920" cy="7920"/>
          </a:xfrm>
          <a:custGeom>
            <a:avLst/>
            <a:gdLst/>
            <a:ahLst/>
            <a:rect l="l" t="t" r="r" b="b"/>
            <a:pathLst>
              <a:path w="3" h="3">
                <a:moveTo>
                  <a:pt x="3" y="3"/>
                </a:moveTo>
                <a:lnTo>
                  <a:pt x="3" y="3"/>
                </a:lnTo>
                <a:lnTo>
                  <a:pt x="0" y="0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787480" y="423072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0"/>
                </a:moveTo>
                <a:lnTo>
                  <a:pt x="0" y="6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800440" y="4238640"/>
            <a:ext cx="25200" cy="255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6"/>
                </a:moveTo>
                <a:lnTo>
                  <a:pt x="12" y="3"/>
                </a:lnTo>
                <a:lnTo>
                  <a:pt x="3" y="0"/>
                </a:lnTo>
                <a:lnTo>
                  <a:pt x="0" y="6"/>
                </a:lnTo>
                <a:lnTo>
                  <a:pt x="9" y="9"/>
                </a:lnTo>
                <a:lnTo>
                  <a:pt x="12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819520" y="4254480"/>
            <a:ext cx="6120" cy="9720"/>
          </a:xfrm>
          <a:custGeom>
            <a:avLst/>
            <a:gdLst/>
            <a:ahLst/>
            <a:rect l="l" t="t" r="r" b="b"/>
            <a:pathLst>
              <a:path w="3" h="3">
                <a:moveTo>
                  <a:pt x="3" y="0"/>
                </a:moveTo>
                <a:lnTo>
                  <a:pt x="3" y="3"/>
                </a:lnTo>
                <a:lnTo>
                  <a:pt x="0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813040" y="4238640"/>
            <a:ext cx="19080" cy="15840"/>
          </a:xfrm>
          <a:custGeom>
            <a:avLst/>
            <a:gdLst/>
            <a:ahLst/>
            <a:rect l="l" t="t" r="r" b="b"/>
            <a:pathLst>
              <a:path w="9" h="6">
                <a:moveTo>
                  <a:pt x="3" y="0"/>
                </a:moveTo>
                <a:lnTo>
                  <a:pt x="9" y="3"/>
                </a:lnTo>
                <a:lnTo>
                  <a:pt x="6" y="6"/>
                </a:lnTo>
                <a:lnTo>
                  <a:pt x="0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825640" y="4206960"/>
            <a:ext cx="25560" cy="31680"/>
          </a:xfrm>
          <a:custGeom>
            <a:avLst/>
            <a:gdLst/>
            <a:ahLst/>
            <a:rect l="l" t="t" r="r" b="b"/>
            <a:pathLst>
              <a:path w="12" h="12">
                <a:moveTo>
                  <a:pt x="12" y="3"/>
                </a:moveTo>
                <a:lnTo>
                  <a:pt x="6" y="0"/>
                </a:lnTo>
                <a:lnTo>
                  <a:pt x="0" y="6"/>
                </a:lnTo>
                <a:lnTo>
                  <a:pt x="6" y="12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851200" y="4214880"/>
            <a:ext cx="468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838600" y="4197240"/>
            <a:ext cx="12600" cy="17640"/>
          </a:xfrm>
          <a:custGeom>
            <a:avLst/>
            <a:gdLst/>
            <a:ahLst/>
            <a:rect l="l" t="t" r="r" b="b"/>
            <a:pathLst>
              <a:path w="6" h="6">
                <a:moveTo>
                  <a:pt x="0" y="0"/>
                </a:moveTo>
                <a:lnTo>
                  <a:pt x="6" y="3"/>
                </a:lnTo>
                <a:lnTo>
                  <a:pt x="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838600" y="4149720"/>
            <a:ext cx="19080" cy="39600"/>
          </a:xfrm>
          <a:custGeom>
            <a:avLst/>
            <a:gdLst/>
            <a:ahLst/>
            <a:rect l="l" t="t" r="r" b="b"/>
            <a:pathLst>
              <a:path w="9" h="15">
                <a:moveTo>
                  <a:pt x="3" y="0"/>
                </a:moveTo>
                <a:lnTo>
                  <a:pt x="9" y="3"/>
                </a:lnTo>
                <a:lnTo>
                  <a:pt x="6" y="15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844720" y="410832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851200" y="4084560"/>
            <a:ext cx="19080" cy="7920"/>
          </a:xfrm>
          <a:custGeom>
            <a:avLst/>
            <a:gdLst/>
            <a:ahLst/>
            <a:rect l="l" t="t" r="r" b="b"/>
            <a:pathLst>
              <a:path w="9" h="3">
                <a:moveTo>
                  <a:pt x="9" y="0"/>
                </a:moveTo>
                <a:lnTo>
                  <a:pt x="3" y="0"/>
                </a:lnTo>
                <a:lnTo>
                  <a:pt x="0" y="3"/>
                </a:lnTo>
                <a:lnTo>
                  <a:pt x="6" y="3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870280" y="4084560"/>
            <a:ext cx="4680" cy="18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857680" y="4059360"/>
            <a:ext cx="12600" cy="252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857680" y="401004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857680" y="3962520"/>
            <a:ext cx="2052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863800" y="3913200"/>
            <a:ext cx="144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863800" y="3863880"/>
            <a:ext cx="2052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870280" y="3840120"/>
            <a:ext cx="14040" cy="79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2884320" y="3840120"/>
            <a:ext cx="3240" cy="18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870280" y="3814920"/>
            <a:ext cx="14040" cy="252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870280" y="3765600"/>
            <a:ext cx="1404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870280" y="3718080"/>
            <a:ext cx="1404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870280" y="3668760"/>
            <a:ext cx="14040" cy="31680"/>
          </a:xfrm>
          <a:custGeom>
            <a:avLst/>
            <a:gdLst/>
            <a:ahLst/>
            <a:rect l="l" t="t" r="r" b="b"/>
            <a:pathLst>
              <a:path w="6" h="12">
                <a:moveTo>
                  <a:pt x="3" y="0"/>
                </a:moveTo>
                <a:lnTo>
                  <a:pt x="6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878200" y="361944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878200" y="357012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878200" y="352116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878200" y="3497400"/>
            <a:ext cx="1260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0" y="0"/>
                </a:moveTo>
                <a:lnTo>
                  <a:pt x="0" y="0"/>
                </a:lnTo>
                <a:lnTo>
                  <a:pt x="0" y="3"/>
                </a:lnTo>
                <a:lnTo>
                  <a:pt x="6" y="3"/>
                </a:lnTo>
                <a:lnTo>
                  <a:pt x="6" y="0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878200" y="3497400"/>
            <a:ext cx="324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2878200" y="3471840"/>
            <a:ext cx="12600" cy="2556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878200" y="342432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884320" y="3375000"/>
            <a:ext cx="1296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884320" y="3325680"/>
            <a:ext cx="1296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884320" y="3276720"/>
            <a:ext cx="1296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884320" y="3227400"/>
            <a:ext cx="1296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884320" y="3187800"/>
            <a:ext cx="12960" cy="23760"/>
          </a:xfrm>
          <a:custGeom>
            <a:avLst/>
            <a:gdLst/>
            <a:ahLst/>
            <a:rect l="l" t="t" r="r" b="b"/>
            <a:pathLst>
              <a:path w="6" h="9">
                <a:moveTo>
                  <a:pt x="6" y="0"/>
                </a:moveTo>
                <a:lnTo>
                  <a:pt x="3" y="0"/>
                </a:lnTo>
                <a:lnTo>
                  <a:pt x="0" y="9"/>
                </a:lnTo>
                <a:lnTo>
                  <a:pt x="6" y="9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897280" y="3187800"/>
            <a:ext cx="324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890800" y="3179880"/>
            <a:ext cx="1260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0" y="0"/>
                </a:moveTo>
                <a:lnTo>
                  <a:pt x="6" y="0"/>
                </a:lnTo>
                <a:lnTo>
                  <a:pt x="3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890800" y="313056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890800" y="308124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2890800" y="303228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890800" y="298296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890800" y="293544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890800" y="288612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897280" y="2836800"/>
            <a:ext cx="12600" cy="31680"/>
          </a:xfrm>
          <a:custGeom>
            <a:avLst/>
            <a:gdLst/>
            <a:ahLst/>
            <a:rect l="l" t="t" r="r" b="b"/>
            <a:pathLst>
              <a:path w="6" h="12">
                <a:moveTo>
                  <a:pt x="0" y="0"/>
                </a:moveTo>
                <a:lnTo>
                  <a:pt x="0" y="0"/>
                </a:lnTo>
                <a:lnTo>
                  <a:pt x="0" y="12"/>
                </a:lnTo>
                <a:lnTo>
                  <a:pt x="6" y="12"/>
                </a:lnTo>
                <a:lnTo>
                  <a:pt x="6" y="0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897280" y="2836800"/>
            <a:ext cx="32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897280" y="2836800"/>
            <a:ext cx="1260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897280" y="278748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903400" y="2763720"/>
            <a:ext cx="1296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6" y="0"/>
                </a:moveTo>
                <a:lnTo>
                  <a:pt x="3" y="0"/>
                </a:lnTo>
                <a:lnTo>
                  <a:pt x="0" y="3"/>
                </a:lnTo>
                <a:lnTo>
                  <a:pt x="6" y="3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909880" y="2714760"/>
            <a:ext cx="6480" cy="48960"/>
          </a:xfrm>
          <a:custGeom>
            <a:avLst/>
            <a:gdLst/>
            <a:ahLst/>
            <a:rect l="l" t="t" r="r" b="b"/>
            <a:pathLst>
              <a:path w="3" h="18">
                <a:moveTo>
                  <a:pt x="0" y="18"/>
                </a:moveTo>
                <a:lnTo>
                  <a:pt x="3" y="0"/>
                </a:lnTo>
                <a:lnTo>
                  <a:pt x="3" y="18"/>
                </a:lnTo>
                <a:lnTo>
                  <a:pt x="0" y="18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909880" y="2763720"/>
            <a:ext cx="12600" cy="23760"/>
          </a:xfrm>
          <a:custGeom>
            <a:avLst/>
            <a:gdLst/>
            <a:ahLst/>
            <a:rect l="l" t="t" r="r" b="b"/>
            <a:pathLst>
              <a:path w="6" h="9">
                <a:moveTo>
                  <a:pt x="6" y="9"/>
                </a:moveTo>
                <a:lnTo>
                  <a:pt x="0" y="9"/>
                </a:lnTo>
                <a:lnTo>
                  <a:pt x="0" y="0"/>
                </a:lnTo>
                <a:lnTo>
                  <a:pt x="3" y="0"/>
                </a:lnTo>
                <a:lnTo>
                  <a:pt x="6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909880" y="2803680"/>
            <a:ext cx="19080" cy="3312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916360" y="285264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916360" y="290196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922480" y="2951280"/>
            <a:ext cx="1296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922480" y="3000240"/>
            <a:ext cx="12960" cy="320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928960" y="304812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928960" y="309708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928960" y="314640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935440" y="319572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935440" y="3244680"/>
            <a:ext cx="12600" cy="8280"/>
          </a:xfrm>
          <a:custGeom>
            <a:avLst/>
            <a:gdLst/>
            <a:ahLst/>
            <a:rect l="l" t="t" r="r" b="b"/>
            <a:pathLst>
              <a:path w="6" h="3">
                <a:moveTo>
                  <a:pt x="0" y="3"/>
                </a:moveTo>
                <a:lnTo>
                  <a:pt x="6" y="0"/>
                </a:lnTo>
                <a:lnTo>
                  <a:pt x="0" y="0"/>
                </a:lnTo>
                <a:lnTo>
                  <a:pt x="0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935440" y="3252960"/>
            <a:ext cx="288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935440" y="3244680"/>
            <a:ext cx="12600" cy="32040"/>
          </a:xfrm>
          <a:custGeom>
            <a:avLst/>
            <a:gdLst/>
            <a:ahLst/>
            <a:rect l="l" t="t" r="r" b="b"/>
            <a:pathLst>
              <a:path w="6" h="12">
                <a:moveTo>
                  <a:pt x="6" y="12"/>
                </a:moveTo>
                <a:lnTo>
                  <a:pt x="0" y="12"/>
                </a:lnTo>
                <a:lnTo>
                  <a:pt x="0" y="3"/>
                </a:lnTo>
                <a:lnTo>
                  <a:pt x="6" y="0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935440" y="3292560"/>
            <a:ext cx="18720" cy="3312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941560" y="334152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2941560" y="339084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948040" y="344016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2948040" y="3489480"/>
            <a:ext cx="324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2948040" y="3489480"/>
            <a:ext cx="12600" cy="31680"/>
          </a:xfrm>
          <a:custGeom>
            <a:avLst/>
            <a:gdLst/>
            <a:ahLst/>
            <a:rect l="l" t="t" r="r" b="b"/>
            <a:pathLst>
              <a:path w="6" h="12">
                <a:moveTo>
                  <a:pt x="6" y="9"/>
                </a:moveTo>
                <a:lnTo>
                  <a:pt x="0" y="12"/>
                </a:lnTo>
                <a:lnTo>
                  <a:pt x="0" y="0"/>
                </a:lnTo>
                <a:lnTo>
                  <a:pt x="6" y="0"/>
                </a:lnTo>
                <a:lnTo>
                  <a:pt x="6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2954160" y="3529080"/>
            <a:ext cx="16200" cy="41040"/>
          </a:xfrm>
          <a:custGeom>
            <a:avLst/>
            <a:gdLst/>
            <a:ahLst/>
            <a:rect l="l" t="t" r="r" b="b"/>
            <a:pathLst>
              <a:path w="6" h="15">
                <a:moveTo>
                  <a:pt x="6" y="12"/>
                </a:moveTo>
                <a:lnTo>
                  <a:pt x="0" y="15"/>
                </a:lnTo>
                <a:lnTo>
                  <a:pt x="0" y="3"/>
                </a:lnTo>
                <a:lnTo>
                  <a:pt x="6" y="0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2954160" y="3578400"/>
            <a:ext cx="22320" cy="41040"/>
          </a:xfrm>
          <a:custGeom>
            <a:avLst/>
            <a:gdLst/>
            <a:ahLst/>
            <a:rect l="l" t="t" r="r" b="b"/>
            <a:pathLst>
              <a:path w="9" h="15">
                <a:moveTo>
                  <a:pt x="9" y="12"/>
                </a:moveTo>
                <a:lnTo>
                  <a:pt x="3" y="15"/>
                </a:lnTo>
                <a:lnTo>
                  <a:pt x="0" y="3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960640" y="3627360"/>
            <a:ext cx="15840" cy="41400"/>
          </a:xfrm>
          <a:custGeom>
            <a:avLst/>
            <a:gdLst/>
            <a:ahLst/>
            <a:rect l="l" t="t" r="r" b="b"/>
            <a:pathLst>
              <a:path w="6" h="15">
                <a:moveTo>
                  <a:pt x="6" y="12"/>
                </a:moveTo>
                <a:lnTo>
                  <a:pt x="0" y="15"/>
                </a:lnTo>
                <a:lnTo>
                  <a:pt x="0" y="3"/>
                </a:lnTo>
                <a:lnTo>
                  <a:pt x="6" y="0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960640" y="3676680"/>
            <a:ext cx="22320" cy="41400"/>
          </a:xfrm>
          <a:custGeom>
            <a:avLst/>
            <a:gdLst/>
            <a:ahLst/>
            <a:rect l="l" t="t" r="r" b="b"/>
            <a:pathLst>
              <a:path w="9" h="15">
                <a:moveTo>
                  <a:pt x="9" y="12"/>
                </a:moveTo>
                <a:lnTo>
                  <a:pt x="3" y="15"/>
                </a:lnTo>
                <a:lnTo>
                  <a:pt x="0" y="3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2970360" y="3726000"/>
            <a:ext cx="1260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0" y="3"/>
                </a:moveTo>
                <a:lnTo>
                  <a:pt x="6" y="3"/>
                </a:lnTo>
                <a:lnTo>
                  <a:pt x="6" y="0"/>
                </a:lnTo>
                <a:lnTo>
                  <a:pt x="0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970360" y="3733920"/>
            <a:ext cx="36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2970360" y="3733920"/>
            <a:ext cx="12600" cy="31680"/>
          </a:xfrm>
          <a:custGeom>
            <a:avLst/>
            <a:gdLst/>
            <a:ahLst/>
            <a:rect l="l" t="t" r="r" b="b"/>
            <a:pathLst>
              <a:path w="6" h="12">
                <a:moveTo>
                  <a:pt x="6" y="9"/>
                </a:moveTo>
                <a:lnTo>
                  <a:pt x="0" y="12"/>
                </a:lnTo>
                <a:lnTo>
                  <a:pt x="0" y="0"/>
                </a:lnTo>
                <a:lnTo>
                  <a:pt x="6" y="0"/>
                </a:lnTo>
                <a:lnTo>
                  <a:pt x="6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2976480" y="3773520"/>
            <a:ext cx="12960" cy="33480"/>
          </a:xfrm>
          <a:custGeom>
            <a:avLst/>
            <a:gdLst/>
            <a:ahLst/>
            <a:rect l="l" t="t" r="r" b="b"/>
            <a:pathLst>
              <a:path w="6" h="12">
                <a:moveTo>
                  <a:pt x="6" y="12"/>
                </a:moveTo>
                <a:lnTo>
                  <a:pt x="0" y="12"/>
                </a:lnTo>
                <a:lnTo>
                  <a:pt x="0" y="3"/>
                </a:lnTo>
                <a:lnTo>
                  <a:pt x="6" y="0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982960" y="3822840"/>
            <a:ext cx="12600" cy="33120"/>
          </a:xfrm>
          <a:custGeom>
            <a:avLst/>
            <a:gdLst/>
            <a:ahLst/>
            <a:rect l="l" t="t" r="r" b="b"/>
            <a:pathLst>
              <a:path w="6" h="12">
                <a:moveTo>
                  <a:pt x="6" y="12"/>
                </a:moveTo>
                <a:lnTo>
                  <a:pt x="0" y="12"/>
                </a:lnTo>
                <a:lnTo>
                  <a:pt x="0" y="0"/>
                </a:lnTo>
                <a:lnTo>
                  <a:pt x="3" y="0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982960" y="3871800"/>
            <a:ext cx="19080" cy="23760"/>
          </a:xfrm>
          <a:custGeom>
            <a:avLst/>
            <a:gdLst/>
            <a:ahLst/>
            <a:rect l="l" t="t" r="r" b="b"/>
            <a:pathLst>
              <a:path w="9" h="9">
                <a:moveTo>
                  <a:pt x="3" y="9"/>
                </a:moveTo>
                <a:lnTo>
                  <a:pt x="9" y="9"/>
                </a:lnTo>
                <a:lnTo>
                  <a:pt x="6" y="0"/>
                </a:lnTo>
                <a:lnTo>
                  <a:pt x="0" y="0"/>
                </a:lnTo>
                <a:lnTo>
                  <a:pt x="3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989440" y="3895560"/>
            <a:ext cx="36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2989440" y="3895560"/>
            <a:ext cx="12600" cy="97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2995560" y="392112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008160" y="3962520"/>
            <a:ext cx="19080" cy="39600"/>
          </a:xfrm>
          <a:custGeom>
            <a:avLst/>
            <a:gdLst/>
            <a:ahLst/>
            <a:rect l="l" t="t" r="r" b="b"/>
            <a:pathLst>
              <a:path w="9" h="15">
                <a:moveTo>
                  <a:pt x="9" y="12"/>
                </a:moveTo>
                <a:lnTo>
                  <a:pt x="3" y="15"/>
                </a:lnTo>
                <a:lnTo>
                  <a:pt x="0" y="3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014640" y="4010040"/>
            <a:ext cx="12600" cy="9360"/>
          </a:xfrm>
          <a:custGeom>
            <a:avLst/>
            <a:gdLst/>
            <a:ahLst/>
            <a:rect l="l" t="t" r="r" b="b"/>
            <a:pathLst>
              <a:path w="6" h="3">
                <a:moveTo>
                  <a:pt x="3" y="3"/>
                </a:moveTo>
                <a:lnTo>
                  <a:pt x="6" y="0"/>
                </a:lnTo>
                <a:lnTo>
                  <a:pt x="0" y="3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021120" y="4010040"/>
            <a:ext cx="19080" cy="41400"/>
          </a:xfrm>
          <a:custGeom>
            <a:avLst/>
            <a:gdLst/>
            <a:ahLst/>
            <a:rect l="l" t="t" r="r" b="b"/>
            <a:pathLst>
              <a:path w="9" h="15">
                <a:moveTo>
                  <a:pt x="9" y="12"/>
                </a:moveTo>
                <a:lnTo>
                  <a:pt x="3" y="15"/>
                </a:lnTo>
                <a:lnTo>
                  <a:pt x="0" y="3"/>
                </a:lnTo>
                <a:lnTo>
                  <a:pt x="3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033720" y="4051440"/>
            <a:ext cx="25560" cy="41040"/>
          </a:xfrm>
          <a:custGeom>
            <a:avLst/>
            <a:gdLst/>
            <a:ahLst/>
            <a:rect l="l" t="t" r="r" b="b"/>
            <a:pathLst>
              <a:path w="12" h="15">
                <a:moveTo>
                  <a:pt x="12" y="12"/>
                </a:moveTo>
                <a:lnTo>
                  <a:pt x="6" y="15"/>
                </a:lnTo>
                <a:lnTo>
                  <a:pt x="0" y="3"/>
                </a:lnTo>
                <a:lnTo>
                  <a:pt x="6" y="0"/>
                </a:lnTo>
                <a:lnTo>
                  <a:pt x="12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052800" y="4092480"/>
            <a:ext cx="25200" cy="39960"/>
          </a:xfrm>
          <a:custGeom>
            <a:avLst/>
            <a:gdLst/>
            <a:ahLst/>
            <a:rect l="l" t="t" r="r" b="b"/>
            <a:pathLst>
              <a:path w="12" h="15">
                <a:moveTo>
                  <a:pt x="12" y="9"/>
                </a:moveTo>
                <a:lnTo>
                  <a:pt x="9" y="15"/>
                </a:lnTo>
                <a:lnTo>
                  <a:pt x="0" y="6"/>
                </a:lnTo>
                <a:lnTo>
                  <a:pt x="6" y="0"/>
                </a:lnTo>
                <a:lnTo>
                  <a:pt x="12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078000" y="4132440"/>
            <a:ext cx="12960" cy="17280"/>
          </a:xfrm>
          <a:custGeom>
            <a:avLst/>
            <a:gdLst/>
            <a:ahLst/>
            <a:rect l="l" t="t" r="r" b="b"/>
            <a:pathLst>
              <a:path w="6" h="6">
                <a:moveTo>
                  <a:pt x="3" y="6"/>
                </a:moveTo>
                <a:lnTo>
                  <a:pt x="6" y="0"/>
                </a:lnTo>
                <a:lnTo>
                  <a:pt x="0" y="3"/>
                </a:lnTo>
                <a:lnTo>
                  <a:pt x="3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078000" y="4141800"/>
            <a:ext cx="6480" cy="7920"/>
          </a:xfrm>
          <a:custGeom>
            <a:avLst/>
            <a:gdLst/>
            <a:ahLst/>
            <a:rect l="l" t="t" r="r" b="b"/>
            <a:pathLst>
              <a:path w="3" h="3">
                <a:moveTo>
                  <a:pt x="3" y="3"/>
                </a:moveTo>
                <a:lnTo>
                  <a:pt x="3" y="3"/>
                </a:lnTo>
                <a:lnTo>
                  <a:pt x="0" y="0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084480" y="4124160"/>
            <a:ext cx="25560" cy="255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9" y="0"/>
                </a:lnTo>
                <a:lnTo>
                  <a:pt x="0" y="3"/>
                </a:lnTo>
                <a:lnTo>
                  <a:pt x="0" y="9"/>
                </a:lnTo>
                <a:lnTo>
                  <a:pt x="9" y="6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103560" y="4132440"/>
            <a:ext cx="6480" cy="9360"/>
          </a:xfrm>
          <a:custGeom>
            <a:avLst/>
            <a:gdLst/>
            <a:ahLst/>
            <a:rect l="l" t="t" r="r" b="b"/>
            <a:pathLst>
              <a:path w="3" h="3">
                <a:moveTo>
                  <a:pt x="3" y="0"/>
                </a:moveTo>
                <a:lnTo>
                  <a:pt x="3" y="3"/>
                </a:lnTo>
                <a:lnTo>
                  <a:pt x="0" y="3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097080" y="4124160"/>
            <a:ext cx="12960" cy="8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3097080" y="4075200"/>
            <a:ext cx="19080" cy="3312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103560" y="4027320"/>
            <a:ext cx="12600" cy="320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110040" y="397836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3110040" y="392904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110040" y="387972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116160" y="3830760"/>
            <a:ext cx="1296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116160" y="3782880"/>
            <a:ext cx="12960" cy="32040"/>
          </a:xfrm>
          <a:custGeom>
            <a:avLst/>
            <a:gdLst/>
            <a:ahLst/>
            <a:rect l="l" t="t" r="r" b="b"/>
            <a:pathLst>
              <a:path w="6" h="12">
                <a:moveTo>
                  <a:pt x="0" y="0"/>
                </a:moveTo>
                <a:lnTo>
                  <a:pt x="6" y="3"/>
                </a:lnTo>
                <a:lnTo>
                  <a:pt x="6" y="12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122640" y="3733920"/>
            <a:ext cx="12600" cy="39600"/>
          </a:xfrm>
          <a:custGeom>
            <a:avLst/>
            <a:gdLst/>
            <a:ahLst/>
            <a:rect l="l" t="t" r="r" b="b"/>
            <a:pathLst>
              <a:path w="6" h="15">
                <a:moveTo>
                  <a:pt x="0" y="0"/>
                </a:moveTo>
                <a:lnTo>
                  <a:pt x="6" y="3"/>
                </a:lnTo>
                <a:lnTo>
                  <a:pt x="6" y="15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122640" y="3700440"/>
            <a:ext cx="12600" cy="25560"/>
          </a:xfrm>
          <a:custGeom>
            <a:avLst/>
            <a:gdLst/>
            <a:ahLst/>
            <a:rect l="l" t="t" r="r" b="b"/>
            <a:pathLst>
              <a:path w="6" h="9">
                <a:moveTo>
                  <a:pt x="6" y="0"/>
                </a:moveTo>
                <a:lnTo>
                  <a:pt x="0" y="0"/>
                </a:lnTo>
                <a:lnTo>
                  <a:pt x="0" y="6"/>
                </a:lnTo>
                <a:lnTo>
                  <a:pt x="6" y="9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135240" y="3700440"/>
            <a:ext cx="32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3122640" y="3684600"/>
            <a:ext cx="126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122640" y="3635280"/>
            <a:ext cx="12600" cy="41400"/>
          </a:xfrm>
          <a:custGeom>
            <a:avLst/>
            <a:gdLst/>
            <a:ahLst/>
            <a:rect l="l" t="t" r="r" b="b"/>
            <a:pathLst>
              <a:path w="6" h="15">
                <a:moveTo>
                  <a:pt x="0" y="0"/>
                </a:moveTo>
                <a:lnTo>
                  <a:pt x="6" y="3"/>
                </a:lnTo>
                <a:lnTo>
                  <a:pt x="6" y="15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122640" y="3586320"/>
            <a:ext cx="12600" cy="41040"/>
          </a:xfrm>
          <a:custGeom>
            <a:avLst/>
            <a:gdLst/>
            <a:ahLst/>
            <a:rect l="l" t="t" r="r" b="b"/>
            <a:pathLst>
              <a:path w="6" h="15">
                <a:moveTo>
                  <a:pt x="0" y="0"/>
                </a:moveTo>
                <a:lnTo>
                  <a:pt x="6" y="3"/>
                </a:lnTo>
                <a:lnTo>
                  <a:pt x="6" y="15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122640" y="3538440"/>
            <a:ext cx="19080" cy="39960"/>
          </a:xfrm>
          <a:custGeom>
            <a:avLst/>
            <a:gdLst/>
            <a:ahLst/>
            <a:rect l="l" t="t" r="r" b="b"/>
            <a:pathLst>
              <a:path w="9" h="15">
                <a:moveTo>
                  <a:pt x="3" y="0"/>
                </a:moveTo>
                <a:lnTo>
                  <a:pt x="9" y="3"/>
                </a:lnTo>
                <a:lnTo>
                  <a:pt x="6" y="15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129120" y="3489480"/>
            <a:ext cx="12600" cy="39600"/>
          </a:xfrm>
          <a:custGeom>
            <a:avLst/>
            <a:gdLst/>
            <a:ahLst/>
            <a:rect l="l" t="t" r="r" b="b"/>
            <a:pathLst>
              <a:path w="6" h="15">
                <a:moveTo>
                  <a:pt x="0" y="0"/>
                </a:moveTo>
                <a:lnTo>
                  <a:pt x="6" y="3"/>
                </a:lnTo>
                <a:lnTo>
                  <a:pt x="6" y="15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3129120" y="3440160"/>
            <a:ext cx="12600" cy="41400"/>
          </a:xfrm>
          <a:custGeom>
            <a:avLst/>
            <a:gdLst/>
            <a:ahLst/>
            <a:rect l="l" t="t" r="r" b="b"/>
            <a:pathLst>
              <a:path w="6" h="15">
                <a:moveTo>
                  <a:pt x="0" y="0"/>
                </a:moveTo>
                <a:lnTo>
                  <a:pt x="6" y="3"/>
                </a:lnTo>
                <a:lnTo>
                  <a:pt x="6" y="15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129120" y="3390840"/>
            <a:ext cx="12600" cy="41400"/>
          </a:xfrm>
          <a:custGeom>
            <a:avLst/>
            <a:gdLst/>
            <a:ahLst/>
            <a:rect l="l" t="t" r="r" b="b"/>
            <a:pathLst>
              <a:path w="6" h="15">
                <a:moveTo>
                  <a:pt x="0" y="0"/>
                </a:moveTo>
                <a:lnTo>
                  <a:pt x="6" y="3"/>
                </a:lnTo>
                <a:lnTo>
                  <a:pt x="6" y="15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129120" y="3375000"/>
            <a:ext cx="12600" cy="79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3141720" y="3375000"/>
            <a:ext cx="32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3129120" y="3349800"/>
            <a:ext cx="12600" cy="252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129120" y="330192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129120" y="325296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129120" y="320364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3135240" y="315432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135240" y="3105000"/>
            <a:ext cx="12600" cy="33480"/>
          </a:xfrm>
          <a:custGeom>
            <a:avLst/>
            <a:gdLst/>
            <a:ahLst/>
            <a:rect l="l" t="t" r="r" b="b"/>
            <a:pathLst>
              <a:path w="6" h="12">
                <a:moveTo>
                  <a:pt x="0" y="0"/>
                </a:moveTo>
                <a:lnTo>
                  <a:pt x="0" y="0"/>
                </a:lnTo>
                <a:lnTo>
                  <a:pt x="0" y="12"/>
                </a:lnTo>
                <a:lnTo>
                  <a:pt x="6" y="12"/>
                </a:lnTo>
                <a:lnTo>
                  <a:pt x="6" y="0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135240" y="3105000"/>
            <a:ext cx="32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135240" y="3105000"/>
            <a:ext cx="1260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135240" y="305748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135240" y="3008160"/>
            <a:ext cx="12600" cy="320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3141720" y="2959200"/>
            <a:ext cx="144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3141720" y="2935440"/>
            <a:ext cx="1440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0" y="0"/>
                </a:moveTo>
                <a:lnTo>
                  <a:pt x="0" y="0"/>
                </a:lnTo>
                <a:lnTo>
                  <a:pt x="0" y="3"/>
                </a:lnTo>
                <a:lnTo>
                  <a:pt x="6" y="3"/>
                </a:lnTo>
                <a:lnTo>
                  <a:pt x="6" y="0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3141720" y="2935440"/>
            <a:ext cx="324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141720" y="2909880"/>
            <a:ext cx="14400" cy="2556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141720" y="2860560"/>
            <a:ext cx="2052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3" y="0"/>
                </a:moveTo>
                <a:lnTo>
                  <a:pt x="9" y="0"/>
                </a:lnTo>
                <a:lnTo>
                  <a:pt x="6" y="12"/>
                </a:lnTo>
                <a:lnTo>
                  <a:pt x="0" y="12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3147840" y="2813040"/>
            <a:ext cx="144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3147840" y="2763720"/>
            <a:ext cx="14400" cy="49320"/>
          </a:xfrm>
          <a:custGeom>
            <a:avLst/>
            <a:gdLst/>
            <a:ahLst/>
            <a:rect l="l" t="t" r="r" b="b"/>
            <a:pathLst>
              <a:path w="6" h="18">
                <a:moveTo>
                  <a:pt x="0" y="18"/>
                </a:moveTo>
                <a:lnTo>
                  <a:pt x="0" y="0"/>
                </a:lnTo>
                <a:lnTo>
                  <a:pt x="6" y="18"/>
                </a:lnTo>
                <a:lnTo>
                  <a:pt x="0" y="18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3147840" y="2813040"/>
            <a:ext cx="1440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6" y="0"/>
                </a:moveTo>
                <a:lnTo>
                  <a:pt x="0" y="3"/>
                </a:lnTo>
                <a:lnTo>
                  <a:pt x="0" y="0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3156120" y="2828880"/>
            <a:ext cx="1872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9" y="12"/>
                </a:lnTo>
                <a:lnTo>
                  <a:pt x="6" y="0"/>
                </a:lnTo>
                <a:lnTo>
                  <a:pt x="0" y="3"/>
                </a:lnTo>
                <a:lnTo>
                  <a:pt x="3" y="12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3174840" y="2860560"/>
            <a:ext cx="180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3162240" y="2860560"/>
            <a:ext cx="1260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6" y="0"/>
                </a:moveTo>
                <a:lnTo>
                  <a:pt x="0" y="3"/>
                </a:lnTo>
                <a:lnTo>
                  <a:pt x="0" y="0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3162240" y="2878200"/>
            <a:ext cx="12600" cy="31680"/>
          </a:xfrm>
          <a:custGeom>
            <a:avLst/>
            <a:gdLst/>
            <a:ahLst/>
            <a:rect l="l" t="t" r="r" b="b"/>
            <a:pathLst>
              <a:path w="6" h="12">
                <a:moveTo>
                  <a:pt x="6" y="12"/>
                </a:moveTo>
                <a:lnTo>
                  <a:pt x="0" y="12"/>
                </a:lnTo>
                <a:lnTo>
                  <a:pt x="0" y="3"/>
                </a:lnTo>
                <a:lnTo>
                  <a:pt x="6" y="0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3162240" y="292572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3168720" y="297504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168720" y="302436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168720" y="307332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3174840" y="3122640"/>
            <a:ext cx="1296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174840" y="3170160"/>
            <a:ext cx="1296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174840" y="3219480"/>
            <a:ext cx="1296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174840" y="3268800"/>
            <a:ext cx="1296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181320" y="3317760"/>
            <a:ext cx="12600" cy="32040"/>
          </a:xfrm>
          <a:custGeom>
            <a:avLst/>
            <a:gdLst/>
            <a:ahLst/>
            <a:rect l="l" t="t" r="r" b="b"/>
            <a:pathLst>
              <a:path w="6" h="12">
                <a:moveTo>
                  <a:pt x="6" y="12"/>
                </a:moveTo>
                <a:lnTo>
                  <a:pt x="6" y="12"/>
                </a:lnTo>
                <a:lnTo>
                  <a:pt x="6" y="0"/>
                </a:lnTo>
                <a:lnTo>
                  <a:pt x="0" y="0"/>
                </a:lnTo>
                <a:lnTo>
                  <a:pt x="0" y="12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193920" y="3349800"/>
            <a:ext cx="180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181320" y="3349800"/>
            <a:ext cx="1260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181320" y="336708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181320" y="341640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3181320" y="3463920"/>
            <a:ext cx="12600" cy="334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3181320" y="3513240"/>
            <a:ext cx="1260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3181320" y="3562200"/>
            <a:ext cx="19080" cy="3204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3187800" y="3611520"/>
            <a:ext cx="126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3187800" y="3627360"/>
            <a:ext cx="14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3187800" y="3627360"/>
            <a:ext cx="126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3187800" y="366084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3187800" y="370836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3193920" y="3757680"/>
            <a:ext cx="12960" cy="331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3193920" y="3807000"/>
            <a:ext cx="19080" cy="3312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3200400" y="3855960"/>
            <a:ext cx="12600" cy="316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200400" y="390528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3206880" y="3952800"/>
            <a:ext cx="1908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3213000" y="4002120"/>
            <a:ext cx="12960" cy="33480"/>
          </a:xfrm>
          <a:custGeom>
            <a:avLst/>
            <a:gdLst/>
            <a:ahLst/>
            <a:rect l="l" t="t" r="r" b="b"/>
            <a:pathLst>
              <a:path w="6" h="12">
                <a:moveTo>
                  <a:pt x="0" y="12"/>
                </a:moveTo>
                <a:lnTo>
                  <a:pt x="6" y="9"/>
                </a:lnTo>
                <a:lnTo>
                  <a:pt x="6" y="0"/>
                </a:lnTo>
                <a:lnTo>
                  <a:pt x="0" y="0"/>
                </a:lnTo>
                <a:lnTo>
                  <a:pt x="0" y="9"/>
                </a:lnTo>
                <a:lnTo>
                  <a:pt x="0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213000" y="4027320"/>
            <a:ext cx="19080" cy="8280"/>
          </a:xfrm>
          <a:custGeom>
            <a:avLst/>
            <a:gdLst/>
            <a:ahLst/>
            <a:rect l="l" t="t" r="r" b="b"/>
            <a:pathLst>
              <a:path w="9" h="3">
                <a:moveTo>
                  <a:pt x="9" y="0"/>
                </a:moveTo>
                <a:lnTo>
                  <a:pt x="3" y="3"/>
                </a:lnTo>
                <a:lnTo>
                  <a:pt x="0" y="3"/>
                </a:lnTo>
                <a:lnTo>
                  <a:pt x="6" y="0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3225960" y="4043520"/>
            <a:ext cx="20520" cy="23760"/>
          </a:xfrm>
          <a:custGeom>
            <a:avLst/>
            <a:gdLst/>
            <a:ahLst/>
            <a:rect l="l" t="t" r="r" b="b"/>
            <a:pathLst>
              <a:path w="9" h="9">
                <a:moveTo>
                  <a:pt x="9" y="6"/>
                </a:moveTo>
                <a:lnTo>
                  <a:pt x="9" y="6"/>
                </a:lnTo>
                <a:lnTo>
                  <a:pt x="6" y="0"/>
                </a:lnTo>
                <a:lnTo>
                  <a:pt x="0" y="3"/>
                </a:lnTo>
                <a:lnTo>
                  <a:pt x="3" y="9"/>
                </a:lnTo>
                <a:lnTo>
                  <a:pt x="9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3246480" y="4059360"/>
            <a:ext cx="324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3232080" y="4059360"/>
            <a:ext cx="14400" cy="158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6"/>
                </a:moveTo>
                <a:lnTo>
                  <a:pt x="0" y="6"/>
                </a:lnTo>
                <a:lnTo>
                  <a:pt x="0" y="3"/>
                </a:lnTo>
                <a:lnTo>
                  <a:pt x="6" y="0"/>
                </a:lnTo>
                <a:lnTo>
                  <a:pt x="6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3238560" y="4092480"/>
            <a:ext cx="2052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252960" y="4141800"/>
            <a:ext cx="12600" cy="158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6"/>
                </a:moveTo>
                <a:lnTo>
                  <a:pt x="6" y="6"/>
                </a:lnTo>
                <a:lnTo>
                  <a:pt x="6" y="0"/>
                </a:lnTo>
                <a:lnTo>
                  <a:pt x="0" y="0"/>
                </a:lnTo>
                <a:lnTo>
                  <a:pt x="0" y="6"/>
                </a:lnTo>
                <a:lnTo>
                  <a:pt x="6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3265560" y="4157640"/>
            <a:ext cx="32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3252960" y="4157640"/>
            <a:ext cx="18720" cy="15840"/>
          </a:xfrm>
          <a:custGeom>
            <a:avLst/>
            <a:gdLst/>
            <a:ahLst/>
            <a:rect l="l" t="t" r="r" b="b"/>
            <a:pathLst>
              <a:path w="9" h="6">
                <a:moveTo>
                  <a:pt x="9" y="3"/>
                </a:moveTo>
                <a:lnTo>
                  <a:pt x="3" y="6"/>
                </a:lnTo>
                <a:lnTo>
                  <a:pt x="0" y="0"/>
                </a:lnTo>
                <a:lnTo>
                  <a:pt x="6" y="0"/>
                </a:lnTo>
                <a:lnTo>
                  <a:pt x="9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3259080" y="4181400"/>
            <a:ext cx="19080" cy="41400"/>
          </a:xfrm>
          <a:custGeom>
            <a:avLst/>
            <a:gdLst/>
            <a:ahLst/>
            <a:rect l="l" t="t" r="r" b="b"/>
            <a:pathLst>
              <a:path w="9" h="15">
                <a:moveTo>
                  <a:pt x="9" y="15"/>
                </a:moveTo>
                <a:lnTo>
                  <a:pt x="9" y="12"/>
                </a:lnTo>
                <a:lnTo>
                  <a:pt x="6" y="0"/>
                </a:lnTo>
                <a:lnTo>
                  <a:pt x="0" y="3"/>
                </a:lnTo>
                <a:lnTo>
                  <a:pt x="3" y="15"/>
                </a:lnTo>
                <a:lnTo>
                  <a:pt x="9" y="15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265560" y="4222800"/>
            <a:ext cx="12600" cy="7920"/>
          </a:xfrm>
          <a:custGeom>
            <a:avLst/>
            <a:gdLst/>
            <a:ahLst/>
            <a:rect l="l" t="t" r="r" b="b"/>
            <a:pathLst>
              <a:path w="6" h="3">
                <a:moveTo>
                  <a:pt x="6" y="0"/>
                </a:moveTo>
                <a:lnTo>
                  <a:pt x="3" y="3"/>
                </a:lnTo>
                <a:lnTo>
                  <a:pt x="0" y="0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271680" y="420696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0" y="0"/>
                </a:moveTo>
                <a:lnTo>
                  <a:pt x="3" y="6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284640" y="4197240"/>
            <a:ext cx="12600" cy="176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3"/>
                </a:moveTo>
                <a:lnTo>
                  <a:pt x="3" y="0"/>
                </a:lnTo>
                <a:lnTo>
                  <a:pt x="0" y="3"/>
                </a:lnTo>
                <a:lnTo>
                  <a:pt x="3" y="6"/>
                </a:lnTo>
                <a:lnTo>
                  <a:pt x="6" y="6"/>
                </a:lnTo>
                <a:lnTo>
                  <a:pt x="6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297240" y="4206960"/>
            <a:ext cx="3240" cy="792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3284640" y="4181400"/>
            <a:ext cx="19080" cy="25560"/>
          </a:xfrm>
          <a:custGeom>
            <a:avLst/>
            <a:gdLst/>
            <a:ahLst/>
            <a:rect l="l" t="t" r="r" b="b"/>
            <a:pathLst>
              <a:path w="9" h="9">
                <a:moveTo>
                  <a:pt x="3" y="0"/>
                </a:moveTo>
                <a:lnTo>
                  <a:pt x="9" y="3"/>
                </a:lnTo>
                <a:lnTo>
                  <a:pt x="6" y="9"/>
                </a:lnTo>
                <a:lnTo>
                  <a:pt x="0" y="9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3297240" y="4132440"/>
            <a:ext cx="19080" cy="41040"/>
          </a:xfrm>
          <a:custGeom>
            <a:avLst/>
            <a:gdLst/>
            <a:ahLst/>
            <a:rect l="l" t="t" r="r" b="b"/>
            <a:pathLst>
              <a:path w="9" h="15">
                <a:moveTo>
                  <a:pt x="6" y="0"/>
                </a:moveTo>
                <a:lnTo>
                  <a:pt x="3" y="3"/>
                </a:lnTo>
                <a:lnTo>
                  <a:pt x="0" y="12"/>
                </a:lnTo>
                <a:lnTo>
                  <a:pt x="6" y="15"/>
                </a:lnTo>
                <a:lnTo>
                  <a:pt x="9" y="6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3303720" y="4132440"/>
            <a:ext cx="6120" cy="9360"/>
          </a:xfrm>
          <a:custGeom>
            <a:avLst/>
            <a:gdLst/>
            <a:ahLst/>
            <a:rect l="l" t="t" r="r" b="b"/>
            <a:pathLst>
              <a:path w="3" h="3">
                <a:moveTo>
                  <a:pt x="0" y="3"/>
                </a:moveTo>
                <a:lnTo>
                  <a:pt x="0" y="3"/>
                </a:lnTo>
                <a:lnTo>
                  <a:pt x="3" y="0"/>
                </a:lnTo>
                <a:lnTo>
                  <a:pt x="0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3309840" y="4132440"/>
            <a:ext cx="6480" cy="17280"/>
          </a:xfrm>
          <a:custGeom>
            <a:avLst/>
            <a:gdLst/>
            <a:ahLst/>
            <a:rect l="l" t="t" r="r" b="b"/>
            <a:pathLst>
              <a:path w="3" h="6">
                <a:moveTo>
                  <a:pt x="0" y="0"/>
                </a:moveTo>
                <a:lnTo>
                  <a:pt x="3" y="6"/>
                </a:lnTo>
                <a:lnTo>
                  <a:pt x="0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3322800" y="4124160"/>
            <a:ext cx="12600" cy="176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0"/>
                </a:moveTo>
                <a:lnTo>
                  <a:pt x="3" y="0"/>
                </a:lnTo>
                <a:lnTo>
                  <a:pt x="0" y="0"/>
                </a:lnTo>
                <a:lnTo>
                  <a:pt x="3" y="6"/>
                </a:lnTo>
                <a:lnTo>
                  <a:pt x="6" y="3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3328920" y="4116240"/>
            <a:ext cx="6480" cy="7920"/>
          </a:xfrm>
          <a:custGeom>
            <a:avLst/>
            <a:gdLst/>
            <a:ahLst/>
            <a:rect l="l" t="t" r="r" b="b"/>
            <a:pathLst>
              <a:path w="3" h="3">
                <a:moveTo>
                  <a:pt x="0" y="3"/>
                </a:moveTo>
                <a:lnTo>
                  <a:pt x="3" y="0"/>
                </a:lnTo>
                <a:lnTo>
                  <a:pt x="3" y="3"/>
                </a:lnTo>
                <a:lnTo>
                  <a:pt x="0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3322800" y="4124160"/>
            <a:ext cx="21960" cy="334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9"/>
                </a:moveTo>
                <a:lnTo>
                  <a:pt x="3" y="12"/>
                </a:lnTo>
                <a:lnTo>
                  <a:pt x="0" y="3"/>
                </a:lnTo>
                <a:lnTo>
                  <a:pt x="6" y="0"/>
                </a:lnTo>
                <a:lnTo>
                  <a:pt x="9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3335400" y="4165560"/>
            <a:ext cx="2232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12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3351240" y="421488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9"/>
                </a:moveTo>
                <a:lnTo>
                  <a:pt x="3" y="12"/>
                </a:lnTo>
                <a:lnTo>
                  <a:pt x="0" y="0"/>
                </a:lnTo>
                <a:lnTo>
                  <a:pt x="6" y="0"/>
                </a:lnTo>
                <a:lnTo>
                  <a:pt x="9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3363840" y="4254480"/>
            <a:ext cx="19080" cy="41400"/>
          </a:xfrm>
          <a:custGeom>
            <a:avLst/>
            <a:gdLst/>
            <a:ahLst/>
            <a:rect l="l" t="t" r="r" b="b"/>
            <a:pathLst>
              <a:path w="9" h="15">
                <a:moveTo>
                  <a:pt x="3" y="15"/>
                </a:moveTo>
                <a:lnTo>
                  <a:pt x="9" y="12"/>
                </a:lnTo>
                <a:lnTo>
                  <a:pt x="3" y="0"/>
                </a:lnTo>
                <a:lnTo>
                  <a:pt x="0" y="3"/>
                </a:lnTo>
                <a:lnTo>
                  <a:pt x="3" y="12"/>
                </a:lnTo>
                <a:lnTo>
                  <a:pt x="3" y="15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370320" y="4280040"/>
            <a:ext cx="612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0"/>
                </a:moveTo>
                <a:lnTo>
                  <a:pt x="3" y="6"/>
                </a:lnTo>
                <a:lnTo>
                  <a:pt x="0" y="6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389400" y="4280040"/>
            <a:ext cx="2520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9" y="3"/>
                </a:lnTo>
                <a:lnTo>
                  <a:pt x="0" y="0"/>
                </a:lnTo>
                <a:lnTo>
                  <a:pt x="0" y="6"/>
                </a:lnTo>
                <a:lnTo>
                  <a:pt x="9" y="9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3408480" y="4287960"/>
            <a:ext cx="6120" cy="28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3408480" y="4287960"/>
            <a:ext cx="612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3"/>
                </a:moveTo>
                <a:lnTo>
                  <a:pt x="0" y="6"/>
                </a:lnTo>
                <a:lnTo>
                  <a:pt x="3" y="0"/>
                </a:lnTo>
                <a:lnTo>
                  <a:pt x="3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3421080" y="4303800"/>
            <a:ext cx="25560" cy="33120"/>
          </a:xfrm>
          <a:custGeom>
            <a:avLst/>
            <a:gdLst/>
            <a:ahLst/>
            <a:rect l="l" t="t" r="r" b="b"/>
            <a:pathLst>
              <a:path w="12" h="12">
                <a:moveTo>
                  <a:pt x="12" y="9"/>
                </a:moveTo>
                <a:lnTo>
                  <a:pt x="9" y="12"/>
                </a:lnTo>
                <a:lnTo>
                  <a:pt x="0" y="6"/>
                </a:lnTo>
                <a:lnTo>
                  <a:pt x="3" y="0"/>
                </a:lnTo>
                <a:lnTo>
                  <a:pt x="12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3446640" y="4344840"/>
            <a:ext cx="25200" cy="32040"/>
          </a:xfrm>
          <a:custGeom>
            <a:avLst/>
            <a:gdLst/>
            <a:ahLst/>
            <a:rect l="l" t="t" r="r" b="b"/>
            <a:pathLst>
              <a:path w="12" h="12">
                <a:moveTo>
                  <a:pt x="12" y="9"/>
                </a:moveTo>
                <a:lnTo>
                  <a:pt x="6" y="12"/>
                </a:lnTo>
                <a:lnTo>
                  <a:pt x="0" y="3"/>
                </a:lnTo>
                <a:lnTo>
                  <a:pt x="3" y="0"/>
                </a:lnTo>
                <a:lnTo>
                  <a:pt x="12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3465360" y="4376880"/>
            <a:ext cx="19080" cy="33120"/>
          </a:xfrm>
          <a:custGeom>
            <a:avLst/>
            <a:gdLst/>
            <a:ahLst/>
            <a:rect l="l" t="t" r="r" b="b"/>
            <a:pathLst>
              <a:path w="9" h="12">
                <a:moveTo>
                  <a:pt x="6" y="12"/>
                </a:moveTo>
                <a:lnTo>
                  <a:pt x="9" y="6"/>
                </a:lnTo>
                <a:lnTo>
                  <a:pt x="6" y="0"/>
                </a:lnTo>
                <a:lnTo>
                  <a:pt x="0" y="3"/>
                </a:lnTo>
                <a:lnTo>
                  <a:pt x="6" y="9"/>
                </a:lnTo>
                <a:lnTo>
                  <a:pt x="6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3478320" y="4394160"/>
            <a:ext cx="12600" cy="158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0"/>
                </a:moveTo>
                <a:lnTo>
                  <a:pt x="6" y="6"/>
                </a:lnTo>
                <a:lnTo>
                  <a:pt x="0" y="6"/>
                </a:lnTo>
                <a:lnTo>
                  <a:pt x="3" y="0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3503520" y="4394160"/>
            <a:ext cx="270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3543480" y="4402080"/>
            <a:ext cx="25200" cy="15840"/>
          </a:xfrm>
          <a:custGeom>
            <a:avLst/>
            <a:gdLst/>
            <a:ahLst/>
            <a:rect l="l" t="t" r="r" b="b"/>
            <a:pathLst>
              <a:path w="12" h="6">
                <a:moveTo>
                  <a:pt x="9" y="6"/>
                </a:moveTo>
                <a:lnTo>
                  <a:pt x="12" y="0"/>
                </a:lnTo>
                <a:lnTo>
                  <a:pt x="0" y="0"/>
                </a:lnTo>
                <a:lnTo>
                  <a:pt x="0" y="6"/>
                </a:lnTo>
                <a:lnTo>
                  <a:pt x="9" y="6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3562200" y="440208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0"/>
                </a:moveTo>
                <a:lnTo>
                  <a:pt x="3" y="6"/>
                </a:lnTo>
                <a:lnTo>
                  <a:pt x="0" y="6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3581280" y="4402080"/>
            <a:ext cx="25560" cy="15840"/>
          </a:xfrm>
          <a:custGeom>
            <a:avLst/>
            <a:gdLst/>
            <a:ahLst/>
            <a:rect l="l" t="t" r="r" b="b"/>
            <a:pathLst>
              <a:path w="12" h="6">
                <a:moveTo>
                  <a:pt x="12" y="3"/>
                </a:moveTo>
                <a:lnTo>
                  <a:pt x="12" y="6"/>
                </a:lnTo>
                <a:lnTo>
                  <a:pt x="0" y="6"/>
                </a:lnTo>
                <a:lnTo>
                  <a:pt x="0" y="0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3621240" y="4410000"/>
            <a:ext cx="25200" cy="158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3659040" y="4410000"/>
            <a:ext cx="648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0"/>
                </a:moveTo>
                <a:lnTo>
                  <a:pt x="3" y="0"/>
                </a:lnTo>
                <a:lnTo>
                  <a:pt x="0" y="0"/>
                </a:lnTo>
                <a:lnTo>
                  <a:pt x="0" y="6"/>
                </a:lnTo>
                <a:lnTo>
                  <a:pt x="3" y="6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3665520" y="4410000"/>
            <a:ext cx="324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665520" y="4410000"/>
            <a:ext cx="19080" cy="23760"/>
          </a:xfrm>
          <a:custGeom>
            <a:avLst/>
            <a:gdLst/>
            <a:ahLst/>
            <a:rect l="l" t="t" r="r" b="b"/>
            <a:pathLst>
              <a:path w="9" h="9">
                <a:moveTo>
                  <a:pt x="9" y="3"/>
                </a:moveTo>
                <a:lnTo>
                  <a:pt x="9" y="9"/>
                </a:lnTo>
                <a:lnTo>
                  <a:pt x="0" y="6"/>
                </a:lnTo>
                <a:lnTo>
                  <a:pt x="0" y="0"/>
                </a:lnTo>
                <a:lnTo>
                  <a:pt x="9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697200" y="4425840"/>
            <a:ext cx="28800" cy="255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9" y="9"/>
                </a:lnTo>
                <a:lnTo>
                  <a:pt x="0" y="6"/>
                </a:lnTo>
                <a:lnTo>
                  <a:pt x="0" y="0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3732120" y="4443480"/>
            <a:ext cx="31680" cy="23760"/>
          </a:xfrm>
          <a:custGeom>
            <a:avLst/>
            <a:gdLst/>
            <a:ahLst/>
            <a:rect l="l" t="t" r="r" b="b"/>
            <a:pathLst>
              <a:path w="15" h="9">
                <a:moveTo>
                  <a:pt x="15" y="3"/>
                </a:moveTo>
                <a:lnTo>
                  <a:pt x="12" y="9"/>
                </a:lnTo>
                <a:lnTo>
                  <a:pt x="0" y="3"/>
                </a:lnTo>
                <a:lnTo>
                  <a:pt x="3" y="0"/>
                </a:lnTo>
                <a:lnTo>
                  <a:pt x="15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770280" y="4451400"/>
            <a:ext cx="2556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3"/>
                </a:moveTo>
                <a:lnTo>
                  <a:pt x="12" y="9"/>
                </a:lnTo>
                <a:lnTo>
                  <a:pt x="0" y="6"/>
                </a:lnTo>
                <a:lnTo>
                  <a:pt x="3" y="0"/>
                </a:lnTo>
                <a:lnTo>
                  <a:pt x="12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808440" y="4467240"/>
            <a:ext cx="2520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12" y="9"/>
                </a:moveTo>
                <a:lnTo>
                  <a:pt x="12" y="3"/>
                </a:lnTo>
                <a:lnTo>
                  <a:pt x="0" y="0"/>
                </a:lnTo>
                <a:lnTo>
                  <a:pt x="0" y="6"/>
                </a:lnTo>
                <a:lnTo>
                  <a:pt x="9" y="9"/>
                </a:lnTo>
                <a:lnTo>
                  <a:pt x="12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3827520" y="4491000"/>
            <a:ext cx="612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3827520" y="4475160"/>
            <a:ext cx="6120" cy="15840"/>
          </a:xfrm>
          <a:custGeom>
            <a:avLst/>
            <a:gdLst/>
            <a:ahLst/>
            <a:rect l="l" t="t" r="r" b="b"/>
            <a:pathLst>
              <a:path w="3" h="6">
                <a:moveTo>
                  <a:pt x="3" y="0"/>
                </a:moveTo>
                <a:lnTo>
                  <a:pt x="3" y="6"/>
                </a:lnTo>
                <a:lnTo>
                  <a:pt x="0" y="0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3846600" y="4467240"/>
            <a:ext cx="25200" cy="23760"/>
          </a:xfrm>
          <a:custGeom>
            <a:avLst/>
            <a:gdLst/>
            <a:ahLst/>
            <a:rect l="l" t="t" r="r" b="b"/>
            <a:pathLst>
              <a:path w="12" h="9">
                <a:moveTo>
                  <a:pt x="9" y="0"/>
                </a:moveTo>
                <a:lnTo>
                  <a:pt x="12" y="6"/>
                </a:lnTo>
                <a:lnTo>
                  <a:pt x="0" y="9"/>
                </a:lnTo>
                <a:lnTo>
                  <a:pt x="0" y="3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3878280" y="4459320"/>
            <a:ext cx="27000" cy="15840"/>
          </a:xfrm>
          <a:custGeom>
            <a:avLst/>
            <a:gdLst/>
            <a:ahLst/>
            <a:rect l="l" t="t" r="r" b="b"/>
            <a:pathLst>
              <a:path w="12" h="6">
                <a:moveTo>
                  <a:pt x="9" y="0"/>
                </a:moveTo>
                <a:lnTo>
                  <a:pt x="9" y="0"/>
                </a:lnTo>
                <a:lnTo>
                  <a:pt x="0" y="0"/>
                </a:lnTo>
                <a:lnTo>
                  <a:pt x="3" y="6"/>
                </a:lnTo>
                <a:lnTo>
                  <a:pt x="12" y="6"/>
                </a:lnTo>
                <a:lnTo>
                  <a:pt x="9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3898800" y="4459320"/>
            <a:ext cx="180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3898800" y="4459320"/>
            <a:ext cx="12960" cy="15840"/>
          </a:xfrm>
          <a:custGeom>
            <a:avLst/>
            <a:gdLst/>
            <a:ahLst/>
            <a:rect l="l" t="t" r="r" b="b"/>
            <a:pathLst>
              <a:path w="6" h="6">
                <a:moveTo>
                  <a:pt x="3" y="0"/>
                </a:moveTo>
                <a:lnTo>
                  <a:pt x="6" y="6"/>
                </a:lnTo>
                <a:lnTo>
                  <a:pt x="0" y="6"/>
                </a:lnTo>
                <a:lnTo>
                  <a:pt x="0" y="0"/>
                </a:lnTo>
                <a:lnTo>
                  <a:pt x="3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3917880" y="4451400"/>
            <a:ext cx="31680" cy="15840"/>
          </a:xfrm>
          <a:custGeom>
            <a:avLst/>
            <a:gdLst/>
            <a:ahLst/>
            <a:rect l="l" t="t" r="r" b="b"/>
            <a:pathLst>
              <a:path w="15" h="6">
                <a:moveTo>
                  <a:pt x="12" y="0"/>
                </a:moveTo>
                <a:lnTo>
                  <a:pt x="15" y="6"/>
                </a:lnTo>
                <a:lnTo>
                  <a:pt x="3" y="6"/>
                </a:lnTo>
                <a:lnTo>
                  <a:pt x="0" y="0"/>
                </a:lnTo>
                <a:lnTo>
                  <a:pt x="12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3956040" y="4443480"/>
            <a:ext cx="12600" cy="23760"/>
          </a:xfrm>
          <a:custGeom>
            <a:avLst/>
            <a:gdLst/>
            <a:ahLst/>
            <a:rect l="l" t="t" r="r" b="b"/>
            <a:pathLst>
              <a:path w="6" h="9">
                <a:moveTo>
                  <a:pt x="6" y="0"/>
                </a:moveTo>
                <a:lnTo>
                  <a:pt x="3" y="0"/>
                </a:lnTo>
                <a:lnTo>
                  <a:pt x="0" y="3"/>
                </a:lnTo>
                <a:lnTo>
                  <a:pt x="3" y="9"/>
                </a:lnTo>
                <a:lnTo>
                  <a:pt x="6" y="6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3962520" y="4443480"/>
            <a:ext cx="6120" cy="14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3968640" y="4443480"/>
            <a:ext cx="20880" cy="23760"/>
          </a:xfrm>
          <a:custGeom>
            <a:avLst/>
            <a:gdLst/>
            <a:ahLst/>
            <a:rect l="l" t="t" r="r" b="b"/>
            <a:pathLst>
              <a:path w="9" h="9">
                <a:moveTo>
                  <a:pt x="9" y="3"/>
                </a:moveTo>
                <a:lnTo>
                  <a:pt x="6" y="9"/>
                </a:lnTo>
                <a:lnTo>
                  <a:pt x="0" y="6"/>
                </a:lnTo>
                <a:lnTo>
                  <a:pt x="0" y="0"/>
                </a:lnTo>
                <a:lnTo>
                  <a:pt x="9" y="3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3995640" y="4451400"/>
            <a:ext cx="31680" cy="15840"/>
          </a:xfrm>
          <a:custGeom>
            <a:avLst/>
            <a:gdLst/>
            <a:ahLst/>
            <a:rect l="l" t="t" r="r" b="b"/>
            <a:pathLst>
              <a:path w="15" h="6">
                <a:moveTo>
                  <a:pt x="15" y="0"/>
                </a:moveTo>
                <a:lnTo>
                  <a:pt x="12" y="6"/>
                </a:lnTo>
                <a:lnTo>
                  <a:pt x="0" y="6"/>
                </a:lnTo>
                <a:lnTo>
                  <a:pt x="3" y="0"/>
                </a:lnTo>
                <a:lnTo>
                  <a:pt x="15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4033800" y="4459320"/>
            <a:ext cx="12600" cy="15840"/>
          </a:xfrm>
          <a:custGeom>
            <a:avLst/>
            <a:gdLst/>
            <a:ahLst/>
            <a:rect l="l" t="t" r="r" b="b"/>
            <a:pathLst>
              <a:path w="6" h="6">
                <a:moveTo>
                  <a:pt x="6" y="0"/>
                </a:moveTo>
                <a:lnTo>
                  <a:pt x="3" y="0"/>
                </a:lnTo>
                <a:lnTo>
                  <a:pt x="0" y="6"/>
                </a:lnTo>
                <a:lnTo>
                  <a:pt x="3" y="6"/>
                </a:lnTo>
                <a:lnTo>
                  <a:pt x="6" y="0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4040280" y="4459320"/>
            <a:ext cx="6120" cy="324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4033800" y="4459320"/>
            <a:ext cx="19080" cy="31680"/>
          </a:xfrm>
          <a:custGeom>
            <a:avLst/>
            <a:gdLst/>
            <a:ahLst/>
            <a:rect l="l" t="t" r="r" b="b"/>
            <a:pathLst>
              <a:path w="9" h="12">
                <a:moveTo>
                  <a:pt x="9" y="9"/>
                </a:moveTo>
                <a:lnTo>
                  <a:pt x="3" y="12"/>
                </a:lnTo>
                <a:lnTo>
                  <a:pt x="0" y="3"/>
                </a:lnTo>
                <a:lnTo>
                  <a:pt x="6" y="0"/>
                </a:lnTo>
                <a:lnTo>
                  <a:pt x="9" y="9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4046400" y="4498920"/>
            <a:ext cx="19080" cy="41400"/>
          </a:xfrm>
          <a:custGeom>
            <a:avLst/>
            <a:gdLst/>
            <a:ahLst/>
            <a:rect l="l" t="t" r="r" b="b"/>
            <a:pathLst>
              <a:path w="9" h="15">
                <a:moveTo>
                  <a:pt x="9" y="12"/>
                </a:moveTo>
                <a:lnTo>
                  <a:pt x="6" y="15"/>
                </a:lnTo>
                <a:lnTo>
                  <a:pt x="0" y="3"/>
                </a:lnTo>
                <a:lnTo>
                  <a:pt x="6" y="0"/>
                </a:lnTo>
                <a:lnTo>
                  <a:pt x="9" y="12"/>
                </a:lnTo>
                <a:close/>
              </a:path>
            </a:pathLst>
          </a:cu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804960" y="1944720"/>
            <a:ext cx="2520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843120" y="1944720"/>
            <a:ext cx="2520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880920" y="1944720"/>
            <a:ext cx="2556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919080" y="1944720"/>
            <a:ext cx="2700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958680" y="1944720"/>
            <a:ext cx="2556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996840" y="1944720"/>
            <a:ext cx="2700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1036800" y="1944720"/>
            <a:ext cx="2520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1074600" y="1944720"/>
            <a:ext cx="2556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1116000" y="1944720"/>
            <a:ext cx="2556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1154160" y="1944720"/>
            <a:ext cx="19080" cy="1728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804960" y="1741320"/>
            <a:ext cx="368280" cy="16200"/>
          </a:xfrm>
          <a:prstGeom prst="rect">
            <a:avLst/>
          </a:prstGeom>
          <a:solidFill>
            <a:srgbClr val="24211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1256040" y="1665360"/>
            <a:ext cx="197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24211d"/>
                </a:solidFill>
                <a:latin typeface="Arial"/>
              </a:rPr>
              <a:t>SG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1256040" y="1893960"/>
            <a:ext cx="197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24211d"/>
                </a:solidFill>
                <a:latin typeface="Arial"/>
              </a:rPr>
              <a:t>PG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2142000" y="1271520"/>
            <a:ext cx="262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24211d"/>
                </a:solidFill>
                <a:latin typeface="Arial"/>
              </a:rPr>
              <a:t>GalNA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2410920" y="1271520"/>
            <a:ext cx="26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24211d"/>
                </a:solidFill>
                <a:latin typeface="Arial"/>
              </a:rPr>
              <a:t>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2442960" y="1271520"/>
            <a:ext cx="256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24211d"/>
                </a:solidFill>
                <a:latin typeface="Arial"/>
              </a:rPr>
              <a:t>Threit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3176640" y="1681200"/>
            <a:ext cx="256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24211d"/>
                </a:solidFill>
                <a:latin typeface="Arial"/>
              </a:rPr>
              <a:t>Threit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2036160" y="3749760"/>
            <a:ext cx="26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24211d"/>
                </a:solidFill>
                <a:latin typeface="Arial"/>
              </a:rPr>
              <a:t>(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2069640" y="3749760"/>
            <a:ext cx="570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24211d"/>
                </a:solidFill>
                <a:latin typeface="Arial"/>
              </a:rPr>
              <a:t>GalNAc)-Threit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2458440" y="3749760"/>
            <a:ext cx="26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24211d"/>
                </a:solidFill>
                <a:latin typeface="Arial"/>
              </a:rPr>
              <a:t>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347920" y="3801960"/>
            <a:ext cx="28080" cy="6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24211d"/>
                </a:solidFill>
                <a:latin typeface="Arial"/>
              </a:rPr>
              <a:t>n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2735280" y="1474920"/>
            <a:ext cx="115920" cy="90360"/>
          </a:xfrm>
          <a:prstGeom prst="line">
            <a:avLst/>
          </a:prstGeom>
          <a:ln cap="rnd" w="144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 flipV="1">
            <a:off x="3211560" y="1809360"/>
            <a:ext cx="69840" cy="219240"/>
          </a:xfrm>
          <a:prstGeom prst="line">
            <a:avLst/>
          </a:prstGeom>
          <a:ln cap="rnd" w="144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 flipV="1">
            <a:off x="2800440" y="3668760"/>
            <a:ext cx="0" cy="520560"/>
          </a:xfrm>
          <a:prstGeom prst="line">
            <a:avLst/>
          </a:prstGeom>
          <a:ln cap="rnd" w="144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 flipV="1">
            <a:off x="1871640" y="3668760"/>
            <a:ext cx="0" cy="520560"/>
          </a:xfrm>
          <a:prstGeom prst="line">
            <a:avLst/>
          </a:prstGeom>
          <a:ln cap="rnd" w="144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584280" y="4597560"/>
            <a:ext cx="3487680" cy="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590400" y="1557360"/>
            <a:ext cx="0" cy="305604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59040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102384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146196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189720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232884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276696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320040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363996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4071960" y="4597560"/>
            <a:ext cx="0" cy="56880"/>
          </a:xfrm>
          <a:prstGeom prst="line">
            <a:avLst/>
          </a:prstGeom>
          <a:ln cap="rnd" w="12600">
            <a:solidFill>
              <a:srgbClr val="24211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517320" y="47070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923400" y="47070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1329120" y="4707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1768680" y="4707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2201400" y="4707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2633040" y="4707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3072960" y="4707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3507120" y="4707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3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3947040" y="4707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24211d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1600200" y="4983120"/>
            <a:ext cx="1389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4211d"/>
                </a:solidFill>
                <a:latin typeface="Arial"/>
              </a:rPr>
              <a:t>Elution time (mi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 rot="16200000">
            <a:off x="277920" y="3197520"/>
            <a:ext cx="229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 rot="16200000">
            <a:off x="29520" y="2748240"/>
            <a:ext cx="735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respon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590400" y="4402080"/>
            <a:ext cx="304920" cy="31680"/>
          </a:xfrm>
          <a:custGeom>
            <a:avLst/>
            <a:gdLst/>
            <a:ahLst/>
            <a:rect l="l" t="t" r="r" b="b"/>
            <a:pathLst>
              <a:path w="142" h="12">
                <a:moveTo>
                  <a:pt x="0" y="0"/>
                </a:moveTo>
                <a:cubicBezTo>
                  <a:pt x="14" y="5"/>
                  <a:pt x="33" y="5"/>
                  <a:pt x="48" y="6"/>
                </a:cubicBezTo>
                <a:cubicBezTo>
                  <a:pt x="52" y="6"/>
                  <a:pt x="54" y="8"/>
                  <a:pt x="58" y="6"/>
                </a:cubicBezTo>
                <a:cubicBezTo>
                  <a:pt x="74" y="8"/>
                  <a:pt x="88" y="9"/>
                  <a:pt x="105" y="9"/>
                </a:cubicBezTo>
                <a:cubicBezTo>
                  <a:pt x="117" y="11"/>
                  <a:pt x="130" y="12"/>
                  <a:pt x="142" y="12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2175120" y="3538440"/>
            <a:ext cx="366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raction 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2230200" y="1141560"/>
            <a:ext cx="3909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raction I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3094560" y="1568520"/>
            <a:ext cx="415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raction II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6046920" y="4892760"/>
            <a:ext cx="180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lution time (mi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4446720" y="1249200"/>
            <a:ext cx="4195800" cy="3714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4743360" y="1459080"/>
            <a:ext cx="0" cy="3097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4713120" y="455616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4713120" y="393876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4713120" y="33210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4713120" y="26938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4713120" y="20764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4713120" y="14590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4743360" y="4556160"/>
            <a:ext cx="380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 flipV="1">
            <a:off x="474336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 flipV="1">
            <a:off x="521820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 flipV="1">
            <a:off x="569448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 flipV="1">
            <a:off x="617076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 flipV="1">
            <a:off x="664704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 flipV="1">
            <a:off x="712296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 flipV="1">
            <a:off x="855180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6164280" y="4008600"/>
            <a:ext cx="98280" cy="547560"/>
          </a:xfrm>
          <a:custGeom>
            <a:avLst/>
            <a:gdLst/>
            <a:ahLst/>
            <a:rect l="l" t="t" r="r" b="b"/>
            <a:pathLst>
              <a:path w="78" h="330">
                <a:moveTo>
                  <a:pt x="0" y="330"/>
                </a:moveTo>
                <a:lnTo>
                  <a:pt x="18" y="252"/>
                </a:lnTo>
                <a:lnTo>
                  <a:pt x="36" y="180"/>
                </a:lnTo>
                <a:lnTo>
                  <a:pt x="48" y="144"/>
                </a:lnTo>
                <a:lnTo>
                  <a:pt x="60" y="102"/>
                </a:lnTo>
                <a:lnTo>
                  <a:pt x="66" y="54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6262560" y="3041640"/>
            <a:ext cx="106560" cy="966960"/>
          </a:xfrm>
          <a:custGeom>
            <a:avLst/>
            <a:gdLst/>
            <a:ahLst/>
            <a:rect l="l" t="t" r="r" b="b"/>
            <a:pathLst>
              <a:path w="84" h="582">
                <a:moveTo>
                  <a:pt x="0" y="582"/>
                </a:moveTo>
                <a:lnTo>
                  <a:pt x="12" y="522"/>
                </a:lnTo>
                <a:lnTo>
                  <a:pt x="18" y="450"/>
                </a:lnTo>
                <a:lnTo>
                  <a:pt x="30" y="372"/>
                </a:lnTo>
                <a:lnTo>
                  <a:pt x="42" y="294"/>
                </a:lnTo>
                <a:lnTo>
                  <a:pt x="54" y="210"/>
                </a:lnTo>
                <a:lnTo>
                  <a:pt x="66" y="132"/>
                </a:lnTo>
                <a:lnTo>
                  <a:pt x="72" y="60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6369120" y="2484360"/>
            <a:ext cx="100080" cy="557280"/>
          </a:xfrm>
          <a:custGeom>
            <a:avLst/>
            <a:gdLst/>
            <a:ahLst/>
            <a:rect l="l" t="t" r="r" b="b"/>
            <a:pathLst>
              <a:path w="78" h="336">
                <a:moveTo>
                  <a:pt x="0" y="336"/>
                </a:moveTo>
                <a:lnTo>
                  <a:pt x="18" y="228"/>
                </a:lnTo>
                <a:lnTo>
                  <a:pt x="42" y="138"/>
                </a:lnTo>
                <a:lnTo>
                  <a:pt x="60" y="60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6469200" y="2355840"/>
            <a:ext cx="98280" cy="128520"/>
          </a:xfrm>
          <a:custGeom>
            <a:avLst/>
            <a:gdLst/>
            <a:ahLst/>
            <a:rect l="l" t="t" r="r" b="b"/>
            <a:pathLst>
              <a:path w="78" h="78">
                <a:moveTo>
                  <a:pt x="0" y="78"/>
                </a:moveTo>
                <a:lnTo>
                  <a:pt x="18" y="48"/>
                </a:lnTo>
                <a:lnTo>
                  <a:pt x="36" y="24"/>
                </a:lnTo>
                <a:lnTo>
                  <a:pt x="60" y="6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6567480" y="2344680"/>
            <a:ext cx="106200" cy="50760"/>
          </a:xfrm>
          <a:custGeom>
            <a:avLst/>
            <a:gdLst/>
            <a:ahLst/>
            <a:rect l="l" t="t" r="r" b="b"/>
            <a:pathLst>
              <a:path w="84" h="30">
                <a:moveTo>
                  <a:pt x="0" y="6"/>
                </a:moveTo>
                <a:lnTo>
                  <a:pt x="18" y="0"/>
                </a:lnTo>
                <a:lnTo>
                  <a:pt x="42" y="0"/>
                </a:lnTo>
                <a:lnTo>
                  <a:pt x="66" y="12"/>
                </a:lnTo>
                <a:lnTo>
                  <a:pt x="84" y="3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6673680" y="2395440"/>
            <a:ext cx="100080" cy="368280"/>
          </a:xfrm>
          <a:custGeom>
            <a:avLst/>
            <a:gdLst/>
            <a:ahLst/>
            <a:rect l="l" t="t" r="r" b="b"/>
            <a:pathLst>
              <a:path w="78" h="222">
                <a:moveTo>
                  <a:pt x="0" y="0"/>
                </a:moveTo>
                <a:lnTo>
                  <a:pt x="12" y="18"/>
                </a:lnTo>
                <a:lnTo>
                  <a:pt x="18" y="42"/>
                </a:lnTo>
                <a:lnTo>
                  <a:pt x="36" y="102"/>
                </a:lnTo>
                <a:lnTo>
                  <a:pt x="60" y="168"/>
                </a:lnTo>
                <a:lnTo>
                  <a:pt x="66" y="198"/>
                </a:lnTo>
                <a:lnTo>
                  <a:pt x="78" y="22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6773760" y="2763720"/>
            <a:ext cx="104760" cy="208080"/>
          </a:xfrm>
          <a:custGeom>
            <a:avLst/>
            <a:gdLst/>
            <a:ahLst/>
            <a:rect l="l" t="t" r="r" b="b"/>
            <a:pathLst>
              <a:path w="84" h="126">
                <a:moveTo>
                  <a:pt x="0" y="0"/>
                </a:moveTo>
                <a:lnTo>
                  <a:pt x="18" y="36"/>
                </a:lnTo>
                <a:lnTo>
                  <a:pt x="42" y="66"/>
                </a:lnTo>
                <a:lnTo>
                  <a:pt x="66" y="90"/>
                </a:lnTo>
                <a:lnTo>
                  <a:pt x="84" y="126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6878520" y="2971800"/>
            <a:ext cx="98640" cy="309600"/>
          </a:xfrm>
          <a:custGeom>
            <a:avLst/>
            <a:gdLst/>
            <a:ahLst/>
            <a:rect l="l" t="t" r="r" b="b"/>
            <a:pathLst>
              <a:path w="78" h="186">
                <a:moveTo>
                  <a:pt x="0" y="0"/>
                </a:moveTo>
                <a:lnTo>
                  <a:pt x="12" y="24"/>
                </a:lnTo>
                <a:lnTo>
                  <a:pt x="18" y="48"/>
                </a:lnTo>
                <a:lnTo>
                  <a:pt x="42" y="114"/>
                </a:lnTo>
                <a:lnTo>
                  <a:pt x="48" y="138"/>
                </a:lnTo>
                <a:lnTo>
                  <a:pt x="60" y="162"/>
                </a:lnTo>
                <a:lnTo>
                  <a:pt x="66" y="180"/>
                </a:lnTo>
                <a:lnTo>
                  <a:pt x="78" y="186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6977160" y="3002040"/>
            <a:ext cx="98280" cy="279360"/>
          </a:xfrm>
          <a:custGeom>
            <a:avLst/>
            <a:gdLst/>
            <a:ahLst/>
            <a:rect l="l" t="t" r="r" b="b"/>
            <a:pathLst>
              <a:path w="78" h="168">
                <a:moveTo>
                  <a:pt x="0" y="168"/>
                </a:moveTo>
                <a:lnTo>
                  <a:pt x="12" y="162"/>
                </a:lnTo>
                <a:lnTo>
                  <a:pt x="18" y="150"/>
                </a:lnTo>
                <a:lnTo>
                  <a:pt x="30" y="126"/>
                </a:lnTo>
                <a:lnTo>
                  <a:pt x="36" y="96"/>
                </a:lnTo>
                <a:lnTo>
                  <a:pt x="60" y="42"/>
                </a:lnTo>
                <a:lnTo>
                  <a:pt x="66" y="18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7075440" y="2932200"/>
            <a:ext cx="108000" cy="69840"/>
          </a:xfrm>
          <a:custGeom>
            <a:avLst/>
            <a:gdLst/>
            <a:ahLst/>
            <a:rect l="l" t="t" r="r" b="b"/>
            <a:pathLst>
              <a:path w="84" h="42">
                <a:moveTo>
                  <a:pt x="0" y="42"/>
                </a:moveTo>
                <a:lnTo>
                  <a:pt x="18" y="18"/>
                </a:lnTo>
                <a:lnTo>
                  <a:pt x="42" y="6"/>
                </a:lnTo>
                <a:lnTo>
                  <a:pt x="66" y="0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7183440" y="2932200"/>
            <a:ext cx="98280" cy="179280"/>
          </a:xfrm>
          <a:custGeom>
            <a:avLst/>
            <a:gdLst/>
            <a:ahLst/>
            <a:rect l="l" t="t" r="r" b="b"/>
            <a:pathLst>
              <a:path w="78" h="108">
                <a:moveTo>
                  <a:pt x="0" y="0"/>
                </a:moveTo>
                <a:lnTo>
                  <a:pt x="12" y="6"/>
                </a:lnTo>
                <a:lnTo>
                  <a:pt x="18" y="18"/>
                </a:lnTo>
                <a:lnTo>
                  <a:pt x="42" y="42"/>
                </a:lnTo>
                <a:lnTo>
                  <a:pt x="60" y="78"/>
                </a:lnTo>
                <a:lnTo>
                  <a:pt x="78" y="108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7281720" y="3111480"/>
            <a:ext cx="98640" cy="200160"/>
          </a:xfrm>
          <a:custGeom>
            <a:avLst/>
            <a:gdLst/>
            <a:ahLst/>
            <a:rect l="l" t="t" r="r" b="b"/>
            <a:pathLst>
              <a:path w="78" h="120">
                <a:moveTo>
                  <a:pt x="0" y="0"/>
                </a:moveTo>
                <a:lnTo>
                  <a:pt x="18" y="36"/>
                </a:lnTo>
                <a:lnTo>
                  <a:pt x="36" y="72"/>
                </a:lnTo>
                <a:lnTo>
                  <a:pt x="48" y="90"/>
                </a:lnTo>
                <a:lnTo>
                  <a:pt x="60" y="108"/>
                </a:lnTo>
                <a:lnTo>
                  <a:pt x="66" y="114"/>
                </a:lnTo>
                <a:lnTo>
                  <a:pt x="78" y="12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7380360" y="3092400"/>
            <a:ext cx="106200" cy="219240"/>
          </a:xfrm>
          <a:custGeom>
            <a:avLst/>
            <a:gdLst/>
            <a:ahLst/>
            <a:rect l="l" t="t" r="r" b="b"/>
            <a:pathLst>
              <a:path w="84" h="132">
                <a:moveTo>
                  <a:pt x="0" y="132"/>
                </a:moveTo>
                <a:lnTo>
                  <a:pt x="12" y="126"/>
                </a:lnTo>
                <a:lnTo>
                  <a:pt x="18" y="108"/>
                </a:lnTo>
                <a:lnTo>
                  <a:pt x="30" y="84"/>
                </a:lnTo>
                <a:lnTo>
                  <a:pt x="42" y="60"/>
                </a:lnTo>
                <a:lnTo>
                  <a:pt x="54" y="36"/>
                </a:lnTo>
                <a:lnTo>
                  <a:pt x="66" y="12"/>
                </a:lnTo>
                <a:lnTo>
                  <a:pt x="72" y="0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7486560" y="3092400"/>
            <a:ext cx="100080" cy="378000"/>
          </a:xfrm>
          <a:custGeom>
            <a:avLst/>
            <a:gdLst/>
            <a:ahLst/>
            <a:rect l="l" t="t" r="r" b="b"/>
            <a:pathLst>
              <a:path w="78" h="228">
                <a:moveTo>
                  <a:pt x="0" y="0"/>
                </a:moveTo>
                <a:lnTo>
                  <a:pt x="12" y="12"/>
                </a:lnTo>
                <a:lnTo>
                  <a:pt x="18" y="36"/>
                </a:lnTo>
                <a:lnTo>
                  <a:pt x="30" y="66"/>
                </a:lnTo>
                <a:lnTo>
                  <a:pt x="42" y="96"/>
                </a:lnTo>
                <a:lnTo>
                  <a:pt x="60" y="168"/>
                </a:lnTo>
                <a:lnTo>
                  <a:pt x="66" y="204"/>
                </a:lnTo>
                <a:lnTo>
                  <a:pt x="78" y="228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7586640" y="3470400"/>
            <a:ext cx="96840" cy="188640"/>
          </a:xfrm>
          <a:custGeom>
            <a:avLst/>
            <a:gdLst/>
            <a:ahLst/>
            <a:rect l="l" t="t" r="r" b="b"/>
            <a:pathLst>
              <a:path w="78" h="114">
                <a:moveTo>
                  <a:pt x="0" y="0"/>
                </a:moveTo>
                <a:lnTo>
                  <a:pt x="18" y="36"/>
                </a:lnTo>
                <a:lnTo>
                  <a:pt x="36" y="66"/>
                </a:lnTo>
                <a:lnTo>
                  <a:pt x="60" y="90"/>
                </a:lnTo>
                <a:lnTo>
                  <a:pt x="78" y="114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7683480" y="3659040"/>
            <a:ext cx="108000" cy="189000"/>
          </a:xfrm>
          <a:custGeom>
            <a:avLst/>
            <a:gdLst/>
            <a:ahLst/>
            <a:rect l="l" t="t" r="r" b="b"/>
            <a:pathLst>
              <a:path w="84" h="114">
                <a:moveTo>
                  <a:pt x="0" y="0"/>
                </a:moveTo>
                <a:lnTo>
                  <a:pt x="6" y="12"/>
                </a:lnTo>
                <a:lnTo>
                  <a:pt x="18" y="36"/>
                </a:lnTo>
                <a:lnTo>
                  <a:pt x="42" y="84"/>
                </a:lnTo>
                <a:lnTo>
                  <a:pt x="54" y="102"/>
                </a:lnTo>
                <a:lnTo>
                  <a:pt x="66" y="114"/>
                </a:lnTo>
                <a:lnTo>
                  <a:pt x="78" y="114"/>
                </a:lnTo>
                <a:lnTo>
                  <a:pt x="78" y="114"/>
                </a:lnTo>
                <a:lnTo>
                  <a:pt x="84" y="10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7791480" y="2614680"/>
            <a:ext cx="100080" cy="1214280"/>
          </a:xfrm>
          <a:custGeom>
            <a:avLst/>
            <a:gdLst/>
            <a:ahLst/>
            <a:rect l="l" t="t" r="r" b="b"/>
            <a:pathLst>
              <a:path w="78" h="732">
                <a:moveTo>
                  <a:pt x="0" y="732"/>
                </a:moveTo>
                <a:lnTo>
                  <a:pt x="6" y="708"/>
                </a:lnTo>
                <a:lnTo>
                  <a:pt x="12" y="672"/>
                </a:lnTo>
                <a:lnTo>
                  <a:pt x="12" y="624"/>
                </a:lnTo>
                <a:lnTo>
                  <a:pt x="18" y="576"/>
                </a:lnTo>
                <a:lnTo>
                  <a:pt x="24" y="516"/>
                </a:lnTo>
                <a:lnTo>
                  <a:pt x="30" y="456"/>
                </a:lnTo>
                <a:lnTo>
                  <a:pt x="36" y="330"/>
                </a:lnTo>
                <a:lnTo>
                  <a:pt x="48" y="210"/>
                </a:lnTo>
                <a:lnTo>
                  <a:pt x="54" y="156"/>
                </a:lnTo>
                <a:lnTo>
                  <a:pt x="60" y="108"/>
                </a:lnTo>
                <a:lnTo>
                  <a:pt x="66" y="66"/>
                </a:lnTo>
                <a:lnTo>
                  <a:pt x="66" y="30"/>
                </a:lnTo>
                <a:lnTo>
                  <a:pt x="72" y="12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7891560" y="2614680"/>
            <a:ext cx="104760" cy="1054080"/>
          </a:xfrm>
          <a:custGeom>
            <a:avLst/>
            <a:gdLst/>
            <a:ahLst/>
            <a:rect l="l" t="t" r="r" b="b"/>
            <a:pathLst>
              <a:path w="84" h="636">
                <a:moveTo>
                  <a:pt x="0" y="0"/>
                </a:moveTo>
                <a:lnTo>
                  <a:pt x="6" y="6"/>
                </a:lnTo>
                <a:lnTo>
                  <a:pt x="12" y="18"/>
                </a:lnTo>
                <a:lnTo>
                  <a:pt x="18" y="42"/>
                </a:lnTo>
                <a:lnTo>
                  <a:pt x="18" y="72"/>
                </a:lnTo>
                <a:lnTo>
                  <a:pt x="24" y="114"/>
                </a:lnTo>
                <a:lnTo>
                  <a:pt x="30" y="156"/>
                </a:lnTo>
                <a:lnTo>
                  <a:pt x="42" y="264"/>
                </a:lnTo>
                <a:lnTo>
                  <a:pt x="54" y="372"/>
                </a:lnTo>
                <a:lnTo>
                  <a:pt x="66" y="480"/>
                </a:lnTo>
                <a:lnTo>
                  <a:pt x="66" y="528"/>
                </a:lnTo>
                <a:lnTo>
                  <a:pt x="72" y="570"/>
                </a:lnTo>
                <a:lnTo>
                  <a:pt x="78" y="606"/>
                </a:lnTo>
                <a:lnTo>
                  <a:pt x="84" y="636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7996320" y="3668760"/>
            <a:ext cx="98280" cy="288720"/>
          </a:xfrm>
          <a:custGeom>
            <a:avLst/>
            <a:gdLst/>
            <a:ahLst/>
            <a:rect l="l" t="t" r="r" b="b"/>
            <a:pathLst>
              <a:path w="78" h="174">
                <a:moveTo>
                  <a:pt x="0" y="0"/>
                </a:moveTo>
                <a:lnTo>
                  <a:pt x="18" y="66"/>
                </a:lnTo>
                <a:lnTo>
                  <a:pt x="42" y="114"/>
                </a:lnTo>
                <a:lnTo>
                  <a:pt x="60" y="150"/>
                </a:lnTo>
                <a:lnTo>
                  <a:pt x="78" y="174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8094600" y="3957480"/>
            <a:ext cx="98640" cy="51120"/>
          </a:xfrm>
          <a:custGeom>
            <a:avLst/>
            <a:gdLst/>
            <a:ahLst/>
            <a:rect l="l" t="t" r="r" b="b"/>
            <a:pathLst>
              <a:path w="78" h="30">
                <a:moveTo>
                  <a:pt x="0" y="0"/>
                </a:moveTo>
                <a:lnTo>
                  <a:pt x="12" y="12"/>
                </a:lnTo>
                <a:lnTo>
                  <a:pt x="18" y="18"/>
                </a:lnTo>
                <a:lnTo>
                  <a:pt x="36" y="18"/>
                </a:lnTo>
                <a:lnTo>
                  <a:pt x="60" y="24"/>
                </a:lnTo>
                <a:lnTo>
                  <a:pt x="78" y="3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8193240" y="4008600"/>
            <a:ext cx="106200" cy="149040"/>
          </a:xfrm>
          <a:custGeom>
            <a:avLst/>
            <a:gdLst/>
            <a:ahLst/>
            <a:rect l="l" t="t" r="r" b="b"/>
            <a:pathLst>
              <a:path w="84" h="90">
                <a:moveTo>
                  <a:pt x="0" y="0"/>
                </a:moveTo>
                <a:lnTo>
                  <a:pt x="18" y="18"/>
                </a:lnTo>
                <a:lnTo>
                  <a:pt x="42" y="42"/>
                </a:lnTo>
                <a:lnTo>
                  <a:pt x="84" y="9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6164280" y="4395960"/>
            <a:ext cx="98280" cy="160200"/>
          </a:xfrm>
          <a:custGeom>
            <a:avLst/>
            <a:gdLst/>
            <a:ahLst/>
            <a:rect l="l" t="t" r="r" b="b"/>
            <a:pathLst>
              <a:path w="78" h="96">
                <a:moveTo>
                  <a:pt x="0" y="96"/>
                </a:moveTo>
                <a:lnTo>
                  <a:pt x="36" y="48"/>
                </a:lnTo>
                <a:lnTo>
                  <a:pt x="60" y="24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6262560" y="4167360"/>
            <a:ext cx="106560" cy="228600"/>
          </a:xfrm>
          <a:custGeom>
            <a:avLst/>
            <a:gdLst/>
            <a:ahLst/>
            <a:rect l="l" t="t" r="r" b="b"/>
            <a:pathLst>
              <a:path w="84" h="138">
                <a:moveTo>
                  <a:pt x="0" y="138"/>
                </a:moveTo>
                <a:lnTo>
                  <a:pt x="18" y="102"/>
                </a:lnTo>
                <a:lnTo>
                  <a:pt x="42" y="66"/>
                </a:lnTo>
                <a:lnTo>
                  <a:pt x="66" y="30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6369120" y="4106880"/>
            <a:ext cx="100080" cy="60480"/>
          </a:xfrm>
          <a:custGeom>
            <a:avLst/>
            <a:gdLst/>
            <a:ahLst/>
            <a:rect l="l" t="t" r="r" b="b"/>
            <a:pathLst>
              <a:path w="78" h="36">
                <a:moveTo>
                  <a:pt x="0" y="36"/>
                </a:moveTo>
                <a:lnTo>
                  <a:pt x="18" y="18"/>
                </a:lnTo>
                <a:lnTo>
                  <a:pt x="42" y="12"/>
                </a:lnTo>
                <a:lnTo>
                  <a:pt x="60" y="6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6469200" y="4008600"/>
            <a:ext cx="98280" cy="98280"/>
          </a:xfrm>
          <a:custGeom>
            <a:avLst/>
            <a:gdLst/>
            <a:ahLst/>
            <a:rect l="l" t="t" r="r" b="b"/>
            <a:pathLst>
              <a:path w="78" h="60">
                <a:moveTo>
                  <a:pt x="0" y="60"/>
                </a:moveTo>
                <a:lnTo>
                  <a:pt x="18" y="48"/>
                </a:lnTo>
                <a:lnTo>
                  <a:pt x="36" y="30"/>
                </a:lnTo>
                <a:lnTo>
                  <a:pt x="60" y="12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6567480" y="3948120"/>
            <a:ext cx="106200" cy="60480"/>
          </a:xfrm>
          <a:custGeom>
            <a:avLst/>
            <a:gdLst/>
            <a:ahLst/>
            <a:rect l="l" t="t" r="r" b="b"/>
            <a:pathLst>
              <a:path w="84" h="36">
                <a:moveTo>
                  <a:pt x="0" y="36"/>
                </a:moveTo>
                <a:lnTo>
                  <a:pt x="42" y="12"/>
                </a:lnTo>
                <a:lnTo>
                  <a:pt x="66" y="6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6673680" y="3948120"/>
            <a:ext cx="100080" cy="20520"/>
          </a:xfrm>
          <a:custGeom>
            <a:avLst/>
            <a:gdLst/>
            <a:ahLst/>
            <a:rect l="l" t="t" r="r" b="b"/>
            <a:pathLst>
              <a:path w="78" h="12">
                <a:moveTo>
                  <a:pt x="0" y="0"/>
                </a:moveTo>
                <a:lnTo>
                  <a:pt x="18" y="0"/>
                </a:lnTo>
                <a:lnTo>
                  <a:pt x="36" y="6"/>
                </a:lnTo>
                <a:lnTo>
                  <a:pt x="60" y="12"/>
                </a:lnTo>
                <a:lnTo>
                  <a:pt x="78" y="1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6773760" y="3908520"/>
            <a:ext cx="104760" cy="60120"/>
          </a:xfrm>
          <a:custGeom>
            <a:avLst/>
            <a:gdLst/>
            <a:ahLst/>
            <a:rect l="l" t="t" r="r" b="b"/>
            <a:pathLst>
              <a:path w="84" h="36">
                <a:moveTo>
                  <a:pt x="0" y="36"/>
                </a:moveTo>
                <a:lnTo>
                  <a:pt x="18" y="36"/>
                </a:lnTo>
                <a:lnTo>
                  <a:pt x="42" y="30"/>
                </a:lnTo>
                <a:lnTo>
                  <a:pt x="66" y="18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6878520" y="3629160"/>
            <a:ext cx="98640" cy="279360"/>
          </a:xfrm>
          <a:custGeom>
            <a:avLst/>
            <a:gdLst/>
            <a:ahLst/>
            <a:rect l="l" t="t" r="r" b="b"/>
            <a:pathLst>
              <a:path w="78" h="168">
                <a:moveTo>
                  <a:pt x="0" y="168"/>
                </a:moveTo>
                <a:lnTo>
                  <a:pt x="12" y="150"/>
                </a:lnTo>
                <a:lnTo>
                  <a:pt x="18" y="132"/>
                </a:lnTo>
                <a:lnTo>
                  <a:pt x="42" y="84"/>
                </a:lnTo>
                <a:lnTo>
                  <a:pt x="60" y="36"/>
                </a:lnTo>
                <a:lnTo>
                  <a:pt x="66" y="18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6977160" y="3500280"/>
            <a:ext cx="98280" cy="128880"/>
          </a:xfrm>
          <a:custGeom>
            <a:avLst/>
            <a:gdLst/>
            <a:ahLst/>
            <a:rect l="l" t="t" r="r" b="b"/>
            <a:pathLst>
              <a:path w="78" h="78">
                <a:moveTo>
                  <a:pt x="0" y="78"/>
                </a:moveTo>
                <a:lnTo>
                  <a:pt x="18" y="54"/>
                </a:lnTo>
                <a:lnTo>
                  <a:pt x="36" y="42"/>
                </a:lnTo>
                <a:lnTo>
                  <a:pt x="60" y="24"/>
                </a:lnTo>
                <a:lnTo>
                  <a:pt x="66" y="12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7075440" y="3201840"/>
            <a:ext cx="108000" cy="298440"/>
          </a:xfrm>
          <a:custGeom>
            <a:avLst/>
            <a:gdLst/>
            <a:ahLst/>
            <a:rect l="l" t="t" r="r" b="b"/>
            <a:pathLst>
              <a:path w="84" h="180">
                <a:moveTo>
                  <a:pt x="0" y="180"/>
                </a:moveTo>
                <a:lnTo>
                  <a:pt x="18" y="144"/>
                </a:lnTo>
                <a:lnTo>
                  <a:pt x="42" y="96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7183440" y="2852640"/>
            <a:ext cx="98280" cy="349200"/>
          </a:xfrm>
          <a:custGeom>
            <a:avLst/>
            <a:gdLst/>
            <a:ahLst/>
            <a:rect l="l" t="t" r="r" b="b"/>
            <a:pathLst>
              <a:path w="78" h="210">
                <a:moveTo>
                  <a:pt x="0" y="210"/>
                </a:moveTo>
                <a:lnTo>
                  <a:pt x="12" y="186"/>
                </a:lnTo>
                <a:lnTo>
                  <a:pt x="18" y="156"/>
                </a:lnTo>
                <a:lnTo>
                  <a:pt x="42" y="90"/>
                </a:lnTo>
                <a:lnTo>
                  <a:pt x="48" y="60"/>
                </a:lnTo>
                <a:lnTo>
                  <a:pt x="60" y="36"/>
                </a:lnTo>
                <a:lnTo>
                  <a:pt x="66" y="12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7281720" y="2852640"/>
            <a:ext cx="98640" cy="119160"/>
          </a:xfrm>
          <a:custGeom>
            <a:avLst/>
            <a:gdLst/>
            <a:ahLst/>
            <a:rect l="l" t="t" r="r" b="b"/>
            <a:pathLst>
              <a:path w="78" h="72">
                <a:moveTo>
                  <a:pt x="0" y="0"/>
                </a:moveTo>
                <a:lnTo>
                  <a:pt x="6" y="0"/>
                </a:lnTo>
                <a:lnTo>
                  <a:pt x="12" y="12"/>
                </a:lnTo>
                <a:lnTo>
                  <a:pt x="24" y="30"/>
                </a:lnTo>
                <a:lnTo>
                  <a:pt x="36" y="42"/>
                </a:lnTo>
                <a:lnTo>
                  <a:pt x="54" y="60"/>
                </a:lnTo>
                <a:lnTo>
                  <a:pt x="66" y="72"/>
                </a:lnTo>
                <a:lnTo>
                  <a:pt x="72" y="72"/>
                </a:lnTo>
                <a:lnTo>
                  <a:pt x="78" y="6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7380360" y="1459080"/>
            <a:ext cx="106200" cy="1493640"/>
          </a:xfrm>
          <a:custGeom>
            <a:avLst/>
            <a:gdLst/>
            <a:ahLst/>
            <a:rect l="l" t="t" r="r" b="b"/>
            <a:pathLst>
              <a:path w="84" h="900">
                <a:moveTo>
                  <a:pt x="0" y="900"/>
                </a:moveTo>
                <a:lnTo>
                  <a:pt x="6" y="870"/>
                </a:lnTo>
                <a:lnTo>
                  <a:pt x="12" y="822"/>
                </a:lnTo>
                <a:lnTo>
                  <a:pt x="18" y="768"/>
                </a:lnTo>
                <a:lnTo>
                  <a:pt x="18" y="708"/>
                </a:lnTo>
                <a:lnTo>
                  <a:pt x="24" y="636"/>
                </a:lnTo>
                <a:lnTo>
                  <a:pt x="30" y="564"/>
                </a:lnTo>
                <a:lnTo>
                  <a:pt x="42" y="414"/>
                </a:lnTo>
                <a:lnTo>
                  <a:pt x="48" y="342"/>
                </a:lnTo>
                <a:lnTo>
                  <a:pt x="54" y="270"/>
                </a:lnTo>
                <a:lnTo>
                  <a:pt x="60" y="198"/>
                </a:lnTo>
                <a:lnTo>
                  <a:pt x="66" y="138"/>
                </a:lnTo>
                <a:lnTo>
                  <a:pt x="66" y="90"/>
                </a:lnTo>
                <a:lnTo>
                  <a:pt x="72" y="48"/>
                </a:lnTo>
                <a:lnTo>
                  <a:pt x="78" y="18"/>
                </a:lnTo>
                <a:lnTo>
                  <a:pt x="84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7486560" y="1459080"/>
            <a:ext cx="100080" cy="1055520"/>
          </a:xfrm>
          <a:custGeom>
            <a:avLst/>
            <a:gdLst/>
            <a:ahLst/>
            <a:rect l="l" t="t" r="r" b="b"/>
            <a:pathLst>
              <a:path w="78" h="636">
                <a:moveTo>
                  <a:pt x="0" y="0"/>
                </a:moveTo>
                <a:lnTo>
                  <a:pt x="6" y="0"/>
                </a:lnTo>
                <a:lnTo>
                  <a:pt x="12" y="6"/>
                </a:lnTo>
                <a:lnTo>
                  <a:pt x="18" y="30"/>
                </a:lnTo>
                <a:lnTo>
                  <a:pt x="18" y="60"/>
                </a:lnTo>
                <a:lnTo>
                  <a:pt x="24" y="96"/>
                </a:lnTo>
                <a:lnTo>
                  <a:pt x="30" y="138"/>
                </a:lnTo>
                <a:lnTo>
                  <a:pt x="36" y="186"/>
                </a:lnTo>
                <a:lnTo>
                  <a:pt x="42" y="240"/>
                </a:lnTo>
                <a:lnTo>
                  <a:pt x="48" y="354"/>
                </a:lnTo>
                <a:lnTo>
                  <a:pt x="60" y="462"/>
                </a:lnTo>
                <a:lnTo>
                  <a:pt x="66" y="516"/>
                </a:lnTo>
                <a:lnTo>
                  <a:pt x="66" y="558"/>
                </a:lnTo>
                <a:lnTo>
                  <a:pt x="72" y="600"/>
                </a:lnTo>
                <a:lnTo>
                  <a:pt x="78" y="636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7586640" y="2514600"/>
            <a:ext cx="96840" cy="547560"/>
          </a:xfrm>
          <a:custGeom>
            <a:avLst/>
            <a:gdLst/>
            <a:ahLst/>
            <a:rect l="l" t="t" r="r" b="b"/>
            <a:pathLst>
              <a:path w="78" h="330">
                <a:moveTo>
                  <a:pt x="0" y="0"/>
                </a:moveTo>
                <a:lnTo>
                  <a:pt x="12" y="54"/>
                </a:lnTo>
                <a:lnTo>
                  <a:pt x="18" y="108"/>
                </a:lnTo>
                <a:lnTo>
                  <a:pt x="30" y="150"/>
                </a:lnTo>
                <a:lnTo>
                  <a:pt x="36" y="186"/>
                </a:lnTo>
                <a:lnTo>
                  <a:pt x="60" y="258"/>
                </a:lnTo>
                <a:lnTo>
                  <a:pt x="78" y="33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7683480" y="3062160"/>
            <a:ext cx="108000" cy="447840"/>
          </a:xfrm>
          <a:custGeom>
            <a:avLst/>
            <a:gdLst/>
            <a:ahLst/>
            <a:rect l="l" t="t" r="r" b="b"/>
            <a:pathLst>
              <a:path w="84" h="270">
                <a:moveTo>
                  <a:pt x="0" y="0"/>
                </a:moveTo>
                <a:lnTo>
                  <a:pt x="12" y="42"/>
                </a:lnTo>
                <a:lnTo>
                  <a:pt x="18" y="84"/>
                </a:lnTo>
                <a:lnTo>
                  <a:pt x="30" y="132"/>
                </a:lnTo>
                <a:lnTo>
                  <a:pt x="42" y="180"/>
                </a:lnTo>
                <a:lnTo>
                  <a:pt x="54" y="216"/>
                </a:lnTo>
                <a:lnTo>
                  <a:pt x="66" y="246"/>
                </a:lnTo>
                <a:lnTo>
                  <a:pt x="72" y="264"/>
                </a:lnTo>
                <a:lnTo>
                  <a:pt x="78" y="270"/>
                </a:lnTo>
                <a:lnTo>
                  <a:pt x="84" y="27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7791480" y="2913120"/>
            <a:ext cx="100080" cy="596880"/>
          </a:xfrm>
          <a:custGeom>
            <a:avLst/>
            <a:gdLst/>
            <a:ahLst/>
            <a:rect l="l" t="t" r="r" b="b"/>
            <a:pathLst>
              <a:path w="78" h="360">
                <a:moveTo>
                  <a:pt x="0" y="360"/>
                </a:moveTo>
                <a:lnTo>
                  <a:pt x="6" y="354"/>
                </a:lnTo>
                <a:lnTo>
                  <a:pt x="12" y="342"/>
                </a:lnTo>
                <a:lnTo>
                  <a:pt x="12" y="324"/>
                </a:lnTo>
                <a:lnTo>
                  <a:pt x="18" y="300"/>
                </a:lnTo>
                <a:lnTo>
                  <a:pt x="30" y="240"/>
                </a:lnTo>
                <a:lnTo>
                  <a:pt x="36" y="180"/>
                </a:lnTo>
                <a:lnTo>
                  <a:pt x="48" y="114"/>
                </a:lnTo>
                <a:lnTo>
                  <a:pt x="60" y="60"/>
                </a:lnTo>
                <a:lnTo>
                  <a:pt x="66" y="36"/>
                </a:lnTo>
                <a:lnTo>
                  <a:pt x="66" y="18"/>
                </a:lnTo>
                <a:lnTo>
                  <a:pt x="72" y="6"/>
                </a:lnTo>
                <a:lnTo>
                  <a:pt x="78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7891560" y="2913120"/>
            <a:ext cx="104760" cy="496800"/>
          </a:xfrm>
          <a:custGeom>
            <a:avLst/>
            <a:gdLst/>
            <a:ahLst/>
            <a:rect l="l" t="t" r="r" b="b"/>
            <a:pathLst>
              <a:path w="84" h="300">
                <a:moveTo>
                  <a:pt x="0" y="0"/>
                </a:moveTo>
                <a:lnTo>
                  <a:pt x="6" y="0"/>
                </a:lnTo>
                <a:lnTo>
                  <a:pt x="12" y="6"/>
                </a:lnTo>
                <a:lnTo>
                  <a:pt x="18" y="30"/>
                </a:lnTo>
                <a:lnTo>
                  <a:pt x="30" y="60"/>
                </a:lnTo>
                <a:lnTo>
                  <a:pt x="42" y="102"/>
                </a:lnTo>
                <a:lnTo>
                  <a:pt x="54" y="156"/>
                </a:lnTo>
                <a:lnTo>
                  <a:pt x="66" y="204"/>
                </a:lnTo>
                <a:lnTo>
                  <a:pt x="72" y="252"/>
                </a:lnTo>
                <a:lnTo>
                  <a:pt x="84" y="30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7996320" y="3409920"/>
            <a:ext cx="98280" cy="617400"/>
          </a:xfrm>
          <a:custGeom>
            <a:avLst/>
            <a:gdLst/>
            <a:ahLst/>
            <a:rect l="l" t="t" r="r" b="b"/>
            <a:pathLst>
              <a:path w="78" h="372">
                <a:moveTo>
                  <a:pt x="0" y="0"/>
                </a:moveTo>
                <a:lnTo>
                  <a:pt x="12" y="48"/>
                </a:lnTo>
                <a:lnTo>
                  <a:pt x="18" y="96"/>
                </a:lnTo>
                <a:lnTo>
                  <a:pt x="42" y="204"/>
                </a:lnTo>
                <a:lnTo>
                  <a:pt x="48" y="258"/>
                </a:lnTo>
                <a:lnTo>
                  <a:pt x="60" y="300"/>
                </a:lnTo>
                <a:lnTo>
                  <a:pt x="66" y="342"/>
                </a:lnTo>
                <a:lnTo>
                  <a:pt x="78" y="37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8094600" y="4027320"/>
            <a:ext cx="98640" cy="30240"/>
          </a:xfrm>
          <a:custGeom>
            <a:avLst/>
            <a:gdLst/>
            <a:ahLst/>
            <a:rect l="l" t="t" r="r" b="b"/>
            <a:pathLst>
              <a:path w="78" h="18">
                <a:moveTo>
                  <a:pt x="0" y="0"/>
                </a:moveTo>
                <a:lnTo>
                  <a:pt x="6" y="12"/>
                </a:lnTo>
                <a:lnTo>
                  <a:pt x="18" y="18"/>
                </a:lnTo>
                <a:lnTo>
                  <a:pt x="36" y="18"/>
                </a:lnTo>
                <a:lnTo>
                  <a:pt x="60" y="18"/>
                </a:lnTo>
                <a:lnTo>
                  <a:pt x="78" y="18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8193240" y="4057560"/>
            <a:ext cx="106200" cy="189000"/>
          </a:xfrm>
          <a:custGeom>
            <a:avLst/>
            <a:gdLst/>
            <a:ahLst/>
            <a:rect l="l" t="t" r="r" b="b"/>
            <a:pathLst>
              <a:path w="84" h="114">
                <a:moveTo>
                  <a:pt x="0" y="0"/>
                </a:moveTo>
                <a:lnTo>
                  <a:pt x="18" y="24"/>
                </a:lnTo>
                <a:lnTo>
                  <a:pt x="42" y="48"/>
                </a:lnTo>
                <a:lnTo>
                  <a:pt x="60" y="84"/>
                </a:lnTo>
                <a:lnTo>
                  <a:pt x="84" y="114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6148440" y="453564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6248520" y="3987720"/>
            <a:ext cx="298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6354720" y="302256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6453360" y="2465280"/>
            <a:ext cx="29880" cy="3996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6551640" y="233532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6659640" y="2374920"/>
            <a:ext cx="2844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6756480" y="274320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6862680" y="295272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6964200" y="3260880"/>
            <a:ext cx="2880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7061040" y="2982960"/>
            <a:ext cx="3024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7167600" y="291312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7265880" y="3092400"/>
            <a:ext cx="3024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7364520" y="3290760"/>
            <a:ext cx="31680" cy="3996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7472520" y="307188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7570800" y="3449520"/>
            <a:ext cx="30240" cy="414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7669080" y="3639960"/>
            <a:ext cx="32040" cy="3996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7777080" y="3808440"/>
            <a:ext cx="2880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7873920" y="2593800"/>
            <a:ext cx="30240" cy="3996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7980480" y="364968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8078760" y="393876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8178840" y="3987720"/>
            <a:ext cx="3024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8285040" y="4137120"/>
            <a:ext cx="3204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6141960" y="4525920"/>
            <a:ext cx="44640" cy="586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6240600" y="4365720"/>
            <a:ext cx="4608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6348240" y="4137120"/>
            <a:ext cx="4464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6445080" y="4078440"/>
            <a:ext cx="46080" cy="586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6545160" y="3978360"/>
            <a:ext cx="4464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6649920" y="3917880"/>
            <a:ext cx="4788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6750000" y="3938760"/>
            <a:ext cx="44640" cy="586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6856560" y="3878280"/>
            <a:ext cx="4428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6954840" y="3600360"/>
            <a:ext cx="47520" cy="586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7053120" y="3470400"/>
            <a:ext cx="4608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7161120" y="3171960"/>
            <a:ext cx="44640" cy="586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7257960" y="2822400"/>
            <a:ext cx="4608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7358040" y="2922480"/>
            <a:ext cx="4464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7466040" y="1428840"/>
            <a:ext cx="4428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7562880" y="2484360"/>
            <a:ext cx="4608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7662960" y="3032280"/>
            <a:ext cx="4428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7767720" y="3479760"/>
            <a:ext cx="4752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7866000" y="2882880"/>
            <a:ext cx="4608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7974000" y="3381480"/>
            <a:ext cx="44640" cy="586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8072280" y="3997440"/>
            <a:ext cx="4464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8170920" y="4027320"/>
            <a:ext cx="4608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8278920" y="4216320"/>
            <a:ext cx="44280" cy="6048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4564800" y="4473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4488120" y="38606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4488120" y="32432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4488120" y="26161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4488120" y="1998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4564800" y="13809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4719600" y="46512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5146920" y="4651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5589720" y="46512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6066000" y="46512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6544080" y="46512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7018560" y="46512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8474400" y="46512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4875120" y="1706400"/>
            <a:ext cx="190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4951440" y="1685880"/>
            <a:ext cx="31680" cy="39600"/>
          </a:xfrm>
          <a:custGeom>
            <a:avLst/>
            <a:gdLst/>
            <a:ahLst/>
            <a:rect l="l" t="t" r="r" b="b"/>
            <a:pathLst>
              <a:path w="24" h="24">
                <a:moveTo>
                  <a:pt x="12" y="0"/>
                </a:moveTo>
                <a:lnTo>
                  <a:pt x="24" y="12"/>
                </a:lnTo>
                <a:lnTo>
                  <a:pt x="12" y="24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4875120" y="1905120"/>
            <a:ext cx="190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4944960" y="1874880"/>
            <a:ext cx="44640" cy="60120"/>
          </a:xfrm>
          <a:custGeom>
            <a:avLst/>
            <a:gdLst/>
            <a:ahLst/>
            <a:rect l="l" t="t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5056920" y="1560600"/>
            <a:ext cx="52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5053680" y="1763640"/>
            <a:ext cx="52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 rot="16200000">
            <a:off x="3745800" y="2870640"/>
            <a:ext cx="109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D 492 n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 flipV="1">
            <a:off x="759924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 flipV="1">
            <a:off x="8075520" y="4556160"/>
            <a:ext cx="0" cy="3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7490880" y="46512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7972920" y="46512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444960" y="236520"/>
            <a:ext cx="1462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. Fig.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6129360" y="1343160"/>
            <a:ext cx="1157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7338960" y="1343160"/>
            <a:ext cx="238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6310440" y="1101600"/>
            <a:ext cx="7138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Gal</a:t>
            </a:r>
            <a:r>
              <a:rPr b="0" lang="fr-FR" sz="1000" spc="-1" strike="noStrike" baseline="-25000">
                <a:solidFill>
                  <a:srgbClr val="000000"/>
                </a:solidFill>
                <a:latin typeface="Arial"/>
              </a:rPr>
              <a:t>n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-AH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7246080" y="108900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H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729000" y="874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4805640" y="8366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9T13:28:05Z</dcterms:created>
  <dc:creator>Institut Pasteur</dc:creator>
  <dc:description/>
  <dc:language>en-US</dc:language>
  <cp:lastModifiedBy>Institut Pasteur</cp:lastModifiedBy>
  <dcterms:modified xsi:type="dcterms:W3CDTF">2011-09-09T13:28:24Z</dcterms:modified>
  <cp:revision>1</cp:revision>
  <dc:subject/>
  <dc:title>Diapositive 1</dc:title>
</cp:coreProperties>
</file>